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67" r:id="rId1"/>
  </p:sldMasterIdLst>
  <p:notesMasterIdLst>
    <p:notesMasterId r:id="rId9"/>
  </p:notesMasterIdLst>
  <p:sldIdLst>
    <p:sldId id="1116" r:id="rId2"/>
    <p:sldId id="1119" r:id="rId3"/>
    <p:sldId id="1128" r:id="rId4"/>
    <p:sldId id="1120" r:id="rId5"/>
    <p:sldId id="1121" r:id="rId6"/>
    <p:sldId id="1122" r:id="rId7"/>
    <p:sldId id="1131" r:id="rId8"/>
  </p:sldIdLst>
  <p:sldSz cx="12190413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  <p15:guide id="3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66"/>
    <a:srgbClr val="F61B0A"/>
    <a:srgbClr val="38979E"/>
    <a:srgbClr val="00FFFF"/>
    <a:srgbClr val="E9EE12"/>
    <a:srgbClr val="617D7A"/>
    <a:srgbClr val="CC3300"/>
    <a:srgbClr val="A1E428"/>
    <a:srgbClr val="66CCFF"/>
    <a:srgbClr val="7C5A5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35758FB7-9AC5-4552-8A53-C91805E547FA}" styleName="Themed Style 1 - Accent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775DCB02-9BB8-47FD-8907-85C794F793BA}" styleName="Themed Style 1 - Accent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787" autoAdjust="0"/>
    <p:restoredTop sz="76650" autoAdjust="0"/>
  </p:normalViewPr>
  <p:slideViewPr>
    <p:cSldViewPr>
      <p:cViewPr varScale="1">
        <p:scale>
          <a:sx n="57" d="100"/>
          <a:sy n="57" d="100"/>
        </p:scale>
        <p:origin x="1230" y="42"/>
      </p:cViewPr>
      <p:guideLst>
        <p:guide orient="horz" pos="2160"/>
        <p:guide pos="2880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50" d="100"/>
        <a:sy n="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ar-EG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4EED6480-ED8B-4BBE-A622-376BE9AE1365}" type="datetimeFigureOut">
              <a:rPr lang="ar-EG" smtClean="0"/>
              <a:pPr/>
              <a:t>08/10/1441</a:t>
            </a:fld>
            <a:endParaRPr lang="ar-EG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2588" y="685800"/>
            <a:ext cx="60928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ar-EG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r-E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ar-E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3EAFE3B9-D881-4970-82DB-BE2F2212133B}" type="slidenum">
              <a:rPr lang="ar-EG" smtClean="0"/>
              <a:pPr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39346101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AFE3B9-D881-4970-82DB-BE2F2212133B}" type="slidenum">
              <a:rPr lang="ar-EG" smtClean="0"/>
              <a:pPr/>
              <a:t>2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48984400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AFE3B9-D881-4970-82DB-BE2F2212133B}" type="slidenum">
              <a:rPr lang="ar-EG" smtClean="0"/>
              <a:pPr/>
              <a:t>5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48984400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AFE3B9-D881-4970-82DB-BE2F2212133B}" type="slidenum">
              <a:rPr lang="ar-EG" smtClean="0"/>
              <a:pPr/>
              <a:t>6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4898440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54805" y="1447800"/>
            <a:ext cx="8824509" cy="3329581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54805" y="4777380"/>
            <a:ext cx="8824509" cy="861420"/>
          </a:xfrm>
        </p:spPr>
        <p:txBody>
          <a:bodyPr anchor="t"/>
          <a:lstStyle>
            <a:lvl1pPr marL="0" indent="0" algn="l">
              <a:buNone/>
              <a:defRPr cap="all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8650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anoramic 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806" y="4800587"/>
            <a:ext cx="8824508" cy="566738"/>
          </a:xfrm>
        </p:spPr>
        <p:txBody>
          <a:bodyPr anchor="b">
            <a:normAutofit/>
          </a:bodyPr>
          <a:lstStyle>
            <a:lvl1pPr algn="l">
              <a:defRPr sz="24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54805" y="685800"/>
            <a:ext cx="8824509" cy="3640666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806" y="5367325"/>
            <a:ext cx="8824507" cy="493712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374022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804" y="1447800"/>
            <a:ext cx="8824510" cy="1981200"/>
          </a:xfrm>
        </p:spPr>
        <p:txBody>
          <a:bodyPr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8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804" y="3657600"/>
            <a:ext cx="8824510" cy="2362200"/>
          </a:xfrm>
        </p:spPr>
        <p:txBody>
          <a:bodyPr anchor="ctr">
            <a:normAutofit/>
          </a:bodyPr>
          <a:lstStyle>
            <a:lvl1pPr marL="0" indent="0">
              <a:buNone/>
              <a:defRPr sz="18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1790731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Quot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74596" y="1447800"/>
            <a:ext cx="7998274" cy="2323374"/>
          </a:xfrm>
        </p:spPr>
        <p:txBody>
          <a:bodyPr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1" name="Text Placeholder 3"/>
          <p:cNvSpPr>
            <a:spLocks noGrp="1"/>
          </p:cNvSpPr>
          <p:nvPr>
            <p:ph type="body" sz="half" idx="14"/>
          </p:nvPr>
        </p:nvSpPr>
        <p:spPr>
          <a:xfrm>
            <a:off x="1930149" y="3771174"/>
            <a:ext cx="7278701" cy="342174"/>
          </a:xfrm>
        </p:spPr>
        <p:txBody>
          <a:bodyPr vert="horz" lIns="91440" tIns="45720" rIns="91440" bIns="45720" rtlCol="0" anchor="t">
            <a:normAutofit/>
          </a:bodyPr>
          <a:lstStyle>
            <a:lvl1pPr marL="0" indent="0">
              <a:buNone/>
              <a:defRPr lang="en-US" sz="1400" b="0" i="0" kern="1200" cap="small" dirty="0">
                <a:solidFill>
                  <a:schemeClr val="bg2">
                    <a:lumMod val="40000"/>
                    <a:lumOff val="60000"/>
                  </a:schemeClr>
                </a:solidFill>
                <a:latin typeface="+mj-lt"/>
                <a:ea typeface="+mj-ea"/>
                <a:cs typeface="+mj-cs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marL="0" lvl="0" indent="0">
              <a:buNone/>
            </a:pPr>
            <a:r>
              <a:rPr lang="en-US"/>
              <a:t>Edit Master text styles</a:t>
            </a:r>
          </a:p>
        </p:txBody>
      </p:sp>
      <p:sp>
        <p:nvSpPr>
          <p:cNvPr id="10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804" y="4350657"/>
            <a:ext cx="8824510" cy="1676400"/>
          </a:xfrm>
        </p:spPr>
        <p:txBody>
          <a:bodyPr anchor="ctr">
            <a:normAutofit/>
          </a:bodyPr>
          <a:lstStyle>
            <a:lvl1pPr marL="0" indent="0">
              <a:buNone/>
              <a:defRPr sz="18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898178" y="971253"/>
            <a:ext cx="801808" cy="1969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r">
              <a:defRPr sz="12200" b="0" i="0">
                <a:solidFill>
                  <a:schemeClr val="bg2">
                    <a:lumMod val="40000"/>
                    <a:lumOff val="60000"/>
                  </a:schemeClr>
                </a:solidFill>
                <a:latin typeface="Arial"/>
                <a:ea typeface="+mj-ea"/>
                <a:cs typeface="+mj-cs"/>
              </a:defRPr>
            </a:lvl1pPr>
          </a:lstStyle>
          <a:p>
            <a:pPr defTabSz="457200"/>
            <a:r>
              <a:rPr lang="en-US" dirty="0">
                <a:solidFill>
                  <a:srgbClr val="1E5155">
                    <a:lumMod val="40000"/>
                    <a:lumOff val="60000"/>
                  </a:srgbClr>
                </a:solidFill>
              </a:rPr>
              <a:t>“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9329275" y="2613787"/>
            <a:ext cx="801808" cy="1969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r">
              <a:defRPr sz="12200" b="0" i="0">
                <a:solidFill>
                  <a:schemeClr val="bg2">
                    <a:lumMod val="40000"/>
                    <a:lumOff val="60000"/>
                  </a:schemeClr>
                </a:solidFill>
                <a:latin typeface="Arial"/>
                <a:ea typeface="+mj-ea"/>
                <a:cs typeface="+mj-cs"/>
              </a:defRPr>
            </a:lvl1pPr>
          </a:lstStyle>
          <a:p>
            <a:pPr defTabSz="457200"/>
            <a:r>
              <a:rPr lang="en-US" dirty="0">
                <a:solidFill>
                  <a:srgbClr val="1E5155">
                    <a:lumMod val="40000"/>
                    <a:lumOff val="60000"/>
                  </a:srgbClr>
                </a:solidFill>
              </a:rPr>
              <a:t>”</a:t>
            </a:r>
          </a:p>
        </p:txBody>
      </p:sp>
    </p:spTree>
    <p:extLst>
      <p:ext uri="{BB962C8B-B14F-4D97-AF65-F5344CB8AC3E}">
        <p14:creationId xmlns:p14="http://schemas.microsoft.com/office/powerpoint/2010/main" val="330679579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Name Car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804" y="3124201"/>
            <a:ext cx="8824511" cy="1653180"/>
          </a:xfrm>
        </p:spPr>
        <p:txBody>
          <a:bodyPr anchor="b"/>
          <a:lstStyle>
            <a:lvl1pPr algn="l">
              <a:defRPr sz="4000" b="0" cap="none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804" y="4777381"/>
            <a:ext cx="8824510" cy="860400"/>
          </a:xfrm>
        </p:spPr>
        <p:txBody>
          <a:bodyPr anchor="t"/>
          <a:lstStyle>
            <a:lvl1pPr marL="0" indent="0" algn="l">
              <a:buNone/>
              <a:defRPr sz="2000" cap="none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4642189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2865" y="1981200"/>
            <a:ext cx="2946482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6" name="Text Placeholder 3"/>
          <p:cNvSpPr>
            <a:spLocks noGrp="1"/>
          </p:cNvSpPr>
          <p:nvPr>
            <p:ph type="body" sz="half" idx="15"/>
          </p:nvPr>
        </p:nvSpPr>
        <p:spPr>
          <a:xfrm>
            <a:off x="652378" y="2667000"/>
            <a:ext cx="2926969" cy="3589338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83154" y="1981200"/>
            <a:ext cx="2935859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9" name="Text Placeholder 3"/>
          <p:cNvSpPr>
            <a:spLocks noGrp="1"/>
          </p:cNvSpPr>
          <p:nvPr>
            <p:ph type="body" sz="half" idx="16"/>
          </p:nvPr>
        </p:nvSpPr>
        <p:spPr>
          <a:xfrm>
            <a:off x="3872602" y="2667000"/>
            <a:ext cx="2946410" cy="3589338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4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123773" y="1981200"/>
            <a:ext cx="2931731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20" name="Text Placeholder 3"/>
          <p:cNvSpPr>
            <a:spLocks noGrp="1"/>
          </p:cNvSpPr>
          <p:nvPr>
            <p:ph type="body" sz="half" idx="17"/>
          </p:nvPr>
        </p:nvSpPr>
        <p:spPr>
          <a:xfrm>
            <a:off x="7123773" y="2667000"/>
            <a:ext cx="2931731" cy="3589338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cxnSp>
        <p:nvCxnSpPr>
          <p:cNvPr id="17" name="Straight Connector 16"/>
          <p:cNvCxnSpPr/>
          <p:nvPr/>
        </p:nvCxnSpPr>
        <p:spPr>
          <a:xfrm>
            <a:off x="3725657" y="2133600"/>
            <a:ext cx="0" cy="3962400"/>
          </a:xfrm>
          <a:prstGeom prst="line">
            <a:avLst/>
          </a:prstGeom>
          <a:ln w="12700" cmpd="sng">
            <a:solidFill>
              <a:schemeClr val="bg2">
                <a:lumMod val="40000"/>
                <a:lumOff val="60000"/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6961321" y="2133600"/>
            <a:ext cx="0" cy="3966882"/>
          </a:xfrm>
          <a:prstGeom prst="line">
            <a:avLst/>
          </a:prstGeom>
          <a:ln w="12700" cmpd="sng">
            <a:solidFill>
              <a:schemeClr val="bg2">
                <a:lumMod val="40000"/>
                <a:lumOff val="60000"/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663372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Picture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2378" y="4250949"/>
            <a:ext cx="2939667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29" name="Picture Placeholder 2"/>
          <p:cNvSpPr>
            <a:spLocks noGrp="1" noChangeAspect="1"/>
          </p:cNvSpPr>
          <p:nvPr>
            <p:ph type="pic" idx="15"/>
          </p:nvPr>
        </p:nvSpPr>
        <p:spPr>
          <a:xfrm>
            <a:off x="652378" y="2209800"/>
            <a:ext cx="2939667" cy="1524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2" name="Text Placeholder 3"/>
          <p:cNvSpPr>
            <a:spLocks noGrp="1"/>
          </p:cNvSpPr>
          <p:nvPr>
            <p:ph type="body" sz="half" idx="18"/>
          </p:nvPr>
        </p:nvSpPr>
        <p:spPr>
          <a:xfrm>
            <a:off x="652378" y="4827212"/>
            <a:ext cx="2939667" cy="659189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88869" y="4250949"/>
            <a:ext cx="2930144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30" name="Picture Placeholder 2"/>
          <p:cNvSpPr>
            <a:spLocks noGrp="1" noChangeAspect="1"/>
          </p:cNvSpPr>
          <p:nvPr>
            <p:ph type="pic" idx="21"/>
          </p:nvPr>
        </p:nvSpPr>
        <p:spPr>
          <a:xfrm>
            <a:off x="3888868" y="2209800"/>
            <a:ext cx="2930144" cy="1524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3" name="Text Placeholder 3"/>
          <p:cNvSpPr>
            <a:spLocks noGrp="1"/>
          </p:cNvSpPr>
          <p:nvPr>
            <p:ph type="body" sz="half" idx="19"/>
          </p:nvPr>
        </p:nvSpPr>
        <p:spPr>
          <a:xfrm>
            <a:off x="3887516" y="4827211"/>
            <a:ext cx="2934024" cy="659189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14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123773" y="4250949"/>
            <a:ext cx="2931731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31" name="Picture Placeholder 2"/>
          <p:cNvSpPr>
            <a:spLocks noGrp="1" noChangeAspect="1"/>
          </p:cNvSpPr>
          <p:nvPr>
            <p:ph type="pic" idx="22"/>
          </p:nvPr>
        </p:nvSpPr>
        <p:spPr>
          <a:xfrm>
            <a:off x="7123772" y="2209800"/>
            <a:ext cx="2931731" cy="1524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4" name="Text Placeholder 3"/>
          <p:cNvSpPr>
            <a:spLocks noGrp="1"/>
          </p:cNvSpPr>
          <p:nvPr>
            <p:ph type="body" sz="half" idx="20"/>
          </p:nvPr>
        </p:nvSpPr>
        <p:spPr>
          <a:xfrm>
            <a:off x="7123648" y="4827209"/>
            <a:ext cx="2935615" cy="659189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cxnSp>
        <p:nvCxnSpPr>
          <p:cNvPr id="19" name="Straight Connector 18"/>
          <p:cNvCxnSpPr/>
          <p:nvPr/>
        </p:nvCxnSpPr>
        <p:spPr>
          <a:xfrm>
            <a:off x="3725657" y="2133600"/>
            <a:ext cx="0" cy="3962400"/>
          </a:xfrm>
          <a:prstGeom prst="line">
            <a:avLst/>
          </a:prstGeom>
          <a:ln w="12700" cmpd="sng">
            <a:solidFill>
              <a:schemeClr val="bg2">
                <a:lumMod val="40000"/>
                <a:lumOff val="60000"/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6961321" y="2133600"/>
            <a:ext cx="0" cy="3966882"/>
          </a:xfrm>
          <a:prstGeom prst="line">
            <a:avLst/>
          </a:prstGeom>
          <a:ln w="12700" cmpd="sng">
            <a:solidFill>
              <a:schemeClr val="bg2">
                <a:lumMod val="40000"/>
                <a:lumOff val="60000"/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6859858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anchor="t" anchorCtr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9706382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303131" y="430213"/>
            <a:ext cx="1752373" cy="5826125"/>
          </a:xfrm>
        </p:spPr>
        <p:txBody>
          <a:bodyPr vert="eaVert" anchor="b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52378" y="887414"/>
            <a:ext cx="7422183" cy="5368924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157532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446691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806" y="2861734"/>
            <a:ext cx="8824508" cy="1915647"/>
          </a:xfrm>
        </p:spPr>
        <p:txBody>
          <a:bodyPr anchor="b"/>
          <a:lstStyle>
            <a:lvl1pPr algn="l">
              <a:defRPr sz="4000" b="0" cap="none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805" y="4777381"/>
            <a:ext cx="8824509" cy="860400"/>
          </a:xfrm>
        </p:spPr>
        <p:txBody>
          <a:bodyPr anchor="t"/>
          <a:lstStyle>
            <a:lvl1pPr marL="0" indent="0" algn="l">
              <a:buNone/>
              <a:defRPr sz="2000" cap="all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390192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03169" y="2060576"/>
            <a:ext cx="4395767" cy="4195763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53757" y="2056092"/>
            <a:ext cx="4395769" cy="4200245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31423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3169" y="1905000"/>
            <a:ext cx="4395766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03169" y="2514600"/>
            <a:ext cx="4395767" cy="3741738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653759" y="1905000"/>
            <a:ext cx="4395767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653759" y="2514600"/>
            <a:ext cx="4395767" cy="3741738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062063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7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33476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32830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803" y="1447800"/>
            <a:ext cx="3400621" cy="1447800"/>
          </a:xfrm>
        </p:spPr>
        <p:txBody>
          <a:bodyPr anchor="b"/>
          <a:lstStyle>
            <a:lvl1pPr algn="l">
              <a:defRPr sz="24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83994" y="1447800"/>
            <a:ext cx="5195321" cy="4572000"/>
          </a:xfrm>
        </p:spPr>
        <p:txBody>
          <a:bodyPr anchor="ctr">
            <a:normAutofit/>
          </a:bodyPr>
          <a:lstStyle>
            <a:lvl1pPr>
              <a:defRPr sz="20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803" y="3129281"/>
            <a:ext cx="3400620" cy="289559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7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12857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3757" y="1854192"/>
            <a:ext cx="5092243" cy="1574808"/>
          </a:xfrm>
        </p:spPr>
        <p:txBody>
          <a:bodyPr anchor="b">
            <a:normAutofit/>
          </a:bodyPr>
          <a:lstStyle>
            <a:lvl1pPr algn="l">
              <a:defRPr sz="36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48642" y="1143000"/>
            <a:ext cx="3199983" cy="4572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804" y="3657600"/>
            <a:ext cx="5084317" cy="1371600"/>
          </a:xfrm>
        </p:spPr>
        <p:txBody>
          <a:bodyPr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36150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21" Type="http://schemas.openxmlformats.org/officeDocument/2006/relationships/image" Target="../media/image4.png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image" Target="../media/image2.png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3"/>
          <a:stretch/>
        </p:blipFill>
        <p:spPr>
          <a:xfrm>
            <a:off x="0" y="2669686"/>
            <a:ext cx="4036487" cy="418831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640"/>
          <a:stretch/>
        </p:blipFill>
        <p:spPr>
          <a:xfrm>
            <a:off x="0" y="2892348"/>
            <a:ext cx="1522214" cy="2365453"/>
          </a:xfrm>
          <a:prstGeom prst="rect">
            <a:avLst/>
          </a:prstGeom>
        </p:spPr>
      </p:pic>
      <p:sp>
        <p:nvSpPr>
          <p:cNvPr id="16" name="Oval 15"/>
          <p:cNvSpPr/>
          <p:nvPr/>
        </p:nvSpPr>
        <p:spPr>
          <a:xfrm>
            <a:off x="8607891" y="1676400"/>
            <a:ext cx="2819033" cy="2819400"/>
          </a:xfrm>
          <a:prstGeom prst="ellipse">
            <a:avLst/>
          </a:prstGeom>
          <a:gradFill flip="none" rotWithShape="1">
            <a:gsLst>
              <a:gs pos="0">
                <a:schemeClr val="bg2">
                  <a:lumMod val="60000"/>
                  <a:lumOff val="40000"/>
                  <a:alpha val="7000"/>
                </a:schemeClr>
              </a:gs>
              <a:gs pos="69000">
                <a:schemeClr val="bg2">
                  <a:lumMod val="60000"/>
                  <a:lumOff val="40000"/>
                  <a:alpha val="0"/>
                </a:schemeClr>
              </a:gs>
              <a:gs pos="36000">
                <a:schemeClr val="bg2">
                  <a:lumMod val="60000"/>
                  <a:lumOff val="40000"/>
                  <a:alpha val="6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813"/>
          <a:stretch/>
        </p:blipFill>
        <p:spPr>
          <a:xfrm>
            <a:off x="7998371" y="0"/>
            <a:ext cx="1603178" cy="1141407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3320"/>
          <a:stretch/>
        </p:blipFill>
        <p:spPr>
          <a:xfrm>
            <a:off x="8604758" y="6096000"/>
            <a:ext cx="993605" cy="76200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10436453" y="0"/>
            <a:ext cx="685711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46027" y="452718"/>
            <a:ext cx="9403499" cy="1400530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3169" y="2052919"/>
            <a:ext cx="8945376" cy="419548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 rot="5400000">
            <a:off x="10154253" y="1790721"/>
            <a:ext cx="990599" cy="304759"/>
          </a:xfrm>
          <a:prstGeom prst="rect">
            <a:avLst/>
          </a:prstGeom>
        </p:spPr>
        <p:txBody>
          <a:bodyPr vert="horz" lIns="91440" tIns="45720" rIns="91440" bIns="45720" rtlCol="0" anchor="t"/>
          <a:lstStyle>
            <a:lvl1pPr algn="l">
              <a:defRPr sz="1100" b="0" i="0">
                <a:solidFill>
                  <a:schemeClr val="tx1">
                    <a:tint val="75000"/>
                    <a:alpha val="60000"/>
                  </a:schemeClr>
                </a:solidFill>
              </a:defRPr>
            </a:lvl1pPr>
          </a:lstStyle>
          <a:p>
            <a:pPr defTabSz="457200"/>
            <a:fld id="{AC7D1C0B-E281-423C-A3BA-457DEE11B8E1}" type="datetimeFigureOut">
              <a:rPr lang="en-US" smtClean="0">
                <a:solidFill>
                  <a:prstClr val="white">
                    <a:tint val="75000"/>
                    <a:alpha val="60000"/>
                  </a:prstClr>
                </a:solidFill>
              </a:rPr>
              <a:pPr defTabSz="457200"/>
              <a:t>5/30/2020</a:t>
            </a:fld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 rot="5400000">
            <a:off x="8950157" y="3225318"/>
            <a:ext cx="3859795" cy="30476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100" b="0" i="0">
                <a:solidFill>
                  <a:schemeClr val="tx1">
                    <a:tint val="75000"/>
                    <a:alpha val="60000"/>
                  </a:schemeClr>
                </a:solidFill>
              </a:defRPr>
            </a:lvl1pPr>
          </a:lstStyle>
          <a:p>
            <a:pPr defTabSz="457200"/>
            <a:endParaRPr lang="en-US">
              <a:solidFill>
                <a:prstClr val="white">
                  <a:tint val="75000"/>
                  <a:alpha val="60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 bwMode="gray">
          <a:xfrm>
            <a:off x="10351193" y="295730"/>
            <a:ext cx="838090" cy="7676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ctr">
              <a:defRPr sz="2800" b="0" i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457200"/>
            <a:fld id="{C2ABEA1E-B0A4-42DD-9AEE-B85CAA7BA790}" type="slidenum">
              <a:rPr lang="en-US" smtClean="0">
                <a:solidFill>
                  <a:prstClr val="white">
                    <a:tint val="75000"/>
                  </a:prstClr>
                </a:solidFill>
              </a:rPr>
              <a:pPr defTabSz="457200"/>
              <a:t>‹#›</a:t>
            </a:fld>
            <a:endParaRPr lang="en-US">
              <a:solidFill>
                <a:prstClr val="white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96132401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4368" r:id="rId1"/>
    <p:sldLayoutId id="2147484369" r:id="rId2"/>
    <p:sldLayoutId id="2147484370" r:id="rId3"/>
    <p:sldLayoutId id="2147484371" r:id="rId4"/>
    <p:sldLayoutId id="2147484372" r:id="rId5"/>
    <p:sldLayoutId id="2147484373" r:id="rId6"/>
    <p:sldLayoutId id="2147484374" r:id="rId7"/>
    <p:sldLayoutId id="2147484375" r:id="rId8"/>
    <p:sldLayoutId id="2147484376" r:id="rId9"/>
    <p:sldLayoutId id="2147484377" r:id="rId10"/>
    <p:sldLayoutId id="2147484378" r:id="rId11"/>
    <p:sldLayoutId id="2147484379" r:id="rId12"/>
    <p:sldLayoutId id="2147484380" r:id="rId13"/>
    <p:sldLayoutId id="2147484381" r:id="rId14"/>
    <p:sldLayoutId id="2147484382" r:id="rId15"/>
    <p:sldLayoutId id="2147484383" r:id="rId16"/>
    <p:sldLayoutId id="2147484384" r:id="rId17"/>
  </p:sldLayoutIdLst>
  <p:txStyles>
    <p:titleStyle>
      <a:lvl1pPr algn="l" defTabSz="457200" rtl="0" eaLnBrk="1" latinLnBrk="0" hangingPunct="1">
        <a:spcBef>
          <a:spcPct val="0"/>
        </a:spcBef>
        <a:buNone/>
        <a:defRPr sz="4200" b="0" i="0" kern="1200">
          <a:solidFill>
            <a:schemeClr val="tx2"/>
          </a:solidFill>
          <a:latin typeface="+mj-lt"/>
          <a:ea typeface="+mj-ea"/>
          <a:cs typeface="+mj-c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342900" indent="-3429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2000" b="0" i="0" kern="1200">
          <a:solidFill>
            <a:schemeClr val="tx1"/>
          </a:solidFill>
          <a:latin typeface="+mj-lt"/>
          <a:ea typeface="+mj-ea"/>
          <a:cs typeface="+mj-cs"/>
        </a:defRPr>
      </a:lvl1pPr>
      <a:lvl2pPr marL="742950" indent="-28575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800" b="0" i="0" kern="1200">
          <a:solidFill>
            <a:schemeClr val="tx1"/>
          </a:solidFill>
          <a:latin typeface="+mj-lt"/>
          <a:ea typeface="+mj-ea"/>
          <a:cs typeface="+mj-cs"/>
        </a:defRPr>
      </a:lvl2pPr>
      <a:lvl3pPr marL="1143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600" b="0" i="0" kern="1200">
          <a:solidFill>
            <a:schemeClr val="tx1"/>
          </a:solidFill>
          <a:latin typeface="+mj-lt"/>
          <a:ea typeface="+mj-ea"/>
          <a:cs typeface="+mj-cs"/>
        </a:defRPr>
      </a:lvl3pPr>
      <a:lvl4pPr marL="1600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4pPr>
      <a:lvl5pPr marL="20574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5pPr>
      <a:lvl6pPr marL="2506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6pPr>
      <a:lvl7pPr marL="29718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7pPr>
      <a:lvl8pPr marL="3429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8pPr>
      <a:lvl9pPr marL="3886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notesSlide" Target="../notesSlides/notesSlide1.xml"/><Relationship Id="rId3" Type="http://schemas.microsoft.com/office/2007/relationships/media" Target="../media/media2.mp4"/><Relationship Id="rId7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11" Type="http://schemas.openxmlformats.org/officeDocument/2006/relationships/image" Target="../media/image9.png"/><Relationship Id="rId5" Type="http://schemas.microsoft.com/office/2007/relationships/media" Target="../media/media3.mp4"/><Relationship Id="rId10" Type="http://schemas.openxmlformats.org/officeDocument/2006/relationships/image" Target="../media/image8.png"/><Relationship Id="rId4" Type="http://schemas.openxmlformats.org/officeDocument/2006/relationships/video" Target="../media/media2.mp4"/><Relationship Id="rId9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microsoft.com/office/2007/relationships/media" Target="../media/media2.mp4"/><Relationship Id="rId7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5" Type="http://schemas.microsoft.com/office/2007/relationships/media" Target="../media/media3.mp4"/><Relationship Id="rId10" Type="http://schemas.openxmlformats.org/officeDocument/2006/relationships/image" Target="../media/image9.png"/><Relationship Id="rId4" Type="http://schemas.openxmlformats.org/officeDocument/2006/relationships/video" Target="../media/media2.mp4"/><Relationship Id="rId9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jpeg"/><Relationship Id="rId5" Type="http://schemas.openxmlformats.org/officeDocument/2006/relationships/image" Target="../media/image12.jpeg"/><Relationship Id="rId4" Type="http://schemas.openxmlformats.org/officeDocument/2006/relationships/image" Target="../media/image11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notesSlide" Target="../notesSlides/notesSlide3.xml"/><Relationship Id="rId3" Type="http://schemas.microsoft.com/office/2007/relationships/media" Target="../media/media5.mp4"/><Relationship Id="rId7" Type="http://schemas.openxmlformats.org/officeDocument/2006/relationships/slideLayout" Target="../slideLayouts/slideLayout7.xml"/><Relationship Id="rId12" Type="http://schemas.openxmlformats.org/officeDocument/2006/relationships/image" Target="../media/image17.png"/><Relationship Id="rId2" Type="http://schemas.openxmlformats.org/officeDocument/2006/relationships/video" Target="../media/media4.mp4"/><Relationship Id="rId1" Type="http://schemas.microsoft.com/office/2007/relationships/media" Target="../media/media4.mp4"/><Relationship Id="rId6" Type="http://schemas.openxmlformats.org/officeDocument/2006/relationships/video" Target="../media/media6.mp4"/><Relationship Id="rId11" Type="http://schemas.openxmlformats.org/officeDocument/2006/relationships/image" Target="../media/image16.png"/><Relationship Id="rId5" Type="http://schemas.microsoft.com/office/2007/relationships/media" Target="../media/media6.mp4"/><Relationship Id="rId10" Type="http://schemas.openxmlformats.org/officeDocument/2006/relationships/image" Target="../media/image15.png"/><Relationship Id="rId4" Type="http://schemas.openxmlformats.org/officeDocument/2006/relationships/video" Target="../media/media5.mp4"/><Relationship Id="rId9" Type="http://schemas.openxmlformats.org/officeDocument/2006/relationships/image" Target="../media/image14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0055646" y="-69119"/>
            <a:ext cx="1998936" cy="814773"/>
            <a:chOff x="9479582" y="-116888"/>
            <a:chExt cx="2729881" cy="1048170"/>
          </a:xfrm>
        </p:grpSpPr>
        <p:sp>
          <p:nvSpPr>
            <p:cNvPr id="4" name="Rectangle 8"/>
            <p:cNvSpPr/>
            <p:nvPr/>
          </p:nvSpPr>
          <p:spPr>
            <a:xfrm rot="5400000" flipH="1">
              <a:off x="10370523" y="-950762"/>
              <a:ext cx="825382" cy="2607264"/>
            </a:xfrm>
            <a:custGeom>
              <a:avLst/>
              <a:gdLst>
                <a:gd name="connsiteX0" fmla="*/ 0 w 381000"/>
                <a:gd name="connsiteY0" fmla="*/ 0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4" fmla="*/ 0 w 381000"/>
                <a:gd name="connsiteY4" fmla="*/ 0 h 1066800"/>
                <a:gd name="connsiteX0" fmla="*/ 155804 w 381000"/>
                <a:gd name="connsiteY0" fmla="*/ 77413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4" fmla="*/ 155804 w 381000"/>
                <a:gd name="connsiteY4" fmla="*/ 77413 h 1066800"/>
                <a:gd name="connsiteX0" fmla="*/ 0 w 381000"/>
                <a:gd name="connsiteY0" fmla="*/ 1066800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0" fmla="*/ 0 w 381000"/>
                <a:gd name="connsiteY0" fmla="*/ 1066800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0" fmla="*/ 0 w 382100"/>
                <a:gd name="connsiteY0" fmla="*/ 1066800 h 1266097"/>
                <a:gd name="connsiteX1" fmla="*/ 381000 w 382100"/>
                <a:gd name="connsiteY1" fmla="*/ 0 h 1266097"/>
                <a:gd name="connsiteX2" fmla="*/ 382100 w 382100"/>
                <a:gd name="connsiteY2" fmla="*/ 1266097 h 1266097"/>
                <a:gd name="connsiteX3" fmla="*/ 0 w 382100"/>
                <a:gd name="connsiteY3" fmla="*/ 1066800 h 1266097"/>
                <a:gd name="connsiteX0" fmla="*/ 81205 w 463305"/>
                <a:gd name="connsiteY0" fmla="*/ 1066800 h 1278547"/>
                <a:gd name="connsiteX1" fmla="*/ 462205 w 463305"/>
                <a:gd name="connsiteY1" fmla="*/ 0 h 1278547"/>
                <a:gd name="connsiteX2" fmla="*/ 463305 w 463305"/>
                <a:gd name="connsiteY2" fmla="*/ 1266097 h 1278547"/>
                <a:gd name="connsiteX3" fmla="*/ 81205 w 463305"/>
                <a:gd name="connsiteY3" fmla="*/ 1066800 h 1278547"/>
                <a:gd name="connsiteX0" fmla="*/ 1100 w 1100"/>
                <a:gd name="connsiteY0" fmla="*/ 1266097 h 1266097"/>
                <a:gd name="connsiteX1" fmla="*/ 0 w 1100"/>
                <a:gd name="connsiteY1" fmla="*/ 0 h 1266097"/>
                <a:gd name="connsiteX2" fmla="*/ 1100 w 1100"/>
                <a:gd name="connsiteY2" fmla="*/ 1266097 h 1266097"/>
                <a:gd name="connsiteX0" fmla="*/ 4504727 w 4504727"/>
                <a:gd name="connsiteY0" fmla="*/ 10000 h 10000"/>
                <a:gd name="connsiteX1" fmla="*/ 4494727 w 4504727"/>
                <a:gd name="connsiteY1" fmla="*/ 0 h 10000"/>
                <a:gd name="connsiteX2" fmla="*/ 4504727 w 4504727"/>
                <a:gd name="connsiteY2" fmla="*/ 10000 h 10000"/>
                <a:gd name="connsiteX0" fmla="*/ 4711554 w 4711554"/>
                <a:gd name="connsiteY0" fmla="*/ 10376 h 10376"/>
                <a:gd name="connsiteX1" fmla="*/ 3938749 w 4711554"/>
                <a:gd name="connsiteY1" fmla="*/ 0 h 10376"/>
                <a:gd name="connsiteX2" fmla="*/ 4711554 w 4711554"/>
                <a:gd name="connsiteY2" fmla="*/ 10376 h 10376"/>
                <a:gd name="connsiteX0" fmla="*/ 5453499 w 5453499"/>
                <a:gd name="connsiteY0" fmla="*/ 10376 h 10376"/>
                <a:gd name="connsiteX1" fmla="*/ 4680694 w 5453499"/>
                <a:gd name="connsiteY1" fmla="*/ 0 h 10376"/>
                <a:gd name="connsiteX2" fmla="*/ 5453499 w 5453499"/>
                <a:gd name="connsiteY2" fmla="*/ 10376 h 10376"/>
                <a:gd name="connsiteX0" fmla="*/ 5188217 w 5193990"/>
                <a:gd name="connsiteY0" fmla="*/ 10193 h 10193"/>
                <a:gd name="connsiteX1" fmla="*/ 5193988 w 5193990"/>
                <a:gd name="connsiteY1" fmla="*/ 0 h 10193"/>
                <a:gd name="connsiteX2" fmla="*/ 5188217 w 5193990"/>
                <a:gd name="connsiteY2" fmla="*/ 10193 h 10193"/>
                <a:gd name="connsiteX0" fmla="*/ 5198190 w 5203963"/>
                <a:gd name="connsiteY0" fmla="*/ 10265 h 10265"/>
                <a:gd name="connsiteX1" fmla="*/ 5203961 w 5203963"/>
                <a:gd name="connsiteY1" fmla="*/ 72 h 10265"/>
                <a:gd name="connsiteX2" fmla="*/ 5198190 w 5203963"/>
                <a:gd name="connsiteY2" fmla="*/ 10265 h 10265"/>
                <a:gd name="connsiteX0" fmla="*/ 3303499 w 3309272"/>
                <a:gd name="connsiteY0" fmla="*/ 10194 h 10194"/>
                <a:gd name="connsiteX1" fmla="*/ 3309270 w 3309272"/>
                <a:gd name="connsiteY1" fmla="*/ 1 h 10194"/>
                <a:gd name="connsiteX2" fmla="*/ 3303499 w 3309272"/>
                <a:gd name="connsiteY2" fmla="*/ 10194 h 10194"/>
                <a:gd name="connsiteX0" fmla="*/ 3375826 w 3381599"/>
                <a:gd name="connsiteY0" fmla="*/ 10193 h 10193"/>
                <a:gd name="connsiteX1" fmla="*/ 3381597 w 3381599"/>
                <a:gd name="connsiteY1" fmla="*/ 0 h 10193"/>
                <a:gd name="connsiteX2" fmla="*/ 3375826 w 3381599"/>
                <a:gd name="connsiteY2" fmla="*/ 10193 h 10193"/>
                <a:gd name="connsiteX0" fmla="*/ 3305544 w 3311317"/>
                <a:gd name="connsiteY0" fmla="*/ 10193 h 10193"/>
                <a:gd name="connsiteX1" fmla="*/ 3311315 w 3311317"/>
                <a:gd name="connsiteY1" fmla="*/ 0 h 10193"/>
                <a:gd name="connsiteX2" fmla="*/ 3305544 w 3311317"/>
                <a:gd name="connsiteY2" fmla="*/ 10193 h 10193"/>
                <a:gd name="connsiteX0" fmla="*/ 3358833 w 3358835"/>
                <a:gd name="connsiteY0" fmla="*/ 8987 h 8987"/>
                <a:gd name="connsiteX1" fmla="*/ 3232079 w 3358835"/>
                <a:gd name="connsiteY1" fmla="*/ 0 h 8987"/>
                <a:gd name="connsiteX2" fmla="*/ 3358833 w 3358835"/>
                <a:gd name="connsiteY2" fmla="*/ 8987 h 8987"/>
                <a:gd name="connsiteX0" fmla="*/ 6470 w 6470"/>
                <a:gd name="connsiteY0" fmla="*/ 10000 h 10000"/>
                <a:gd name="connsiteX1" fmla="*/ 6093 w 6470"/>
                <a:gd name="connsiteY1" fmla="*/ 0 h 10000"/>
                <a:gd name="connsiteX2" fmla="*/ 6470 w 6470"/>
                <a:gd name="connsiteY2" fmla="*/ 10000 h 10000"/>
                <a:gd name="connsiteX0" fmla="*/ 9802 w 9802"/>
                <a:gd name="connsiteY0" fmla="*/ 10000 h 10000"/>
                <a:gd name="connsiteX1" fmla="*/ 9219 w 9802"/>
                <a:gd name="connsiteY1" fmla="*/ 0 h 10000"/>
                <a:gd name="connsiteX2" fmla="*/ 9802 w 9802"/>
                <a:gd name="connsiteY2" fmla="*/ 10000 h 10000"/>
                <a:gd name="connsiteX0" fmla="*/ 9298 w 10018"/>
                <a:gd name="connsiteY0" fmla="*/ 10932 h 10932"/>
                <a:gd name="connsiteX1" fmla="*/ 9994 w 10018"/>
                <a:gd name="connsiteY1" fmla="*/ 0 h 10932"/>
                <a:gd name="connsiteX2" fmla="*/ 9298 w 10018"/>
                <a:gd name="connsiteY2" fmla="*/ 10932 h 10932"/>
                <a:gd name="connsiteX0" fmla="*/ 10017 w 10017"/>
                <a:gd name="connsiteY0" fmla="*/ 10384 h 10384"/>
                <a:gd name="connsiteX1" fmla="*/ 9391 w 10017"/>
                <a:gd name="connsiteY1" fmla="*/ 0 h 10384"/>
                <a:gd name="connsiteX2" fmla="*/ 10017 w 10017"/>
                <a:gd name="connsiteY2" fmla="*/ 10384 h 10384"/>
                <a:gd name="connsiteX0" fmla="*/ 4732 w 4732"/>
                <a:gd name="connsiteY0" fmla="*/ 10390 h 11041"/>
                <a:gd name="connsiteX1" fmla="*/ 4106 w 4732"/>
                <a:gd name="connsiteY1" fmla="*/ 6 h 11041"/>
                <a:gd name="connsiteX2" fmla="*/ 3 w 4732"/>
                <a:gd name="connsiteY2" fmla="*/ 8873 h 11041"/>
                <a:gd name="connsiteX3" fmla="*/ 4732 w 4732"/>
                <a:gd name="connsiteY3" fmla="*/ 10390 h 11041"/>
                <a:gd name="connsiteX0" fmla="*/ 5470 w 5470"/>
                <a:gd name="connsiteY0" fmla="*/ 9410 h 10025"/>
                <a:gd name="connsiteX1" fmla="*/ 4147 w 5470"/>
                <a:gd name="connsiteY1" fmla="*/ 5 h 10025"/>
                <a:gd name="connsiteX2" fmla="*/ 13 w 5470"/>
                <a:gd name="connsiteY2" fmla="*/ 8140 h 10025"/>
                <a:gd name="connsiteX3" fmla="*/ 5470 w 5470"/>
                <a:gd name="connsiteY3" fmla="*/ 9410 h 10025"/>
                <a:gd name="connsiteX0" fmla="*/ 10000 w 10000"/>
                <a:gd name="connsiteY0" fmla="*/ 9387 h 9696"/>
                <a:gd name="connsiteX1" fmla="*/ 7581 w 10000"/>
                <a:gd name="connsiteY1" fmla="*/ 5 h 9696"/>
                <a:gd name="connsiteX2" fmla="*/ 24 w 10000"/>
                <a:gd name="connsiteY2" fmla="*/ 8120 h 9696"/>
                <a:gd name="connsiteX3" fmla="*/ 10000 w 10000"/>
                <a:gd name="connsiteY3" fmla="*/ 9387 h 9696"/>
                <a:gd name="connsiteX0" fmla="*/ 65556 w 65556"/>
                <a:gd name="connsiteY0" fmla="*/ 9686 h 10004"/>
                <a:gd name="connsiteX1" fmla="*/ 63137 w 65556"/>
                <a:gd name="connsiteY1" fmla="*/ 10 h 10004"/>
                <a:gd name="connsiteX2" fmla="*/ 55580 w 65556"/>
                <a:gd name="connsiteY2" fmla="*/ 8380 h 10004"/>
                <a:gd name="connsiteX3" fmla="*/ 65556 w 65556"/>
                <a:gd name="connsiteY3" fmla="*/ 9686 h 10004"/>
                <a:gd name="connsiteX0" fmla="*/ 65556 w 65556"/>
                <a:gd name="connsiteY0" fmla="*/ 9686 h 10140"/>
                <a:gd name="connsiteX1" fmla="*/ 63137 w 65556"/>
                <a:gd name="connsiteY1" fmla="*/ 10 h 10140"/>
                <a:gd name="connsiteX2" fmla="*/ 55580 w 65556"/>
                <a:gd name="connsiteY2" fmla="*/ 8380 h 10140"/>
                <a:gd name="connsiteX3" fmla="*/ 65556 w 65556"/>
                <a:gd name="connsiteY3" fmla="*/ 9686 h 10140"/>
                <a:gd name="connsiteX0" fmla="*/ 64984 w 64984"/>
                <a:gd name="connsiteY0" fmla="*/ 10088 h 10491"/>
                <a:gd name="connsiteX1" fmla="*/ 63137 w 64984"/>
                <a:gd name="connsiteY1" fmla="*/ 10 h 10491"/>
                <a:gd name="connsiteX2" fmla="*/ 55580 w 64984"/>
                <a:gd name="connsiteY2" fmla="*/ 8380 h 10491"/>
                <a:gd name="connsiteX3" fmla="*/ 64984 w 64984"/>
                <a:gd name="connsiteY3" fmla="*/ 10088 h 10491"/>
                <a:gd name="connsiteX0" fmla="*/ 64984 w 64984"/>
                <a:gd name="connsiteY0" fmla="*/ 10088 h 10411"/>
                <a:gd name="connsiteX1" fmla="*/ 63137 w 64984"/>
                <a:gd name="connsiteY1" fmla="*/ 10 h 10411"/>
                <a:gd name="connsiteX2" fmla="*/ 55580 w 64984"/>
                <a:gd name="connsiteY2" fmla="*/ 8380 h 10411"/>
                <a:gd name="connsiteX3" fmla="*/ 64984 w 64984"/>
                <a:gd name="connsiteY3" fmla="*/ 10088 h 10411"/>
                <a:gd name="connsiteX0" fmla="*/ 64984 w 64984"/>
                <a:gd name="connsiteY0" fmla="*/ 10088 h 10088"/>
                <a:gd name="connsiteX1" fmla="*/ 63137 w 64984"/>
                <a:gd name="connsiteY1" fmla="*/ 10 h 10088"/>
                <a:gd name="connsiteX2" fmla="*/ 55580 w 64984"/>
                <a:gd name="connsiteY2" fmla="*/ 8380 h 10088"/>
                <a:gd name="connsiteX3" fmla="*/ 64984 w 64984"/>
                <a:gd name="connsiteY3" fmla="*/ 10088 h 10088"/>
                <a:gd name="connsiteX0" fmla="*/ 64984 w 64984"/>
                <a:gd name="connsiteY0" fmla="*/ 10088 h 10088"/>
                <a:gd name="connsiteX1" fmla="*/ 63137 w 64984"/>
                <a:gd name="connsiteY1" fmla="*/ 10 h 10088"/>
                <a:gd name="connsiteX2" fmla="*/ 55580 w 64984"/>
                <a:gd name="connsiteY2" fmla="*/ 8380 h 10088"/>
                <a:gd name="connsiteX3" fmla="*/ 64984 w 64984"/>
                <a:gd name="connsiteY3" fmla="*/ 10088 h 10088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373 w 80373"/>
                <a:gd name="connsiteY0" fmla="*/ 10131 h 10131"/>
                <a:gd name="connsiteX1" fmla="*/ 78526 w 80373"/>
                <a:gd name="connsiteY1" fmla="*/ 53 h 10131"/>
                <a:gd name="connsiteX2" fmla="*/ 51392 w 80373"/>
                <a:gd name="connsiteY2" fmla="*/ 7671 h 10131"/>
                <a:gd name="connsiteX3" fmla="*/ 80373 w 80373"/>
                <a:gd name="connsiteY3" fmla="*/ 10131 h 10131"/>
                <a:gd name="connsiteX0" fmla="*/ 62961 w 62961"/>
                <a:gd name="connsiteY0" fmla="*/ 10126 h 10126"/>
                <a:gd name="connsiteX1" fmla="*/ 61114 w 62961"/>
                <a:gd name="connsiteY1" fmla="*/ 48 h 10126"/>
                <a:gd name="connsiteX2" fmla="*/ 33980 w 62961"/>
                <a:gd name="connsiteY2" fmla="*/ 7666 h 10126"/>
                <a:gd name="connsiteX3" fmla="*/ 62961 w 62961"/>
                <a:gd name="connsiteY3" fmla="*/ 10126 h 10126"/>
                <a:gd name="connsiteX0" fmla="*/ 62961 w 62961"/>
                <a:gd name="connsiteY0" fmla="*/ 10126 h 10126"/>
                <a:gd name="connsiteX1" fmla="*/ 61114 w 62961"/>
                <a:gd name="connsiteY1" fmla="*/ 48 h 10126"/>
                <a:gd name="connsiteX2" fmla="*/ 33980 w 62961"/>
                <a:gd name="connsiteY2" fmla="*/ 7666 h 10126"/>
                <a:gd name="connsiteX3" fmla="*/ 62961 w 62961"/>
                <a:gd name="connsiteY3" fmla="*/ 10126 h 10126"/>
                <a:gd name="connsiteX0" fmla="*/ 62357 w 62357"/>
                <a:gd name="connsiteY0" fmla="*/ 9891 h 9891"/>
                <a:gd name="connsiteX1" fmla="*/ 61114 w 62357"/>
                <a:gd name="connsiteY1" fmla="*/ 48 h 9891"/>
                <a:gd name="connsiteX2" fmla="*/ 33980 w 62357"/>
                <a:gd name="connsiteY2" fmla="*/ 7666 h 9891"/>
                <a:gd name="connsiteX3" fmla="*/ 62357 w 62357"/>
                <a:gd name="connsiteY3" fmla="*/ 9891 h 9891"/>
                <a:gd name="connsiteX0" fmla="*/ 10000 w 10178"/>
                <a:gd name="connsiteY0" fmla="*/ 10000 h 10000"/>
                <a:gd name="connsiteX1" fmla="*/ 9801 w 10178"/>
                <a:gd name="connsiteY1" fmla="*/ 49 h 10000"/>
                <a:gd name="connsiteX2" fmla="*/ 5449 w 10178"/>
                <a:gd name="connsiteY2" fmla="*/ 7750 h 10000"/>
                <a:gd name="connsiteX3" fmla="*/ 10000 w 10178"/>
                <a:gd name="connsiteY3" fmla="*/ 10000 h 10000"/>
                <a:gd name="connsiteX0" fmla="*/ 10000 w 10178"/>
                <a:gd name="connsiteY0" fmla="*/ 10000 h 10000"/>
                <a:gd name="connsiteX1" fmla="*/ 9801 w 10178"/>
                <a:gd name="connsiteY1" fmla="*/ 49 h 10000"/>
                <a:gd name="connsiteX2" fmla="*/ 5449 w 10178"/>
                <a:gd name="connsiteY2" fmla="*/ 7750 h 10000"/>
                <a:gd name="connsiteX3" fmla="*/ 10000 w 10178"/>
                <a:gd name="connsiteY3" fmla="*/ 10000 h 10000"/>
                <a:gd name="connsiteX0" fmla="*/ 10000 w 10178"/>
                <a:gd name="connsiteY0" fmla="*/ 10000 h 10000"/>
                <a:gd name="connsiteX1" fmla="*/ 9801 w 10178"/>
                <a:gd name="connsiteY1" fmla="*/ 49 h 10000"/>
                <a:gd name="connsiteX2" fmla="*/ 5449 w 10178"/>
                <a:gd name="connsiteY2" fmla="*/ 7750 h 10000"/>
                <a:gd name="connsiteX3" fmla="*/ 10000 w 10178"/>
                <a:gd name="connsiteY3" fmla="*/ 10000 h 10000"/>
                <a:gd name="connsiteX0" fmla="*/ 10267 w 10403"/>
                <a:gd name="connsiteY0" fmla="*/ 9740 h 9740"/>
                <a:gd name="connsiteX1" fmla="*/ 9801 w 10403"/>
                <a:gd name="connsiteY1" fmla="*/ 49 h 9740"/>
                <a:gd name="connsiteX2" fmla="*/ 5449 w 10403"/>
                <a:gd name="connsiteY2" fmla="*/ 7750 h 9740"/>
                <a:gd name="connsiteX3" fmla="*/ 10267 w 10403"/>
                <a:gd name="connsiteY3" fmla="*/ 9740 h 9740"/>
                <a:gd name="connsiteX0" fmla="*/ 9564 w 9745"/>
                <a:gd name="connsiteY0" fmla="*/ 9865 h 9865"/>
                <a:gd name="connsiteX1" fmla="*/ 9421 w 9745"/>
                <a:gd name="connsiteY1" fmla="*/ 50 h 9865"/>
                <a:gd name="connsiteX2" fmla="*/ 5238 w 9745"/>
                <a:gd name="connsiteY2" fmla="*/ 7957 h 9865"/>
                <a:gd name="connsiteX3" fmla="*/ 9564 w 9745"/>
                <a:gd name="connsiteY3" fmla="*/ 9865 h 9865"/>
                <a:gd name="connsiteX0" fmla="*/ 10130 w 10317"/>
                <a:gd name="connsiteY0" fmla="*/ 10000 h 10000"/>
                <a:gd name="connsiteX1" fmla="*/ 9984 w 10317"/>
                <a:gd name="connsiteY1" fmla="*/ 51 h 10000"/>
                <a:gd name="connsiteX2" fmla="*/ 5691 w 10317"/>
                <a:gd name="connsiteY2" fmla="*/ 8066 h 10000"/>
                <a:gd name="connsiteX3" fmla="*/ 10130 w 10317"/>
                <a:gd name="connsiteY3" fmla="*/ 10000 h 10000"/>
                <a:gd name="connsiteX0" fmla="*/ 10130 w 10317"/>
                <a:gd name="connsiteY0" fmla="*/ 10000 h 10000"/>
                <a:gd name="connsiteX1" fmla="*/ 9984 w 10317"/>
                <a:gd name="connsiteY1" fmla="*/ 51 h 10000"/>
                <a:gd name="connsiteX2" fmla="*/ 5691 w 10317"/>
                <a:gd name="connsiteY2" fmla="*/ 8066 h 10000"/>
                <a:gd name="connsiteX3" fmla="*/ 10130 w 10317"/>
                <a:gd name="connsiteY3" fmla="*/ 10000 h 10000"/>
                <a:gd name="connsiteX0" fmla="*/ 10130 w 10317"/>
                <a:gd name="connsiteY0" fmla="*/ 10000 h 10000"/>
                <a:gd name="connsiteX1" fmla="*/ 9984 w 10317"/>
                <a:gd name="connsiteY1" fmla="*/ 51 h 10000"/>
                <a:gd name="connsiteX2" fmla="*/ 5691 w 10317"/>
                <a:gd name="connsiteY2" fmla="*/ 8066 h 10000"/>
                <a:gd name="connsiteX3" fmla="*/ 10130 w 10317"/>
                <a:gd name="connsiteY3" fmla="*/ 10000 h 10000"/>
                <a:gd name="connsiteX0" fmla="*/ 9833 w 10120"/>
                <a:gd name="connsiteY0" fmla="*/ 10175 h 10175"/>
                <a:gd name="connsiteX1" fmla="*/ 9984 w 10120"/>
                <a:gd name="connsiteY1" fmla="*/ 51 h 10175"/>
                <a:gd name="connsiteX2" fmla="*/ 5691 w 10120"/>
                <a:gd name="connsiteY2" fmla="*/ 8066 h 10175"/>
                <a:gd name="connsiteX3" fmla="*/ 9833 w 10120"/>
                <a:gd name="connsiteY3" fmla="*/ 10175 h 10175"/>
                <a:gd name="connsiteX0" fmla="*/ 9960 w 10194"/>
                <a:gd name="connsiteY0" fmla="*/ 10252 h 10252"/>
                <a:gd name="connsiteX1" fmla="*/ 9984 w 10194"/>
                <a:gd name="connsiteY1" fmla="*/ 51 h 10252"/>
                <a:gd name="connsiteX2" fmla="*/ 5691 w 10194"/>
                <a:gd name="connsiteY2" fmla="*/ 8066 h 10252"/>
                <a:gd name="connsiteX3" fmla="*/ 9960 w 10194"/>
                <a:gd name="connsiteY3" fmla="*/ 10252 h 10252"/>
                <a:gd name="connsiteX0" fmla="*/ 9960 w 10194"/>
                <a:gd name="connsiteY0" fmla="*/ 10252 h 10252"/>
                <a:gd name="connsiteX1" fmla="*/ 9984 w 10194"/>
                <a:gd name="connsiteY1" fmla="*/ 51 h 10252"/>
                <a:gd name="connsiteX2" fmla="*/ 5691 w 10194"/>
                <a:gd name="connsiteY2" fmla="*/ 8066 h 10252"/>
                <a:gd name="connsiteX3" fmla="*/ 9960 w 10194"/>
                <a:gd name="connsiteY3" fmla="*/ 10252 h 10252"/>
                <a:gd name="connsiteX0" fmla="*/ 10201 w 10373"/>
                <a:gd name="connsiteY0" fmla="*/ 10161 h 10161"/>
                <a:gd name="connsiteX1" fmla="*/ 9984 w 10373"/>
                <a:gd name="connsiteY1" fmla="*/ 51 h 10161"/>
                <a:gd name="connsiteX2" fmla="*/ 5691 w 10373"/>
                <a:gd name="connsiteY2" fmla="*/ 8066 h 10161"/>
                <a:gd name="connsiteX3" fmla="*/ 10201 w 10373"/>
                <a:gd name="connsiteY3" fmla="*/ 10161 h 10161"/>
                <a:gd name="connsiteX0" fmla="*/ 10201 w 10373"/>
                <a:gd name="connsiteY0" fmla="*/ 10161 h 10161"/>
                <a:gd name="connsiteX1" fmla="*/ 9984 w 10373"/>
                <a:gd name="connsiteY1" fmla="*/ 51 h 10161"/>
                <a:gd name="connsiteX2" fmla="*/ 5691 w 10373"/>
                <a:gd name="connsiteY2" fmla="*/ 8066 h 10161"/>
                <a:gd name="connsiteX3" fmla="*/ 10201 w 10373"/>
                <a:gd name="connsiteY3" fmla="*/ 10161 h 10161"/>
                <a:gd name="connsiteX0" fmla="*/ 10592 w 10710"/>
                <a:gd name="connsiteY0" fmla="*/ 10201 h 10201"/>
                <a:gd name="connsiteX1" fmla="*/ 9984 w 10710"/>
                <a:gd name="connsiteY1" fmla="*/ 51 h 10201"/>
                <a:gd name="connsiteX2" fmla="*/ 5691 w 10710"/>
                <a:gd name="connsiteY2" fmla="*/ 8066 h 10201"/>
                <a:gd name="connsiteX3" fmla="*/ 10592 w 10710"/>
                <a:gd name="connsiteY3" fmla="*/ 10201 h 10201"/>
                <a:gd name="connsiteX0" fmla="*/ 10592 w 10710"/>
                <a:gd name="connsiteY0" fmla="*/ 10201 h 10201"/>
                <a:gd name="connsiteX1" fmla="*/ 9984 w 10710"/>
                <a:gd name="connsiteY1" fmla="*/ 51 h 10201"/>
                <a:gd name="connsiteX2" fmla="*/ 5691 w 10710"/>
                <a:gd name="connsiteY2" fmla="*/ 8066 h 10201"/>
                <a:gd name="connsiteX3" fmla="*/ 10592 w 10710"/>
                <a:gd name="connsiteY3" fmla="*/ 10201 h 10201"/>
                <a:gd name="connsiteX0" fmla="*/ 10592 w 10710"/>
                <a:gd name="connsiteY0" fmla="*/ 10201 h 10201"/>
                <a:gd name="connsiteX1" fmla="*/ 9984 w 10710"/>
                <a:gd name="connsiteY1" fmla="*/ 51 h 10201"/>
                <a:gd name="connsiteX2" fmla="*/ 5691 w 10710"/>
                <a:gd name="connsiteY2" fmla="*/ 8066 h 10201"/>
                <a:gd name="connsiteX3" fmla="*/ 10592 w 10710"/>
                <a:gd name="connsiteY3" fmla="*/ 10201 h 10201"/>
                <a:gd name="connsiteX0" fmla="*/ 10934 w 11052"/>
                <a:gd name="connsiteY0" fmla="*/ 10201 h 10201"/>
                <a:gd name="connsiteX1" fmla="*/ 10326 w 11052"/>
                <a:gd name="connsiteY1" fmla="*/ 51 h 10201"/>
                <a:gd name="connsiteX2" fmla="*/ 5609 w 11052"/>
                <a:gd name="connsiteY2" fmla="*/ 8164 h 10201"/>
                <a:gd name="connsiteX3" fmla="*/ 10934 w 11052"/>
                <a:gd name="connsiteY3" fmla="*/ 10201 h 10201"/>
                <a:gd name="connsiteX0" fmla="*/ 10934 w 11052"/>
                <a:gd name="connsiteY0" fmla="*/ 10201 h 10201"/>
                <a:gd name="connsiteX1" fmla="*/ 10326 w 11052"/>
                <a:gd name="connsiteY1" fmla="*/ 51 h 10201"/>
                <a:gd name="connsiteX2" fmla="*/ 5609 w 11052"/>
                <a:gd name="connsiteY2" fmla="*/ 8164 h 10201"/>
                <a:gd name="connsiteX3" fmla="*/ 10934 w 11052"/>
                <a:gd name="connsiteY3" fmla="*/ 10201 h 10201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8463 w 18581"/>
                <a:gd name="connsiteY0" fmla="*/ 10150 h 10150"/>
                <a:gd name="connsiteX1" fmla="*/ 17855 w 18581"/>
                <a:gd name="connsiteY1" fmla="*/ 0 h 10150"/>
                <a:gd name="connsiteX2" fmla="*/ 12596 w 18581"/>
                <a:gd name="connsiteY2" fmla="*/ 7942 h 10150"/>
                <a:gd name="connsiteX3" fmla="*/ 18463 w 18581"/>
                <a:gd name="connsiteY3" fmla="*/ 10150 h 10150"/>
                <a:gd name="connsiteX0" fmla="*/ 608 w 726"/>
                <a:gd name="connsiteY0" fmla="*/ 10150 h 10150"/>
                <a:gd name="connsiteX1" fmla="*/ 0 w 726"/>
                <a:gd name="connsiteY1" fmla="*/ 0 h 10150"/>
                <a:gd name="connsiteX2" fmla="*/ 608 w 726"/>
                <a:gd name="connsiteY2" fmla="*/ 10150 h 10150"/>
                <a:gd name="connsiteX0" fmla="*/ 59658 w 61295"/>
                <a:gd name="connsiteY0" fmla="*/ 10000 h 10000"/>
                <a:gd name="connsiteX1" fmla="*/ 51283 w 61295"/>
                <a:gd name="connsiteY1" fmla="*/ 0 h 10000"/>
                <a:gd name="connsiteX2" fmla="*/ 59658 w 61295"/>
                <a:gd name="connsiteY2" fmla="*/ 10000 h 10000"/>
                <a:gd name="connsiteX0" fmla="*/ 59658 w 84651"/>
                <a:gd name="connsiteY0" fmla="*/ 10000 h 10000"/>
                <a:gd name="connsiteX1" fmla="*/ 51283 w 84651"/>
                <a:gd name="connsiteY1" fmla="*/ 0 h 10000"/>
                <a:gd name="connsiteX2" fmla="*/ 59658 w 84651"/>
                <a:gd name="connsiteY2" fmla="*/ 10000 h 10000"/>
                <a:gd name="connsiteX0" fmla="*/ 148647 w 173640"/>
                <a:gd name="connsiteY0" fmla="*/ 10000 h 10000"/>
                <a:gd name="connsiteX1" fmla="*/ 140272 w 173640"/>
                <a:gd name="connsiteY1" fmla="*/ 0 h 10000"/>
                <a:gd name="connsiteX2" fmla="*/ 148647 w 173640"/>
                <a:gd name="connsiteY2" fmla="*/ 10000 h 10000"/>
                <a:gd name="connsiteX0" fmla="*/ 148647 w 153064"/>
                <a:gd name="connsiteY0" fmla="*/ 10000 h 10000"/>
                <a:gd name="connsiteX1" fmla="*/ 140272 w 153064"/>
                <a:gd name="connsiteY1" fmla="*/ 0 h 10000"/>
                <a:gd name="connsiteX2" fmla="*/ 148647 w 153064"/>
                <a:gd name="connsiteY2" fmla="*/ 10000 h 10000"/>
                <a:gd name="connsiteX0" fmla="*/ 148647 w 148647"/>
                <a:gd name="connsiteY0" fmla="*/ 10000 h 10000"/>
                <a:gd name="connsiteX1" fmla="*/ 140272 w 148647"/>
                <a:gd name="connsiteY1" fmla="*/ 0 h 10000"/>
                <a:gd name="connsiteX2" fmla="*/ 148647 w 148647"/>
                <a:gd name="connsiteY2" fmla="*/ 10000 h 10000"/>
                <a:gd name="connsiteX0" fmla="*/ 154722 w 154722"/>
                <a:gd name="connsiteY0" fmla="*/ 10000 h 10000"/>
                <a:gd name="connsiteX1" fmla="*/ 146347 w 154722"/>
                <a:gd name="connsiteY1" fmla="*/ 0 h 10000"/>
                <a:gd name="connsiteX2" fmla="*/ 154722 w 154722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3231"/>
                <a:gd name="connsiteY0" fmla="*/ 10000 h 10000"/>
                <a:gd name="connsiteX1" fmla="*/ 144350 w 153231"/>
                <a:gd name="connsiteY1" fmla="*/ 0 h 10000"/>
                <a:gd name="connsiteX2" fmla="*/ 152725 w 153231"/>
                <a:gd name="connsiteY2" fmla="*/ 10000 h 10000"/>
                <a:gd name="connsiteX0" fmla="*/ 152725 w 153930"/>
                <a:gd name="connsiteY0" fmla="*/ 10000 h 10000"/>
                <a:gd name="connsiteX1" fmla="*/ 144350 w 153930"/>
                <a:gd name="connsiteY1" fmla="*/ 0 h 10000"/>
                <a:gd name="connsiteX2" fmla="*/ 152725 w 153930"/>
                <a:gd name="connsiteY2" fmla="*/ 10000 h 10000"/>
                <a:gd name="connsiteX0" fmla="*/ 152725 w 156746"/>
                <a:gd name="connsiteY0" fmla="*/ 10000 h 10000"/>
                <a:gd name="connsiteX1" fmla="*/ 144350 w 156746"/>
                <a:gd name="connsiteY1" fmla="*/ 0 h 10000"/>
                <a:gd name="connsiteX2" fmla="*/ 152725 w 156746"/>
                <a:gd name="connsiteY2" fmla="*/ 10000 h 10000"/>
                <a:gd name="connsiteX0" fmla="*/ 156368 w 160389"/>
                <a:gd name="connsiteY0" fmla="*/ 10000 h 10000"/>
                <a:gd name="connsiteX1" fmla="*/ 147993 w 160389"/>
                <a:gd name="connsiteY1" fmla="*/ 0 h 10000"/>
                <a:gd name="connsiteX2" fmla="*/ 156368 w 160389"/>
                <a:gd name="connsiteY2" fmla="*/ 10000 h 10000"/>
                <a:gd name="connsiteX0" fmla="*/ 159522 w 163543"/>
                <a:gd name="connsiteY0" fmla="*/ 10000 h 10000"/>
                <a:gd name="connsiteX1" fmla="*/ 151147 w 163543"/>
                <a:gd name="connsiteY1" fmla="*/ 0 h 10000"/>
                <a:gd name="connsiteX2" fmla="*/ 159522 w 163543"/>
                <a:gd name="connsiteY2" fmla="*/ 10000 h 10000"/>
                <a:gd name="connsiteX0" fmla="*/ 164492 w 168513"/>
                <a:gd name="connsiteY0" fmla="*/ 10000 h 10000"/>
                <a:gd name="connsiteX1" fmla="*/ 156117 w 168513"/>
                <a:gd name="connsiteY1" fmla="*/ 0 h 10000"/>
                <a:gd name="connsiteX2" fmla="*/ 164492 w 168513"/>
                <a:gd name="connsiteY2" fmla="*/ 10000 h 10000"/>
                <a:gd name="connsiteX0" fmla="*/ 157865 w 166869"/>
                <a:gd name="connsiteY0" fmla="*/ 10241 h 10241"/>
                <a:gd name="connsiteX1" fmla="*/ 161044 w 166869"/>
                <a:gd name="connsiteY1" fmla="*/ 0 h 10241"/>
                <a:gd name="connsiteX2" fmla="*/ 157865 w 166869"/>
                <a:gd name="connsiteY2" fmla="*/ 10241 h 1024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66869" h="10241">
                  <a:moveTo>
                    <a:pt x="157865" y="10241"/>
                  </a:moveTo>
                  <a:cubicBezTo>
                    <a:pt x="166687" y="7400"/>
                    <a:pt x="171237" y="2927"/>
                    <a:pt x="161044" y="0"/>
                  </a:cubicBezTo>
                  <a:cubicBezTo>
                    <a:pt x="-90146" y="1558"/>
                    <a:pt x="-12963" y="7628"/>
                    <a:pt x="157865" y="10241"/>
                  </a:cubicBezTo>
                  <a:close/>
                </a:path>
              </a:pathLst>
            </a:custGeom>
            <a:gradFill flip="none" rotWithShape="1">
              <a:gsLst>
                <a:gs pos="20000">
                  <a:srgbClr val="DFDFDF"/>
                </a:gs>
                <a:gs pos="0">
                  <a:sysClr val="window" lastClr="FFFFFF">
                    <a:lumMod val="95000"/>
                  </a:sysClr>
                </a:gs>
                <a:gs pos="97000">
                  <a:sysClr val="window" lastClr="FFFFFF">
                    <a:lumMod val="65000"/>
                  </a:sysClr>
                </a:gs>
                <a:gs pos="69000">
                  <a:sysClr val="windowText" lastClr="000000">
                    <a:lumMod val="50000"/>
                    <a:lumOff val="50000"/>
                  </a:sysClr>
                </a:gs>
                <a:gs pos="84000">
                  <a:sysClr val="window" lastClr="FFFFFF">
                    <a:lumMod val="95000"/>
                  </a:sysClr>
                </a:gs>
              </a:gsLst>
              <a:lin ang="0" scaled="1"/>
              <a:tileRect/>
            </a:gradFill>
            <a:ln w="25400" cap="flat" cmpd="sng" algn="ctr">
              <a:noFill/>
              <a:prstDash val="solid"/>
            </a:ln>
            <a:effectLst>
              <a:outerShdw blurRad="177800" dist="38100" dir="720000" algn="l" rotWithShape="0">
                <a:prstClr val="black">
                  <a:alpha val="63000"/>
                </a:prstClr>
              </a:outerShdw>
            </a:effectLst>
          </p:spPr>
          <p:txBody>
            <a:bodyPr rtlCol="0" anchor="ctr"/>
            <a:lstStyle/>
            <a:p>
              <a:pPr algn="ctr">
                <a:defRPr/>
              </a:pPr>
              <a:endParaRPr lang="en-US" sz="1200" kern="0">
                <a:solidFill>
                  <a:sysClr val="window" lastClr="FFFFFF"/>
                </a:solidFill>
              </a:endParaRPr>
            </a:p>
          </p:txBody>
        </p:sp>
        <p:sp>
          <p:nvSpPr>
            <p:cNvPr id="5" name="Rectangle 4"/>
            <p:cNvSpPr/>
            <p:nvPr/>
          </p:nvSpPr>
          <p:spPr>
            <a:xfrm>
              <a:off x="9592047" y="-116888"/>
              <a:ext cx="2617416" cy="1048170"/>
            </a:xfrm>
            <a:prstGeom prst="rect">
              <a:avLst/>
            </a:prstGeom>
            <a:noFill/>
          </p:spPr>
          <p:txBody>
            <a:bodyPr wrap="square" lIns="432044" tIns="216022" rIns="432044" bIns="216022">
              <a:spAutoFit/>
            </a:bodyPr>
            <a:lstStyle>
              <a:defPPr>
                <a:defRPr lang="ar-EG"/>
              </a:defPPr>
              <a:lvl1pPr marL="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defTabSz="914363" rtl="0">
                <a:spcBef>
                  <a:spcPct val="0"/>
                </a:spcBef>
                <a:defRPr/>
              </a:pPr>
              <a:r>
                <a:rPr lang="en-US" sz="1400" cap="small" dirty="0" smtClean="0">
                  <a:ln w="12700">
                    <a:noFill/>
                  </a:ln>
                  <a:solidFill>
                    <a:prstClr val="black"/>
                  </a:solidFill>
                  <a:latin typeface="Book Antiqua" pitchFamily="18" charset="0"/>
                  <a:cs typeface="Diwani Letter" pitchFamily="2" charset="-78"/>
                </a:rPr>
                <a:t>Results </a:t>
              </a:r>
              <a:endParaRPr lang="ar-EG" sz="1200" cap="small" dirty="0">
                <a:ln w="12700">
                  <a:noFill/>
                </a:ln>
                <a:solidFill>
                  <a:prstClr val="black"/>
                </a:solidFill>
                <a:latin typeface="Book Antiqua" pitchFamily="18" charset="0"/>
                <a:cs typeface="Diwani Letter" pitchFamily="2" charset="-78"/>
              </a:endParaRPr>
            </a:p>
          </p:txBody>
        </p:sp>
      </p:grpSp>
      <p:sp>
        <p:nvSpPr>
          <p:cNvPr id="7" name="Rectangle 6"/>
          <p:cNvSpPr/>
          <p:nvPr/>
        </p:nvSpPr>
        <p:spPr>
          <a:xfrm>
            <a:off x="4943635" y="2664314"/>
            <a:ext cx="6647268" cy="1484766"/>
          </a:xfrm>
          <a:prstGeom prst="rect">
            <a:avLst/>
          </a:prstGeom>
          <a:solidFill>
            <a:schemeClr val="tx1">
              <a:alpha val="7000"/>
            </a:schemeClr>
          </a:solidFill>
          <a:ln w="19050" cap="flat" cmpd="sng" algn="ctr">
            <a:gradFill flip="none" rotWithShape="1">
              <a:gsLst>
                <a:gs pos="0">
                  <a:srgbClr val="FBE4AE"/>
                </a:gs>
                <a:gs pos="13000">
                  <a:srgbClr val="BD922A"/>
                </a:gs>
                <a:gs pos="21001">
                  <a:srgbClr val="BD922A"/>
                </a:gs>
                <a:gs pos="63000">
                  <a:srgbClr val="FBE4AE"/>
                </a:gs>
                <a:gs pos="67000">
                  <a:srgbClr val="BD922A"/>
                </a:gs>
                <a:gs pos="69000">
                  <a:srgbClr val="835E17"/>
                </a:gs>
                <a:gs pos="82001">
                  <a:srgbClr val="A28949"/>
                </a:gs>
                <a:gs pos="100000">
                  <a:srgbClr val="FAE3B7"/>
                </a:gs>
              </a:gsLst>
              <a:lin ang="18900000" scaled="1"/>
              <a:tileRect/>
            </a:gra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l" rtl="0"/>
            <a:endParaRPr lang="ar-EG" sz="3600" kern="0">
              <a:solidFill>
                <a:sysClr val="window" lastClr="FFFFFF"/>
              </a:solidFill>
              <a:latin typeface="Cambria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730522" y="3072287"/>
            <a:ext cx="9207542" cy="576248"/>
          </a:xfrm>
          <a:prstGeom prst="rect">
            <a:avLst/>
          </a:prstGeom>
          <a:noFill/>
          <a:ln>
            <a:noFill/>
          </a:ln>
          <a:effectLst>
            <a:glow rad="25400">
              <a:schemeClr val="tx1">
                <a:alpha val="99000"/>
              </a:schemeClr>
            </a:glow>
          </a:effectLst>
        </p:spPr>
        <p:txBody>
          <a:bodyPr wrap="square" rtlCol="1">
            <a:spAutoFit/>
          </a:bodyPr>
          <a:lstStyle>
            <a:defPPr>
              <a:defRPr lang="ar-EG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ctr" defTabSz="914363" rtl="0">
              <a:lnSpc>
                <a:spcPct val="120000"/>
              </a:lnSpc>
              <a:spcBef>
                <a:spcPct val="0"/>
              </a:spcBef>
              <a:defRPr/>
            </a:pPr>
            <a:r>
              <a:rPr lang="en-US" sz="2800" b="1" kern="0" dirty="0" smtClean="0">
                <a:solidFill>
                  <a:srgbClr val="E8B7B7">
                    <a:lumMod val="20000"/>
                    <a:lumOff val="80000"/>
                  </a:srgbClr>
                </a:solidFill>
                <a:effectLst>
                  <a:glow rad="25400">
                    <a:sysClr val="windowText" lastClr="000000">
                      <a:alpha val="99000"/>
                    </a:sysClr>
                  </a:glow>
                  <a:outerShdw blurRad="50800" dist="38100" dir="2700000" algn="tl" rotWithShape="0">
                    <a:prstClr val="black"/>
                  </a:outerShdw>
                </a:effectLst>
                <a:latin typeface="Book Antiqua" pitchFamily="18" charset="0"/>
                <a:cs typeface="Arial" charset="0"/>
              </a:rPr>
              <a:t>Full Volume 3D Echocardiography</a:t>
            </a:r>
            <a:endParaRPr lang="en-US" sz="2800" b="1" kern="0" dirty="0">
              <a:solidFill>
                <a:srgbClr val="E8B7B7">
                  <a:lumMod val="20000"/>
                  <a:lumOff val="80000"/>
                </a:srgbClr>
              </a:solidFill>
              <a:effectLst>
                <a:glow rad="25400">
                  <a:sysClr val="windowText" lastClr="000000">
                    <a:alpha val="99000"/>
                  </a:sysClr>
                </a:glow>
                <a:outerShdw blurRad="50800" dist="38100" dir="2700000" algn="tl" rotWithShape="0">
                  <a:prstClr val="black"/>
                </a:outerShdw>
              </a:effectLst>
              <a:latin typeface="Book Antiqua" pitchFamily="18" charset="0"/>
              <a:cs typeface="Arial" charset="0"/>
            </a:endParaRPr>
          </a:p>
        </p:txBody>
      </p:sp>
      <p:pic>
        <p:nvPicPr>
          <p:cNvPr id="24" name="Picture 2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574926" y="980728"/>
            <a:ext cx="4759367" cy="47593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5" name="Rectangle 24"/>
          <p:cNvSpPr/>
          <p:nvPr/>
        </p:nvSpPr>
        <p:spPr>
          <a:xfrm>
            <a:off x="4219516" y="2733902"/>
            <a:ext cx="3517885" cy="1631202"/>
          </a:xfrm>
          <a:prstGeom prst="rect">
            <a:avLst/>
          </a:prstGeom>
        </p:spPr>
        <p:txBody>
          <a:bodyPr wrap="square" lIns="91427" tIns="45713" rIns="91427" bIns="45713">
            <a:spAutoFit/>
          </a:bodyPr>
          <a:lstStyle/>
          <a:p>
            <a:pPr lvl="0" algn="ctr" defTabSz="914363">
              <a:spcBef>
                <a:spcPct val="0"/>
              </a:spcBef>
              <a:defRPr/>
            </a:pPr>
            <a:r>
              <a:rPr lang="en-US" sz="3400" b="1" kern="0" spc="300" dirty="0">
                <a:solidFill>
                  <a:srgbClr val="B01513"/>
                </a:solidFill>
                <a:latin typeface="Book Antiqua" pitchFamily="18" charset="0"/>
                <a:cs typeface="AF_Unizah " pitchFamily="2" charset="-78"/>
              </a:rPr>
              <a:t>A case of</a:t>
            </a:r>
          </a:p>
          <a:p>
            <a:pPr lvl="0" algn="ctr" defTabSz="914363">
              <a:spcBef>
                <a:spcPct val="0"/>
              </a:spcBef>
              <a:defRPr/>
            </a:pPr>
            <a:r>
              <a:rPr lang="en-US" sz="6600" b="1" kern="0" spc="300" dirty="0">
                <a:gradFill flip="none" rotWithShape="1">
                  <a:gsLst>
                    <a:gs pos="0">
                      <a:srgbClr val="38979E">
                        <a:shade val="30000"/>
                        <a:satMod val="115000"/>
                      </a:srgbClr>
                    </a:gs>
                    <a:gs pos="50000">
                      <a:srgbClr val="38979E">
                        <a:shade val="67500"/>
                        <a:satMod val="115000"/>
                      </a:srgbClr>
                    </a:gs>
                    <a:gs pos="100000">
                      <a:srgbClr val="38979E">
                        <a:shade val="100000"/>
                        <a:satMod val="115000"/>
                      </a:srgbClr>
                    </a:gs>
                  </a:gsLst>
                  <a:lin ang="16200000" scaled="1"/>
                  <a:tileRect/>
                </a:gradFill>
                <a:latin typeface="Book Antiqua" pitchFamily="18" charset="0"/>
                <a:cs typeface="AF_Unizah " pitchFamily="2" charset="-78"/>
              </a:rPr>
              <a:t>PIVD</a:t>
            </a:r>
            <a:endParaRPr lang="en-US" sz="6000" b="1" kern="0" spc="300" dirty="0">
              <a:gradFill flip="none" rotWithShape="1">
                <a:gsLst>
                  <a:gs pos="0">
                    <a:srgbClr val="38979E">
                      <a:shade val="30000"/>
                      <a:satMod val="115000"/>
                    </a:srgbClr>
                  </a:gs>
                  <a:gs pos="50000">
                    <a:srgbClr val="38979E">
                      <a:shade val="67500"/>
                      <a:satMod val="115000"/>
                    </a:srgbClr>
                  </a:gs>
                  <a:gs pos="100000">
                    <a:srgbClr val="38979E">
                      <a:shade val="100000"/>
                      <a:satMod val="115000"/>
                    </a:srgbClr>
                  </a:gs>
                </a:gsLst>
                <a:lin ang="16200000" scaled="1"/>
                <a:tileRect/>
              </a:gradFill>
              <a:latin typeface="Book Antiqua" pitchFamily="18" charset="0"/>
              <a:cs typeface="AF_Unizah " pitchFamily="2" charset="-78"/>
            </a:endParaRPr>
          </a:p>
        </p:txBody>
      </p:sp>
    </p:spTree>
    <p:extLst>
      <p:ext uri="{BB962C8B-B14F-4D97-AF65-F5344CB8AC3E}">
        <p14:creationId xmlns:p14="http://schemas.microsoft.com/office/powerpoint/2010/main" val="185524633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2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" dur="1000"/>
                                        <p:tgtEl>
                                          <p:spTgt spid="2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" fill="hold">
                            <p:stCondLst>
                              <p:cond delay="1500"/>
                            </p:stCondLst>
                            <p:childTnLst>
                              <p:par>
                                <p:cTn id="13" presetID="35" presetClass="path" presetSubtype="0" accel="50000" decel="5000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0 L -0.25 0 E" pathEditMode="relative" ptsTypes="">
                                      <p:cBhvr>
                                        <p:cTn id="14" dur="1000" fill="hold"/>
                                        <p:tgtEl>
                                          <p:spTgt spid="2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15" presetID="35" presetClass="path" presetSubtype="0" accel="50000" decel="5000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0 L -0.25 0 E" pathEditMode="relative" ptsTypes="">
                                      <p:cBhvr>
                                        <p:cTn id="16" dur="1000" fill="hold"/>
                                        <p:tgtEl>
                                          <p:spTgt spid="25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7" fill="hold">
                            <p:stCondLst>
                              <p:cond delay="2500"/>
                            </p:stCondLst>
                            <p:childTnLst>
                              <p:par>
                                <p:cTn id="18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0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1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3" dur="5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 animBg="1"/>
      <p:bldP spid="8" grpId="0"/>
      <p:bldP spid="25" grpId="0"/>
      <p:bldP spid="25" grpId="1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ost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>
                  <p14:fade in="700"/>
                </p14:media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72008" y="-39719"/>
            <a:ext cx="12097344" cy="6867769"/>
          </a:xfrm>
          <a:prstGeom prst="rect">
            <a:avLst/>
          </a:prstGeom>
        </p:spPr>
      </p:pic>
      <p:pic>
        <p:nvPicPr>
          <p:cNvPr id="7" name="Follow up.avi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71442" y="51578"/>
            <a:ext cx="12144444" cy="6833968"/>
          </a:xfrm>
          <a:prstGeom prst="rect">
            <a:avLst/>
          </a:prstGeom>
        </p:spPr>
      </p:pic>
      <p:pic>
        <p:nvPicPr>
          <p:cNvPr id="6" name="pre.avi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1"/>
          <a:stretch>
            <a:fillRect/>
          </a:stretch>
        </p:blipFill>
        <p:spPr>
          <a:xfrm>
            <a:off x="72008" y="1045"/>
            <a:ext cx="12072436" cy="6843737"/>
          </a:xfrm>
          <a:prstGeom prst="rect">
            <a:avLst/>
          </a:prstGeom>
        </p:spPr>
      </p:pic>
      <p:sp>
        <p:nvSpPr>
          <p:cNvPr id="23" name="Rectangle 21"/>
          <p:cNvSpPr/>
          <p:nvPr/>
        </p:nvSpPr>
        <p:spPr>
          <a:xfrm flipH="1">
            <a:off x="-1551063" y="1740912"/>
            <a:ext cx="6159175" cy="571150"/>
          </a:xfrm>
          <a:prstGeom prst="round2DiagRect">
            <a:avLst/>
          </a:prstGeom>
          <a:noFill/>
        </p:spPr>
        <p:txBody>
          <a:bodyPr wrap="square" lIns="0" tIns="0" rIns="0" bIns="0">
            <a:spAutoFit/>
          </a:bodyPr>
          <a:lstStyle>
            <a:defPPr>
              <a:defRPr lang="ar-EG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rtl="0" fontAlgn="base">
              <a:lnSpc>
                <a:spcPct val="130000"/>
              </a:lnSpc>
              <a:spcBef>
                <a:spcPct val="0"/>
              </a:spcBef>
              <a:spcAft>
                <a:spcPct val="0"/>
              </a:spcAft>
              <a:defRPr/>
            </a:pPr>
            <a:r>
              <a:rPr lang="en-GB" sz="2800" b="1" kern="0" spc="300" dirty="0" smtClean="0">
                <a:solidFill>
                  <a:prstClr val="white"/>
                </a:solidFill>
                <a:latin typeface="Book Antiqua" panose="02040602050305030304" pitchFamily="18" charset="0"/>
              </a:rPr>
              <a:t>Pre-Pacing </a:t>
            </a:r>
            <a:endParaRPr lang="en-GB" sz="2800" b="1" kern="0" spc="300" dirty="0">
              <a:solidFill>
                <a:prstClr val="white"/>
              </a:solidFill>
              <a:latin typeface="Book Antiqua" panose="02040602050305030304" pitchFamily="18" charset="0"/>
            </a:endParaRPr>
          </a:p>
        </p:txBody>
      </p:sp>
      <p:sp>
        <p:nvSpPr>
          <p:cNvPr id="8" name="Rectangle 21"/>
          <p:cNvSpPr/>
          <p:nvPr/>
        </p:nvSpPr>
        <p:spPr>
          <a:xfrm flipH="1">
            <a:off x="-1584635" y="1431040"/>
            <a:ext cx="6159175" cy="1190894"/>
          </a:xfrm>
          <a:prstGeom prst="round2DiagRect">
            <a:avLst/>
          </a:prstGeom>
          <a:noFill/>
        </p:spPr>
        <p:txBody>
          <a:bodyPr wrap="square" lIns="0" tIns="0" rIns="0" bIns="0">
            <a:spAutoFit/>
          </a:bodyPr>
          <a:lstStyle>
            <a:defPPr>
              <a:defRPr lang="ar-EG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rtl="0" fontAlgn="base">
              <a:lnSpc>
                <a:spcPct val="130000"/>
              </a:lnSpc>
              <a:spcBef>
                <a:spcPct val="0"/>
              </a:spcBef>
              <a:spcAft>
                <a:spcPct val="0"/>
              </a:spcAft>
              <a:defRPr/>
            </a:pPr>
            <a:r>
              <a:rPr lang="en-GB" sz="2800" b="1" kern="0" spc="300" dirty="0" smtClean="0">
                <a:solidFill>
                  <a:prstClr val="white"/>
                </a:solidFill>
                <a:latin typeface="Book Antiqua" panose="02040602050305030304" pitchFamily="18" charset="0"/>
              </a:rPr>
              <a:t>Post-Pacing</a:t>
            </a:r>
          </a:p>
          <a:p>
            <a:pPr algn="ctr" rtl="0" fontAlgn="base">
              <a:lnSpc>
                <a:spcPct val="130000"/>
              </a:lnSpc>
              <a:spcBef>
                <a:spcPct val="0"/>
              </a:spcBef>
              <a:spcAft>
                <a:spcPct val="0"/>
              </a:spcAft>
              <a:defRPr/>
            </a:pPr>
            <a:r>
              <a:rPr lang="en-GB" sz="2800" b="1" kern="0" spc="300" dirty="0" smtClean="0">
                <a:solidFill>
                  <a:prstClr val="white"/>
                </a:solidFill>
                <a:latin typeface="Book Antiqua" panose="02040602050305030304" pitchFamily="18" charset="0"/>
              </a:rPr>
              <a:t>At 7 Days </a:t>
            </a:r>
            <a:endParaRPr lang="en-GB" sz="2800" b="1" kern="0" spc="300" dirty="0">
              <a:solidFill>
                <a:prstClr val="white"/>
              </a:solidFill>
              <a:latin typeface="Book Antiqua" panose="02040602050305030304" pitchFamily="18" charset="0"/>
            </a:endParaRPr>
          </a:p>
        </p:txBody>
      </p:sp>
      <p:sp>
        <p:nvSpPr>
          <p:cNvPr id="10" name="Rectangle 21"/>
          <p:cNvSpPr/>
          <p:nvPr/>
        </p:nvSpPr>
        <p:spPr>
          <a:xfrm flipH="1">
            <a:off x="-1593130" y="1434080"/>
            <a:ext cx="6159175" cy="1190894"/>
          </a:xfrm>
          <a:prstGeom prst="round2DiagRect">
            <a:avLst/>
          </a:prstGeom>
          <a:noFill/>
        </p:spPr>
        <p:txBody>
          <a:bodyPr wrap="square" lIns="0" tIns="0" rIns="0" bIns="0">
            <a:spAutoFit/>
          </a:bodyPr>
          <a:lstStyle>
            <a:defPPr>
              <a:defRPr lang="ar-EG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rtl="0" fontAlgn="base">
              <a:lnSpc>
                <a:spcPct val="130000"/>
              </a:lnSpc>
              <a:spcBef>
                <a:spcPct val="0"/>
              </a:spcBef>
              <a:spcAft>
                <a:spcPct val="0"/>
              </a:spcAft>
              <a:defRPr/>
            </a:pPr>
            <a:r>
              <a:rPr lang="en-GB" sz="2800" b="1" kern="0" spc="300" dirty="0">
                <a:solidFill>
                  <a:prstClr val="white"/>
                </a:solidFill>
                <a:latin typeface="Book Antiqua" panose="02040602050305030304" pitchFamily="18" charset="0"/>
              </a:rPr>
              <a:t>Post-Pacing</a:t>
            </a:r>
          </a:p>
          <a:p>
            <a:pPr algn="ctr" rtl="0" fontAlgn="base">
              <a:lnSpc>
                <a:spcPct val="130000"/>
              </a:lnSpc>
              <a:spcBef>
                <a:spcPct val="0"/>
              </a:spcBef>
              <a:spcAft>
                <a:spcPct val="0"/>
              </a:spcAft>
              <a:defRPr/>
            </a:pPr>
            <a:r>
              <a:rPr lang="en-GB" sz="2800" b="1" kern="0" spc="300" dirty="0" smtClean="0">
                <a:solidFill>
                  <a:prstClr val="white"/>
                </a:solidFill>
                <a:latin typeface="Book Antiqua" panose="02040602050305030304" pitchFamily="18" charset="0"/>
              </a:rPr>
              <a:t>At 6 months</a:t>
            </a:r>
            <a:endParaRPr lang="en-GB" sz="2800" b="1" kern="0" spc="300" dirty="0">
              <a:solidFill>
                <a:prstClr val="white"/>
              </a:solidFill>
              <a:latin typeface="Book Antiqua" panose="020406020503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740525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)">
                                      <p:cBhvr>
                                        <p:cTn id="6" dur="1498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4" presetClass="exit" presetSubtype="1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randombar(horizontal)">
                                      <p:cBhvr>
                                        <p:cTn id="10" dur="750"/>
                                        <p:tgtEl>
                                          <p:spTgt spid="2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749"/>
                                          </p:stCondLst>
                                        </p:cTn>
                                        <p:tgtEl>
                                          <p:spTgt spid="2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2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  <p:cmd type="call" cmd="stop">
                                      <p:cBhvr>
                                        <p:cTn id="14" dur="1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15" presetID="14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randombar(horizontal)">
                                      <p:cBhvr>
                                        <p:cTn id="17" dur="5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8" fill="hold">
                            <p:stCondLst>
                              <p:cond delay="750"/>
                            </p:stCondLst>
                            <p:childTnLst>
                              <p:par>
                                <p:cTn id="19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1" dur="5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2" fill="hold">
                            <p:stCondLst>
                              <p:cond delay="1250"/>
                            </p:stCondLst>
                            <p:childTnLst>
                              <p:par>
                                <p:cTn id="23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24" dur="706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1" presetClass="exit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  <p:cmd type="call" cmd="stop">
                                      <p:cBhvr>
                                        <p:cTn id="29" dur="1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30" presetID="14" presetClass="exit" presetSubtype="1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randombar(horizontal)">
                                      <p:cBhvr>
                                        <p:cTn id="31" dur="5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4" presetClass="entr" presetSubtype="1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randombar(horizontal)">
                                      <p:cBhvr>
                                        <p:cTn id="35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6" fill="hold">
                            <p:stCondLst>
                              <p:cond delay="500"/>
                            </p:stCondLst>
                            <p:childTnLst>
                              <p:par>
                                <p:cTn id="37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9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0" fill="hold">
                            <p:stCondLst>
                              <p:cond delay="1000"/>
                            </p:stCondLst>
                            <p:childTnLst>
                              <p:par>
                                <p:cTn id="41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42" dur="749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 fullScrn="1">
              <p:cMediaNode vol="80000">
                <p:cTn id="43" repeatCount="indefinite" fill="remove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video fullScrn="1">
              <p:cMediaNode vol="80000">
                <p:cTn id="44" repeatCount="indefinite" fill="remove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video fullScrn="1">
              <p:cMediaNode vol="80000">
                <p:cTn id="45" repeatCount="indefinite" fill="remove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</p:childTnLst>
        </p:cTn>
      </p:par>
    </p:tnLst>
    <p:bldLst>
      <p:bldP spid="23" grpId="0" build="allAtOnce"/>
      <p:bldP spid="8" grpId="0"/>
      <p:bldP spid="8" grpId="1"/>
      <p:bldP spid="10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ost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>
                  <p14:fade in="700"/>
                </p14:media>
              </p:ext>
            </p:extLst>
          </p:nvPr>
        </p:nvPicPr>
        <p:blipFill rotWithShape="1">
          <a:blip r:embed="rId8"/>
          <a:srcRect l="21649" t="5900" r="25773" b="27950"/>
          <a:stretch/>
        </p:blipFill>
        <p:spPr>
          <a:xfrm>
            <a:off x="4033782" y="641196"/>
            <a:ext cx="4032448" cy="6316196"/>
          </a:xfrm>
          <a:prstGeom prst="rect">
            <a:avLst/>
          </a:prstGeom>
        </p:spPr>
      </p:pic>
      <p:pic>
        <p:nvPicPr>
          <p:cNvPr id="3" name="Follow up.avi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9"/>
          <a:srcRect l="21388" t="6859" r="25197" b="28903"/>
          <a:stretch/>
        </p:blipFill>
        <p:spPr>
          <a:xfrm>
            <a:off x="8006544" y="624911"/>
            <a:ext cx="4176464" cy="6242752"/>
          </a:xfrm>
          <a:prstGeom prst="rect">
            <a:avLst/>
          </a:prstGeom>
        </p:spPr>
      </p:pic>
      <p:pic>
        <p:nvPicPr>
          <p:cNvPr id="2" name="pre.avi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 rotWithShape="1">
          <a:blip r:embed="rId10"/>
          <a:srcRect l="19178" t="5570" r="26941" b="28048"/>
          <a:stretch/>
        </p:blipFill>
        <p:spPr>
          <a:xfrm>
            <a:off x="-25474" y="642632"/>
            <a:ext cx="4032448" cy="6242752"/>
          </a:xfrm>
          <a:prstGeom prst="rect">
            <a:avLst/>
          </a:prstGeom>
        </p:spPr>
      </p:pic>
      <p:grpSp>
        <p:nvGrpSpPr>
          <p:cNvPr id="5" name="Group 4"/>
          <p:cNvGrpSpPr/>
          <p:nvPr/>
        </p:nvGrpSpPr>
        <p:grpSpPr>
          <a:xfrm>
            <a:off x="-25474" y="-10026"/>
            <a:ext cx="4108398" cy="630714"/>
            <a:chOff x="1028700" y="2231017"/>
            <a:chExt cx="1375064" cy="450637"/>
          </a:xfrm>
        </p:grpSpPr>
        <p:sp>
          <p:nvSpPr>
            <p:cNvPr id="6" name="Snip Same Side Corner Rectangle 5"/>
            <p:cNvSpPr/>
            <p:nvPr/>
          </p:nvSpPr>
          <p:spPr>
            <a:xfrm>
              <a:off x="1028700" y="2231017"/>
              <a:ext cx="1375064" cy="450637"/>
            </a:xfrm>
            <a:prstGeom prst="snip2SameRect">
              <a:avLst>
                <a:gd name="adj1" fmla="val 0"/>
                <a:gd name="adj2" fmla="val 0"/>
              </a:avLst>
            </a:prstGeom>
            <a:gradFill flip="none" rotWithShape="1">
              <a:gsLst>
                <a:gs pos="0">
                  <a:sysClr val="window" lastClr="FFFFFF"/>
                </a:gs>
                <a:gs pos="90000">
                  <a:sysClr val="window" lastClr="FFFFFF">
                    <a:lumMod val="65000"/>
                  </a:sysClr>
                </a:gs>
                <a:gs pos="73000">
                  <a:sysClr val="window" lastClr="FFFFFF"/>
                </a:gs>
                <a:gs pos="50500">
                  <a:sysClr val="window" lastClr="FFFFFF"/>
                </a:gs>
                <a:gs pos="14000">
                  <a:sysClr val="window" lastClr="FFFFFF"/>
                </a:gs>
              </a:gsLst>
              <a:path path="circle">
                <a:fillToRect l="50000" t="50000" r="50000" b="50000"/>
              </a:path>
              <a:tileRect/>
            </a:gradFill>
            <a:ln w="25400" cap="flat" cmpd="sng" algn="ctr">
              <a:noFill/>
              <a:prstDash val="solid"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 rtlCol="1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000" b="0" i="0" u="none" strike="noStrike" kern="0" cap="none" spc="20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learly Gothic" pitchFamily="2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412841" y="2297885"/>
              <a:ext cx="607983" cy="303466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pPr lvl="0" algn="ctr" defTabSz="914363">
                <a:lnSpc>
                  <a:spcPct val="90000"/>
                </a:lnSpc>
                <a:buClr>
                  <a:sysClr val="windowText" lastClr="000000"/>
                </a:buClr>
                <a:defRPr/>
              </a:pPr>
              <a:r>
                <a:rPr lang="en-US" sz="2400" b="1" kern="0" spc="100" dirty="0" smtClean="0">
                  <a:solidFill>
                    <a:sysClr val="windowText" lastClr="000000"/>
                  </a:solidFill>
                  <a:latin typeface="Book Antiqua" panose="02040602050305030304" pitchFamily="18" charset="0"/>
                </a:rPr>
                <a:t>Pre-Pacing</a:t>
              </a:r>
              <a:endParaRPr lang="en-US" sz="2400" b="1" kern="0" spc="100" dirty="0">
                <a:solidFill>
                  <a:sysClr val="windowText" lastClr="000000"/>
                </a:solidFill>
                <a:latin typeface="Book Antiqua" panose="02040602050305030304" pitchFamily="18" charset="0"/>
              </a:endParaRPr>
            </a:p>
          </p:txBody>
        </p:sp>
      </p:grpSp>
      <p:grpSp>
        <p:nvGrpSpPr>
          <p:cNvPr id="14" name="Group 13"/>
          <p:cNvGrpSpPr/>
          <p:nvPr/>
        </p:nvGrpSpPr>
        <p:grpSpPr>
          <a:xfrm>
            <a:off x="4147048" y="-5803"/>
            <a:ext cx="3945990" cy="630714"/>
            <a:chOff x="1028700" y="2231017"/>
            <a:chExt cx="1375064" cy="450637"/>
          </a:xfrm>
        </p:grpSpPr>
        <p:sp>
          <p:nvSpPr>
            <p:cNvPr id="15" name="Snip Same Side Corner Rectangle 14"/>
            <p:cNvSpPr/>
            <p:nvPr/>
          </p:nvSpPr>
          <p:spPr>
            <a:xfrm>
              <a:off x="1028700" y="2231017"/>
              <a:ext cx="1375064" cy="450637"/>
            </a:xfrm>
            <a:prstGeom prst="snip2SameRect">
              <a:avLst>
                <a:gd name="adj1" fmla="val 0"/>
                <a:gd name="adj2" fmla="val 0"/>
              </a:avLst>
            </a:prstGeom>
            <a:gradFill flip="none" rotWithShape="1">
              <a:gsLst>
                <a:gs pos="0">
                  <a:sysClr val="window" lastClr="FFFFFF"/>
                </a:gs>
                <a:gs pos="90000">
                  <a:sysClr val="window" lastClr="FFFFFF">
                    <a:lumMod val="65000"/>
                  </a:sysClr>
                </a:gs>
                <a:gs pos="73000">
                  <a:sysClr val="window" lastClr="FFFFFF"/>
                </a:gs>
                <a:gs pos="50500">
                  <a:sysClr val="window" lastClr="FFFFFF"/>
                </a:gs>
                <a:gs pos="14000">
                  <a:sysClr val="window" lastClr="FFFFFF"/>
                </a:gs>
              </a:gsLst>
              <a:path path="circle">
                <a:fillToRect l="50000" t="50000" r="50000" b="50000"/>
              </a:path>
              <a:tileRect/>
            </a:gradFill>
            <a:ln w="25400" cap="flat" cmpd="sng" algn="ctr">
              <a:noFill/>
              <a:prstDash val="solid"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 rtlCol="1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000" b="0" i="0" u="none" strike="noStrike" kern="0" cap="none" spc="20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learly Gothic" pitchFamily="2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426307" y="2297885"/>
              <a:ext cx="581056" cy="303466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pPr lvl="0" algn="ctr" defTabSz="914363">
                <a:lnSpc>
                  <a:spcPct val="90000"/>
                </a:lnSpc>
                <a:buClr>
                  <a:sysClr val="windowText" lastClr="000000"/>
                </a:buClr>
                <a:defRPr/>
              </a:pPr>
              <a:r>
                <a:rPr lang="en-US" sz="2400" b="1" kern="0" spc="100" dirty="0" smtClean="0">
                  <a:solidFill>
                    <a:sysClr val="windowText" lastClr="000000"/>
                  </a:solidFill>
                  <a:latin typeface="Book Antiqua" panose="02040602050305030304" pitchFamily="18" charset="0"/>
                </a:rPr>
                <a:t>At 7 Days</a:t>
              </a:r>
              <a:endParaRPr lang="en-US" sz="2400" b="1" kern="0" spc="100" dirty="0">
                <a:solidFill>
                  <a:sysClr val="windowText" lastClr="000000"/>
                </a:solidFill>
                <a:latin typeface="Book Antiqua" panose="02040602050305030304" pitchFamily="18" charset="0"/>
              </a:endParaRPr>
            </a:p>
          </p:txBody>
        </p:sp>
      </p:grpSp>
      <p:sp>
        <p:nvSpPr>
          <p:cNvPr id="17" name="Snip Same Side Corner Rectangle 16"/>
          <p:cNvSpPr/>
          <p:nvPr/>
        </p:nvSpPr>
        <p:spPr>
          <a:xfrm>
            <a:off x="8157161" y="-5803"/>
            <a:ext cx="4033251" cy="630714"/>
          </a:xfrm>
          <a:prstGeom prst="snip2SameRect">
            <a:avLst>
              <a:gd name="adj1" fmla="val 0"/>
              <a:gd name="adj2" fmla="val 0"/>
            </a:avLst>
          </a:prstGeom>
          <a:gradFill flip="none" rotWithShape="1">
            <a:gsLst>
              <a:gs pos="0">
                <a:sysClr val="window" lastClr="FFFFFF"/>
              </a:gs>
              <a:gs pos="90000">
                <a:sysClr val="window" lastClr="FFFFFF">
                  <a:lumMod val="65000"/>
                </a:sysClr>
              </a:gs>
              <a:gs pos="73000">
                <a:sysClr val="window" lastClr="FFFFFF"/>
              </a:gs>
              <a:gs pos="50500">
                <a:sysClr val="window" lastClr="FFFFFF"/>
              </a:gs>
              <a:gs pos="14000">
                <a:sysClr val="window" lastClr="FFFFFF"/>
              </a:gs>
            </a:gsLst>
            <a:path path="circle">
              <a:fillToRect l="50000" t="50000" r="50000" b="50000"/>
            </a:path>
            <a:tileRect/>
          </a:gradFill>
          <a:ln w="25400" cap="flat" cmpd="sng" algn="ctr">
            <a:noFill/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rtlCol="1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2000" b="0" i="0" u="none" strike="noStrike" kern="0" cap="none" spc="20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learly Gothic" pitchFamily="2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9207200" y="116632"/>
            <a:ext cx="2068195" cy="4247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lvl="0" algn="ctr" defTabSz="914363">
              <a:lnSpc>
                <a:spcPct val="90000"/>
              </a:lnSpc>
              <a:buClr>
                <a:sysClr val="windowText" lastClr="000000"/>
              </a:buClr>
              <a:defRPr/>
            </a:pPr>
            <a:r>
              <a:rPr lang="en-US" sz="2400" b="1" kern="0" spc="100" dirty="0" smtClean="0">
                <a:solidFill>
                  <a:sysClr val="windowText" lastClr="000000"/>
                </a:solidFill>
                <a:latin typeface="Book Antiqua" panose="02040602050305030304" pitchFamily="18" charset="0"/>
              </a:rPr>
              <a:t>At 6 Months</a:t>
            </a:r>
            <a:endParaRPr lang="en-US" sz="2400" b="1" kern="0" spc="100" dirty="0">
              <a:solidFill>
                <a:sysClr val="windowText" lastClr="000000"/>
              </a:solidFill>
              <a:latin typeface="Book Antiqua" panose="020406020503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00450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498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8" dur="749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9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706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repeatCount="indefinite" fill="remove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video>
              <p:cMediaNode vol="80000">
                <p:cTn id="12" repeatCount="indefinite" fill="remove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video>
              <p:cMediaNode vol="80000">
                <p:cTn id="13" repeatCount="indefinite" fill="remove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0055646" y="-69119"/>
            <a:ext cx="1998936" cy="814773"/>
            <a:chOff x="9479582" y="-116888"/>
            <a:chExt cx="2729881" cy="1048170"/>
          </a:xfrm>
        </p:grpSpPr>
        <p:sp>
          <p:nvSpPr>
            <p:cNvPr id="4" name="Rectangle 8"/>
            <p:cNvSpPr/>
            <p:nvPr/>
          </p:nvSpPr>
          <p:spPr>
            <a:xfrm rot="5400000" flipH="1">
              <a:off x="10370523" y="-950762"/>
              <a:ext cx="825382" cy="2607264"/>
            </a:xfrm>
            <a:custGeom>
              <a:avLst/>
              <a:gdLst>
                <a:gd name="connsiteX0" fmla="*/ 0 w 381000"/>
                <a:gd name="connsiteY0" fmla="*/ 0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4" fmla="*/ 0 w 381000"/>
                <a:gd name="connsiteY4" fmla="*/ 0 h 1066800"/>
                <a:gd name="connsiteX0" fmla="*/ 155804 w 381000"/>
                <a:gd name="connsiteY0" fmla="*/ 77413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4" fmla="*/ 155804 w 381000"/>
                <a:gd name="connsiteY4" fmla="*/ 77413 h 1066800"/>
                <a:gd name="connsiteX0" fmla="*/ 0 w 381000"/>
                <a:gd name="connsiteY0" fmla="*/ 1066800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0" fmla="*/ 0 w 381000"/>
                <a:gd name="connsiteY0" fmla="*/ 1066800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0" fmla="*/ 0 w 382100"/>
                <a:gd name="connsiteY0" fmla="*/ 1066800 h 1266097"/>
                <a:gd name="connsiteX1" fmla="*/ 381000 w 382100"/>
                <a:gd name="connsiteY1" fmla="*/ 0 h 1266097"/>
                <a:gd name="connsiteX2" fmla="*/ 382100 w 382100"/>
                <a:gd name="connsiteY2" fmla="*/ 1266097 h 1266097"/>
                <a:gd name="connsiteX3" fmla="*/ 0 w 382100"/>
                <a:gd name="connsiteY3" fmla="*/ 1066800 h 1266097"/>
                <a:gd name="connsiteX0" fmla="*/ 81205 w 463305"/>
                <a:gd name="connsiteY0" fmla="*/ 1066800 h 1278547"/>
                <a:gd name="connsiteX1" fmla="*/ 462205 w 463305"/>
                <a:gd name="connsiteY1" fmla="*/ 0 h 1278547"/>
                <a:gd name="connsiteX2" fmla="*/ 463305 w 463305"/>
                <a:gd name="connsiteY2" fmla="*/ 1266097 h 1278547"/>
                <a:gd name="connsiteX3" fmla="*/ 81205 w 463305"/>
                <a:gd name="connsiteY3" fmla="*/ 1066800 h 1278547"/>
                <a:gd name="connsiteX0" fmla="*/ 1100 w 1100"/>
                <a:gd name="connsiteY0" fmla="*/ 1266097 h 1266097"/>
                <a:gd name="connsiteX1" fmla="*/ 0 w 1100"/>
                <a:gd name="connsiteY1" fmla="*/ 0 h 1266097"/>
                <a:gd name="connsiteX2" fmla="*/ 1100 w 1100"/>
                <a:gd name="connsiteY2" fmla="*/ 1266097 h 1266097"/>
                <a:gd name="connsiteX0" fmla="*/ 4504727 w 4504727"/>
                <a:gd name="connsiteY0" fmla="*/ 10000 h 10000"/>
                <a:gd name="connsiteX1" fmla="*/ 4494727 w 4504727"/>
                <a:gd name="connsiteY1" fmla="*/ 0 h 10000"/>
                <a:gd name="connsiteX2" fmla="*/ 4504727 w 4504727"/>
                <a:gd name="connsiteY2" fmla="*/ 10000 h 10000"/>
                <a:gd name="connsiteX0" fmla="*/ 4711554 w 4711554"/>
                <a:gd name="connsiteY0" fmla="*/ 10376 h 10376"/>
                <a:gd name="connsiteX1" fmla="*/ 3938749 w 4711554"/>
                <a:gd name="connsiteY1" fmla="*/ 0 h 10376"/>
                <a:gd name="connsiteX2" fmla="*/ 4711554 w 4711554"/>
                <a:gd name="connsiteY2" fmla="*/ 10376 h 10376"/>
                <a:gd name="connsiteX0" fmla="*/ 5453499 w 5453499"/>
                <a:gd name="connsiteY0" fmla="*/ 10376 h 10376"/>
                <a:gd name="connsiteX1" fmla="*/ 4680694 w 5453499"/>
                <a:gd name="connsiteY1" fmla="*/ 0 h 10376"/>
                <a:gd name="connsiteX2" fmla="*/ 5453499 w 5453499"/>
                <a:gd name="connsiteY2" fmla="*/ 10376 h 10376"/>
                <a:gd name="connsiteX0" fmla="*/ 5188217 w 5193990"/>
                <a:gd name="connsiteY0" fmla="*/ 10193 h 10193"/>
                <a:gd name="connsiteX1" fmla="*/ 5193988 w 5193990"/>
                <a:gd name="connsiteY1" fmla="*/ 0 h 10193"/>
                <a:gd name="connsiteX2" fmla="*/ 5188217 w 5193990"/>
                <a:gd name="connsiteY2" fmla="*/ 10193 h 10193"/>
                <a:gd name="connsiteX0" fmla="*/ 5198190 w 5203963"/>
                <a:gd name="connsiteY0" fmla="*/ 10265 h 10265"/>
                <a:gd name="connsiteX1" fmla="*/ 5203961 w 5203963"/>
                <a:gd name="connsiteY1" fmla="*/ 72 h 10265"/>
                <a:gd name="connsiteX2" fmla="*/ 5198190 w 5203963"/>
                <a:gd name="connsiteY2" fmla="*/ 10265 h 10265"/>
                <a:gd name="connsiteX0" fmla="*/ 3303499 w 3309272"/>
                <a:gd name="connsiteY0" fmla="*/ 10194 h 10194"/>
                <a:gd name="connsiteX1" fmla="*/ 3309270 w 3309272"/>
                <a:gd name="connsiteY1" fmla="*/ 1 h 10194"/>
                <a:gd name="connsiteX2" fmla="*/ 3303499 w 3309272"/>
                <a:gd name="connsiteY2" fmla="*/ 10194 h 10194"/>
                <a:gd name="connsiteX0" fmla="*/ 3375826 w 3381599"/>
                <a:gd name="connsiteY0" fmla="*/ 10193 h 10193"/>
                <a:gd name="connsiteX1" fmla="*/ 3381597 w 3381599"/>
                <a:gd name="connsiteY1" fmla="*/ 0 h 10193"/>
                <a:gd name="connsiteX2" fmla="*/ 3375826 w 3381599"/>
                <a:gd name="connsiteY2" fmla="*/ 10193 h 10193"/>
                <a:gd name="connsiteX0" fmla="*/ 3305544 w 3311317"/>
                <a:gd name="connsiteY0" fmla="*/ 10193 h 10193"/>
                <a:gd name="connsiteX1" fmla="*/ 3311315 w 3311317"/>
                <a:gd name="connsiteY1" fmla="*/ 0 h 10193"/>
                <a:gd name="connsiteX2" fmla="*/ 3305544 w 3311317"/>
                <a:gd name="connsiteY2" fmla="*/ 10193 h 10193"/>
                <a:gd name="connsiteX0" fmla="*/ 3358833 w 3358835"/>
                <a:gd name="connsiteY0" fmla="*/ 8987 h 8987"/>
                <a:gd name="connsiteX1" fmla="*/ 3232079 w 3358835"/>
                <a:gd name="connsiteY1" fmla="*/ 0 h 8987"/>
                <a:gd name="connsiteX2" fmla="*/ 3358833 w 3358835"/>
                <a:gd name="connsiteY2" fmla="*/ 8987 h 8987"/>
                <a:gd name="connsiteX0" fmla="*/ 6470 w 6470"/>
                <a:gd name="connsiteY0" fmla="*/ 10000 h 10000"/>
                <a:gd name="connsiteX1" fmla="*/ 6093 w 6470"/>
                <a:gd name="connsiteY1" fmla="*/ 0 h 10000"/>
                <a:gd name="connsiteX2" fmla="*/ 6470 w 6470"/>
                <a:gd name="connsiteY2" fmla="*/ 10000 h 10000"/>
                <a:gd name="connsiteX0" fmla="*/ 9802 w 9802"/>
                <a:gd name="connsiteY0" fmla="*/ 10000 h 10000"/>
                <a:gd name="connsiteX1" fmla="*/ 9219 w 9802"/>
                <a:gd name="connsiteY1" fmla="*/ 0 h 10000"/>
                <a:gd name="connsiteX2" fmla="*/ 9802 w 9802"/>
                <a:gd name="connsiteY2" fmla="*/ 10000 h 10000"/>
                <a:gd name="connsiteX0" fmla="*/ 9298 w 10018"/>
                <a:gd name="connsiteY0" fmla="*/ 10932 h 10932"/>
                <a:gd name="connsiteX1" fmla="*/ 9994 w 10018"/>
                <a:gd name="connsiteY1" fmla="*/ 0 h 10932"/>
                <a:gd name="connsiteX2" fmla="*/ 9298 w 10018"/>
                <a:gd name="connsiteY2" fmla="*/ 10932 h 10932"/>
                <a:gd name="connsiteX0" fmla="*/ 10017 w 10017"/>
                <a:gd name="connsiteY0" fmla="*/ 10384 h 10384"/>
                <a:gd name="connsiteX1" fmla="*/ 9391 w 10017"/>
                <a:gd name="connsiteY1" fmla="*/ 0 h 10384"/>
                <a:gd name="connsiteX2" fmla="*/ 10017 w 10017"/>
                <a:gd name="connsiteY2" fmla="*/ 10384 h 10384"/>
                <a:gd name="connsiteX0" fmla="*/ 4732 w 4732"/>
                <a:gd name="connsiteY0" fmla="*/ 10390 h 11041"/>
                <a:gd name="connsiteX1" fmla="*/ 4106 w 4732"/>
                <a:gd name="connsiteY1" fmla="*/ 6 h 11041"/>
                <a:gd name="connsiteX2" fmla="*/ 3 w 4732"/>
                <a:gd name="connsiteY2" fmla="*/ 8873 h 11041"/>
                <a:gd name="connsiteX3" fmla="*/ 4732 w 4732"/>
                <a:gd name="connsiteY3" fmla="*/ 10390 h 11041"/>
                <a:gd name="connsiteX0" fmla="*/ 5470 w 5470"/>
                <a:gd name="connsiteY0" fmla="*/ 9410 h 10025"/>
                <a:gd name="connsiteX1" fmla="*/ 4147 w 5470"/>
                <a:gd name="connsiteY1" fmla="*/ 5 h 10025"/>
                <a:gd name="connsiteX2" fmla="*/ 13 w 5470"/>
                <a:gd name="connsiteY2" fmla="*/ 8140 h 10025"/>
                <a:gd name="connsiteX3" fmla="*/ 5470 w 5470"/>
                <a:gd name="connsiteY3" fmla="*/ 9410 h 10025"/>
                <a:gd name="connsiteX0" fmla="*/ 10000 w 10000"/>
                <a:gd name="connsiteY0" fmla="*/ 9387 h 9696"/>
                <a:gd name="connsiteX1" fmla="*/ 7581 w 10000"/>
                <a:gd name="connsiteY1" fmla="*/ 5 h 9696"/>
                <a:gd name="connsiteX2" fmla="*/ 24 w 10000"/>
                <a:gd name="connsiteY2" fmla="*/ 8120 h 9696"/>
                <a:gd name="connsiteX3" fmla="*/ 10000 w 10000"/>
                <a:gd name="connsiteY3" fmla="*/ 9387 h 9696"/>
                <a:gd name="connsiteX0" fmla="*/ 65556 w 65556"/>
                <a:gd name="connsiteY0" fmla="*/ 9686 h 10004"/>
                <a:gd name="connsiteX1" fmla="*/ 63137 w 65556"/>
                <a:gd name="connsiteY1" fmla="*/ 10 h 10004"/>
                <a:gd name="connsiteX2" fmla="*/ 55580 w 65556"/>
                <a:gd name="connsiteY2" fmla="*/ 8380 h 10004"/>
                <a:gd name="connsiteX3" fmla="*/ 65556 w 65556"/>
                <a:gd name="connsiteY3" fmla="*/ 9686 h 10004"/>
                <a:gd name="connsiteX0" fmla="*/ 65556 w 65556"/>
                <a:gd name="connsiteY0" fmla="*/ 9686 h 10140"/>
                <a:gd name="connsiteX1" fmla="*/ 63137 w 65556"/>
                <a:gd name="connsiteY1" fmla="*/ 10 h 10140"/>
                <a:gd name="connsiteX2" fmla="*/ 55580 w 65556"/>
                <a:gd name="connsiteY2" fmla="*/ 8380 h 10140"/>
                <a:gd name="connsiteX3" fmla="*/ 65556 w 65556"/>
                <a:gd name="connsiteY3" fmla="*/ 9686 h 10140"/>
                <a:gd name="connsiteX0" fmla="*/ 64984 w 64984"/>
                <a:gd name="connsiteY0" fmla="*/ 10088 h 10491"/>
                <a:gd name="connsiteX1" fmla="*/ 63137 w 64984"/>
                <a:gd name="connsiteY1" fmla="*/ 10 h 10491"/>
                <a:gd name="connsiteX2" fmla="*/ 55580 w 64984"/>
                <a:gd name="connsiteY2" fmla="*/ 8380 h 10491"/>
                <a:gd name="connsiteX3" fmla="*/ 64984 w 64984"/>
                <a:gd name="connsiteY3" fmla="*/ 10088 h 10491"/>
                <a:gd name="connsiteX0" fmla="*/ 64984 w 64984"/>
                <a:gd name="connsiteY0" fmla="*/ 10088 h 10411"/>
                <a:gd name="connsiteX1" fmla="*/ 63137 w 64984"/>
                <a:gd name="connsiteY1" fmla="*/ 10 h 10411"/>
                <a:gd name="connsiteX2" fmla="*/ 55580 w 64984"/>
                <a:gd name="connsiteY2" fmla="*/ 8380 h 10411"/>
                <a:gd name="connsiteX3" fmla="*/ 64984 w 64984"/>
                <a:gd name="connsiteY3" fmla="*/ 10088 h 10411"/>
                <a:gd name="connsiteX0" fmla="*/ 64984 w 64984"/>
                <a:gd name="connsiteY0" fmla="*/ 10088 h 10088"/>
                <a:gd name="connsiteX1" fmla="*/ 63137 w 64984"/>
                <a:gd name="connsiteY1" fmla="*/ 10 h 10088"/>
                <a:gd name="connsiteX2" fmla="*/ 55580 w 64984"/>
                <a:gd name="connsiteY2" fmla="*/ 8380 h 10088"/>
                <a:gd name="connsiteX3" fmla="*/ 64984 w 64984"/>
                <a:gd name="connsiteY3" fmla="*/ 10088 h 10088"/>
                <a:gd name="connsiteX0" fmla="*/ 64984 w 64984"/>
                <a:gd name="connsiteY0" fmla="*/ 10088 h 10088"/>
                <a:gd name="connsiteX1" fmla="*/ 63137 w 64984"/>
                <a:gd name="connsiteY1" fmla="*/ 10 h 10088"/>
                <a:gd name="connsiteX2" fmla="*/ 55580 w 64984"/>
                <a:gd name="connsiteY2" fmla="*/ 8380 h 10088"/>
                <a:gd name="connsiteX3" fmla="*/ 64984 w 64984"/>
                <a:gd name="connsiteY3" fmla="*/ 10088 h 10088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373 w 80373"/>
                <a:gd name="connsiteY0" fmla="*/ 10131 h 10131"/>
                <a:gd name="connsiteX1" fmla="*/ 78526 w 80373"/>
                <a:gd name="connsiteY1" fmla="*/ 53 h 10131"/>
                <a:gd name="connsiteX2" fmla="*/ 51392 w 80373"/>
                <a:gd name="connsiteY2" fmla="*/ 7671 h 10131"/>
                <a:gd name="connsiteX3" fmla="*/ 80373 w 80373"/>
                <a:gd name="connsiteY3" fmla="*/ 10131 h 10131"/>
                <a:gd name="connsiteX0" fmla="*/ 62961 w 62961"/>
                <a:gd name="connsiteY0" fmla="*/ 10126 h 10126"/>
                <a:gd name="connsiteX1" fmla="*/ 61114 w 62961"/>
                <a:gd name="connsiteY1" fmla="*/ 48 h 10126"/>
                <a:gd name="connsiteX2" fmla="*/ 33980 w 62961"/>
                <a:gd name="connsiteY2" fmla="*/ 7666 h 10126"/>
                <a:gd name="connsiteX3" fmla="*/ 62961 w 62961"/>
                <a:gd name="connsiteY3" fmla="*/ 10126 h 10126"/>
                <a:gd name="connsiteX0" fmla="*/ 62961 w 62961"/>
                <a:gd name="connsiteY0" fmla="*/ 10126 h 10126"/>
                <a:gd name="connsiteX1" fmla="*/ 61114 w 62961"/>
                <a:gd name="connsiteY1" fmla="*/ 48 h 10126"/>
                <a:gd name="connsiteX2" fmla="*/ 33980 w 62961"/>
                <a:gd name="connsiteY2" fmla="*/ 7666 h 10126"/>
                <a:gd name="connsiteX3" fmla="*/ 62961 w 62961"/>
                <a:gd name="connsiteY3" fmla="*/ 10126 h 10126"/>
                <a:gd name="connsiteX0" fmla="*/ 62357 w 62357"/>
                <a:gd name="connsiteY0" fmla="*/ 9891 h 9891"/>
                <a:gd name="connsiteX1" fmla="*/ 61114 w 62357"/>
                <a:gd name="connsiteY1" fmla="*/ 48 h 9891"/>
                <a:gd name="connsiteX2" fmla="*/ 33980 w 62357"/>
                <a:gd name="connsiteY2" fmla="*/ 7666 h 9891"/>
                <a:gd name="connsiteX3" fmla="*/ 62357 w 62357"/>
                <a:gd name="connsiteY3" fmla="*/ 9891 h 9891"/>
                <a:gd name="connsiteX0" fmla="*/ 10000 w 10178"/>
                <a:gd name="connsiteY0" fmla="*/ 10000 h 10000"/>
                <a:gd name="connsiteX1" fmla="*/ 9801 w 10178"/>
                <a:gd name="connsiteY1" fmla="*/ 49 h 10000"/>
                <a:gd name="connsiteX2" fmla="*/ 5449 w 10178"/>
                <a:gd name="connsiteY2" fmla="*/ 7750 h 10000"/>
                <a:gd name="connsiteX3" fmla="*/ 10000 w 10178"/>
                <a:gd name="connsiteY3" fmla="*/ 10000 h 10000"/>
                <a:gd name="connsiteX0" fmla="*/ 10000 w 10178"/>
                <a:gd name="connsiteY0" fmla="*/ 10000 h 10000"/>
                <a:gd name="connsiteX1" fmla="*/ 9801 w 10178"/>
                <a:gd name="connsiteY1" fmla="*/ 49 h 10000"/>
                <a:gd name="connsiteX2" fmla="*/ 5449 w 10178"/>
                <a:gd name="connsiteY2" fmla="*/ 7750 h 10000"/>
                <a:gd name="connsiteX3" fmla="*/ 10000 w 10178"/>
                <a:gd name="connsiteY3" fmla="*/ 10000 h 10000"/>
                <a:gd name="connsiteX0" fmla="*/ 10000 w 10178"/>
                <a:gd name="connsiteY0" fmla="*/ 10000 h 10000"/>
                <a:gd name="connsiteX1" fmla="*/ 9801 w 10178"/>
                <a:gd name="connsiteY1" fmla="*/ 49 h 10000"/>
                <a:gd name="connsiteX2" fmla="*/ 5449 w 10178"/>
                <a:gd name="connsiteY2" fmla="*/ 7750 h 10000"/>
                <a:gd name="connsiteX3" fmla="*/ 10000 w 10178"/>
                <a:gd name="connsiteY3" fmla="*/ 10000 h 10000"/>
                <a:gd name="connsiteX0" fmla="*/ 10267 w 10403"/>
                <a:gd name="connsiteY0" fmla="*/ 9740 h 9740"/>
                <a:gd name="connsiteX1" fmla="*/ 9801 w 10403"/>
                <a:gd name="connsiteY1" fmla="*/ 49 h 9740"/>
                <a:gd name="connsiteX2" fmla="*/ 5449 w 10403"/>
                <a:gd name="connsiteY2" fmla="*/ 7750 h 9740"/>
                <a:gd name="connsiteX3" fmla="*/ 10267 w 10403"/>
                <a:gd name="connsiteY3" fmla="*/ 9740 h 9740"/>
                <a:gd name="connsiteX0" fmla="*/ 9564 w 9745"/>
                <a:gd name="connsiteY0" fmla="*/ 9865 h 9865"/>
                <a:gd name="connsiteX1" fmla="*/ 9421 w 9745"/>
                <a:gd name="connsiteY1" fmla="*/ 50 h 9865"/>
                <a:gd name="connsiteX2" fmla="*/ 5238 w 9745"/>
                <a:gd name="connsiteY2" fmla="*/ 7957 h 9865"/>
                <a:gd name="connsiteX3" fmla="*/ 9564 w 9745"/>
                <a:gd name="connsiteY3" fmla="*/ 9865 h 9865"/>
                <a:gd name="connsiteX0" fmla="*/ 10130 w 10317"/>
                <a:gd name="connsiteY0" fmla="*/ 10000 h 10000"/>
                <a:gd name="connsiteX1" fmla="*/ 9984 w 10317"/>
                <a:gd name="connsiteY1" fmla="*/ 51 h 10000"/>
                <a:gd name="connsiteX2" fmla="*/ 5691 w 10317"/>
                <a:gd name="connsiteY2" fmla="*/ 8066 h 10000"/>
                <a:gd name="connsiteX3" fmla="*/ 10130 w 10317"/>
                <a:gd name="connsiteY3" fmla="*/ 10000 h 10000"/>
                <a:gd name="connsiteX0" fmla="*/ 10130 w 10317"/>
                <a:gd name="connsiteY0" fmla="*/ 10000 h 10000"/>
                <a:gd name="connsiteX1" fmla="*/ 9984 w 10317"/>
                <a:gd name="connsiteY1" fmla="*/ 51 h 10000"/>
                <a:gd name="connsiteX2" fmla="*/ 5691 w 10317"/>
                <a:gd name="connsiteY2" fmla="*/ 8066 h 10000"/>
                <a:gd name="connsiteX3" fmla="*/ 10130 w 10317"/>
                <a:gd name="connsiteY3" fmla="*/ 10000 h 10000"/>
                <a:gd name="connsiteX0" fmla="*/ 10130 w 10317"/>
                <a:gd name="connsiteY0" fmla="*/ 10000 h 10000"/>
                <a:gd name="connsiteX1" fmla="*/ 9984 w 10317"/>
                <a:gd name="connsiteY1" fmla="*/ 51 h 10000"/>
                <a:gd name="connsiteX2" fmla="*/ 5691 w 10317"/>
                <a:gd name="connsiteY2" fmla="*/ 8066 h 10000"/>
                <a:gd name="connsiteX3" fmla="*/ 10130 w 10317"/>
                <a:gd name="connsiteY3" fmla="*/ 10000 h 10000"/>
                <a:gd name="connsiteX0" fmla="*/ 9833 w 10120"/>
                <a:gd name="connsiteY0" fmla="*/ 10175 h 10175"/>
                <a:gd name="connsiteX1" fmla="*/ 9984 w 10120"/>
                <a:gd name="connsiteY1" fmla="*/ 51 h 10175"/>
                <a:gd name="connsiteX2" fmla="*/ 5691 w 10120"/>
                <a:gd name="connsiteY2" fmla="*/ 8066 h 10175"/>
                <a:gd name="connsiteX3" fmla="*/ 9833 w 10120"/>
                <a:gd name="connsiteY3" fmla="*/ 10175 h 10175"/>
                <a:gd name="connsiteX0" fmla="*/ 9960 w 10194"/>
                <a:gd name="connsiteY0" fmla="*/ 10252 h 10252"/>
                <a:gd name="connsiteX1" fmla="*/ 9984 w 10194"/>
                <a:gd name="connsiteY1" fmla="*/ 51 h 10252"/>
                <a:gd name="connsiteX2" fmla="*/ 5691 w 10194"/>
                <a:gd name="connsiteY2" fmla="*/ 8066 h 10252"/>
                <a:gd name="connsiteX3" fmla="*/ 9960 w 10194"/>
                <a:gd name="connsiteY3" fmla="*/ 10252 h 10252"/>
                <a:gd name="connsiteX0" fmla="*/ 9960 w 10194"/>
                <a:gd name="connsiteY0" fmla="*/ 10252 h 10252"/>
                <a:gd name="connsiteX1" fmla="*/ 9984 w 10194"/>
                <a:gd name="connsiteY1" fmla="*/ 51 h 10252"/>
                <a:gd name="connsiteX2" fmla="*/ 5691 w 10194"/>
                <a:gd name="connsiteY2" fmla="*/ 8066 h 10252"/>
                <a:gd name="connsiteX3" fmla="*/ 9960 w 10194"/>
                <a:gd name="connsiteY3" fmla="*/ 10252 h 10252"/>
                <a:gd name="connsiteX0" fmla="*/ 10201 w 10373"/>
                <a:gd name="connsiteY0" fmla="*/ 10161 h 10161"/>
                <a:gd name="connsiteX1" fmla="*/ 9984 w 10373"/>
                <a:gd name="connsiteY1" fmla="*/ 51 h 10161"/>
                <a:gd name="connsiteX2" fmla="*/ 5691 w 10373"/>
                <a:gd name="connsiteY2" fmla="*/ 8066 h 10161"/>
                <a:gd name="connsiteX3" fmla="*/ 10201 w 10373"/>
                <a:gd name="connsiteY3" fmla="*/ 10161 h 10161"/>
                <a:gd name="connsiteX0" fmla="*/ 10201 w 10373"/>
                <a:gd name="connsiteY0" fmla="*/ 10161 h 10161"/>
                <a:gd name="connsiteX1" fmla="*/ 9984 w 10373"/>
                <a:gd name="connsiteY1" fmla="*/ 51 h 10161"/>
                <a:gd name="connsiteX2" fmla="*/ 5691 w 10373"/>
                <a:gd name="connsiteY2" fmla="*/ 8066 h 10161"/>
                <a:gd name="connsiteX3" fmla="*/ 10201 w 10373"/>
                <a:gd name="connsiteY3" fmla="*/ 10161 h 10161"/>
                <a:gd name="connsiteX0" fmla="*/ 10592 w 10710"/>
                <a:gd name="connsiteY0" fmla="*/ 10201 h 10201"/>
                <a:gd name="connsiteX1" fmla="*/ 9984 w 10710"/>
                <a:gd name="connsiteY1" fmla="*/ 51 h 10201"/>
                <a:gd name="connsiteX2" fmla="*/ 5691 w 10710"/>
                <a:gd name="connsiteY2" fmla="*/ 8066 h 10201"/>
                <a:gd name="connsiteX3" fmla="*/ 10592 w 10710"/>
                <a:gd name="connsiteY3" fmla="*/ 10201 h 10201"/>
                <a:gd name="connsiteX0" fmla="*/ 10592 w 10710"/>
                <a:gd name="connsiteY0" fmla="*/ 10201 h 10201"/>
                <a:gd name="connsiteX1" fmla="*/ 9984 w 10710"/>
                <a:gd name="connsiteY1" fmla="*/ 51 h 10201"/>
                <a:gd name="connsiteX2" fmla="*/ 5691 w 10710"/>
                <a:gd name="connsiteY2" fmla="*/ 8066 h 10201"/>
                <a:gd name="connsiteX3" fmla="*/ 10592 w 10710"/>
                <a:gd name="connsiteY3" fmla="*/ 10201 h 10201"/>
                <a:gd name="connsiteX0" fmla="*/ 10592 w 10710"/>
                <a:gd name="connsiteY0" fmla="*/ 10201 h 10201"/>
                <a:gd name="connsiteX1" fmla="*/ 9984 w 10710"/>
                <a:gd name="connsiteY1" fmla="*/ 51 h 10201"/>
                <a:gd name="connsiteX2" fmla="*/ 5691 w 10710"/>
                <a:gd name="connsiteY2" fmla="*/ 8066 h 10201"/>
                <a:gd name="connsiteX3" fmla="*/ 10592 w 10710"/>
                <a:gd name="connsiteY3" fmla="*/ 10201 h 10201"/>
                <a:gd name="connsiteX0" fmla="*/ 10934 w 11052"/>
                <a:gd name="connsiteY0" fmla="*/ 10201 h 10201"/>
                <a:gd name="connsiteX1" fmla="*/ 10326 w 11052"/>
                <a:gd name="connsiteY1" fmla="*/ 51 h 10201"/>
                <a:gd name="connsiteX2" fmla="*/ 5609 w 11052"/>
                <a:gd name="connsiteY2" fmla="*/ 8164 h 10201"/>
                <a:gd name="connsiteX3" fmla="*/ 10934 w 11052"/>
                <a:gd name="connsiteY3" fmla="*/ 10201 h 10201"/>
                <a:gd name="connsiteX0" fmla="*/ 10934 w 11052"/>
                <a:gd name="connsiteY0" fmla="*/ 10201 h 10201"/>
                <a:gd name="connsiteX1" fmla="*/ 10326 w 11052"/>
                <a:gd name="connsiteY1" fmla="*/ 51 h 10201"/>
                <a:gd name="connsiteX2" fmla="*/ 5609 w 11052"/>
                <a:gd name="connsiteY2" fmla="*/ 8164 h 10201"/>
                <a:gd name="connsiteX3" fmla="*/ 10934 w 11052"/>
                <a:gd name="connsiteY3" fmla="*/ 10201 h 10201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8463 w 18581"/>
                <a:gd name="connsiteY0" fmla="*/ 10150 h 10150"/>
                <a:gd name="connsiteX1" fmla="*/ 17855 w 18581"/>
                <a:gd name="connsiteY1" fmla="*/ 0 h 10150"/>
                <a:gd name="connsiteX2" fmla="*/ 12596 w 18581"/>
                <a:gd name="connsiteY2" fmla="*/ 7942 h 10150"/>
                <a:gd name="connsiteX3" fmla="*/ 18463 w 18581"/>
                <a:gd name="connsiteY3" fmla="*/ 10150 h 10150"/>
                <a:gd name="connsiteX0" fmla="*/ 608 w 726"/>
                <a:gd name="connsiteY0" fmla="*/ 10150 h 10150"/>
                <a:gd name="connsiteX1" fmla="*/ 0 w 726"/>
                <a:gd name="connsiteY1" fmla="*/ 0 h 10150"/>
                <a:gd name="connsiteX2" fmla="*/ 608 w 726"/>
                <a:gd name="connsiteY2" fmla="*/ 10150 h 10150"/>
                <a:gd name="connsiteX0" fmla="*/ 59658 w 61295"/>
                <a:gd name="connsiteY0" fmla="*/ 10000 h 10000"/>
                <a:gd name="connsiteX1" fmla="*/ 51283 w 61295"/>
                <a:gd name="connsiteY1" fmla="*/ 0 h 10000"/>
                <a:gd name="connsiteX2" fmla="*/ 59658 w 61295"/>
                <a:gd name="connsiteY2" fmla="*/ 10000 h 10000"/>
                <a:gd name="connsiteX0" fmla="*/ 59658 w 84651"/>
                <a:gd name="connsiteY0" fmla="*/ 10000 h 10000"/>
                <a:gd name="connsiteX1" fmla="*/ 51283 w 84651"/>
                <a:gd name="connsiteY1" fmla="*/ 0 h 10000"/>
                <a:gd name="connsiteX2" fmla="*/ 59658 w 84651"/>
                <a:gd name="connsiteY2" fmla="*/ 10000 h 10000"/>
                <a:gd name="connsiteX0" fmla="*/ 148647 w 173640"/>
                <a:gd name="connsiteY0" fmla="*/ 10000 h 10000"/>
                <a:gd name="connsiteX1" fmla="*/ 140272 w 173640"/>
                <a:gd name="connsiteY1" fmla="*/ 0 h 10000"/>
                <a:gd name="connsiteX2" fmla="*/ 148647 w 173640"/>
                <a:gd name="connsiteY2" fmla="*/ 10000 h 10000"/>
                <a:gd name="connsiteX0" fmla="*/ 148647 w 153064"/>
                <a:gd name="connsiteY0" fmla="*/ 10000 h 10000"/>
                <a:gd name="connsiteX1" fmla="*/ 140272 w 153064"/>
                <a:gd name="connsiteY1" fmla="*/ 0 h 10000"/>
                <a:gd name="connsiteX2" fmla="*/ 148647 w 153064"/>
                <a:gd name="connsiteY2" fmla="*/ 10000 h 10000"/>
                <a:gd name="connsiteX0" fmla="*/ 148647 w 148647"/>
                <a:gd name="connsiteY0" fmla="*/ 10000 h 10000"/>
                <a:gd name="connsiteX1" fmla="*/ 140272 w 148647"/>
                <a:gd name="connsiteY1" fmla="*/ 0 h 10000"/>
                <a:gd name="connsiteX2" fmla="*/ 148647 w 148647"/>
                <a:gd name="connsiteY2" fmla="*/ 10000 h 10000"/>
                <a:gd name="connsiteX0" fmla="*/ 154722 w 154722"/>
                <a:gd name="connsiteY0" fmla="*/ 10000 h 10000"/>
                <a:gd name="connsiteX1" fmla="*/ 146347 w 154722"/>
                <a:gd name="connsiteY1" fmla="*/ 0 h 10000"/>
                <a:gd name="connsiteX2" fmla="*/ 154722 w 154722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3231"/>
                <a:gd name="connsiteY0" fmla="*/ 10000 h 10000"/>
                <a:gd name="connsiteX1" fmla="*/ 144350 w 153231"/>
                <a:gd name="connsiteY1" fmla="*/ 0 h 10000"/>
                <a:gd name="connsiteX2" fmla="*/ 152725 w 153231"/>
                <a:gd name="connsiteY2" fmla="*/ 10000 h 10000"/>
                <a:gd name="connsiteX0" fmla="*/ 152725 w 153930"/>
                <a:gd name="connsiteY0" fmla="*/ 10000 h 10000"/>
                <a:gd name="connsiteX1" fmla="*/ 144350 w 153930"/>
                <a:gd name="connsiteY1" fmla="*/ 0 h 10000"/>
                <a:gd name="connsiteX2" fmla="*/ 152725 w 153930"/>
                <a:gd name="connsiteY2" fmla="*/ 10000 h 10000"/>
                <a:gd name="connsiteX0" fmla="*/ 152725 w 156746"/>
                <a:gd name="connsiteY0" fmla="*/ 10000 h 10000"/>
                <a:gd name="connsiteX1" fmla="*/ 144350 w 156746"/>
                <a:gd name="connsiteY1" fmla="*/ 0 h 10000"/>
                <a:gd name="connsiteX2" fmla="*/ 152725 w 156746"/>
                <a:gd name="connsiteY2" fmla="*/ 10000 h 10000"/>
                <a:gd name="connsiteX0" fmla="*/ 156368 w 160389"/>
                <a:gd name="connsiteY0" fmla="*/ 10000 h 10000"/>
                <a:gd name="connsiteX1" fmla="*/ 147993 w 160389"/>
                <a:gd name="connsiteY1" fmla="*/ 0 h 10000"/>
                <a:gd name="connsiteX2" fmla="*/ 156368 w 160389"/>
                <a:gd name="connsiteY2" fmla="*/ 10000 h 10000"/>
                <a:gd name="connsiteX0" fmla="*/ 159522 w 163543"/>
                <a:gd name="connsiteY0" fmla="*/ 10000 h 10000"/>
                <a:gd name="connsiteX1" fmla="*/ 151147 w 163543"/>
                <a:gd name="connsiteY1" fmla="*/ 0 h 10000"/>
                <a:gd name="connsiteX2" fmla="*/ 159522 w 163543"/>
                <a:gd name="connsiteY2" fmla="*/ 10000 h 10000"/>
                <a:gd name="connsiteX0" fmla="*/ 164492 w 168513"/>
                <a:gd name="connsiteY0" fmla="*/ 10000 h 10000"/>
                <a:gd name="connsiteX1" fmla="*/ 156117 w 168513"/>
                <a:gd name="connsiteY1" fmla="*/ 0 h 10000"/>
                <a:gd name="connsiteX2" fmla="*/ 164492 w 168513"/>
                <a:gd name="connsiteY2" fmla="*/ 10000 h 10000"/>
                <a:gd name="connsiteX0" fmla="*/ 157865 w 166869"/>
                <a:gd name="connsiteY0" fmla="*/ 10241 h 10241"/>
                <a:gd name="connsiteX1" fmla="*/ 161044 w 166869"/>
                <a:gd name="connsiteY1" fmla="*/ 0 h 10241"/>
                <a:gd name="connsiteX2" fmla="*/ 157865 w 166869"/>
                <a:gd name="connsiteY2" fmla="*/ 10241 h 1024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66869" h="10241">
                  <a:moveTo>
                    <a:pt x="157865" y="10241"/>
                  </a:moveTo>
                  <a:cubicBezTo>
                    <a:pt x="166687" y="7400"/>
                    <a:pt x="171237" y="2927"/>
                    <a:pt x="161044" y="0"/>
                  </a:cubicBezTo>
                  <a:cubicBezTo>
                    <a:pt x="-90146" y="1558"/>
                    <a:pt x="-12963" y="7628"/>
                    <a:pt x="157865" y="10241"/>
                  </a:cubicBezTo>
                  <a:close/>
                </a:path>
              </a:pathLst>
            </a:custGeom>
            <a:gradFill flip="none" rotWithShape="1">
              <a:gsLst>
                <a:gs pos="20000">
                  <a:srgbClr val="DFDFDF"/>
                </a:gs>
                <a:gs pos="0">
                  <a:sysClr val="window" lastClr="FFFFFF">
                    <a:lumMod val="95000"/>
                  </a:sysClr>
                </a:gs>
                <a:gs pos="97000">
                  <a:sysClr val="window" lastClr="FFFFFF">
                    <a:lumMod val="65000"/>
                  </a:sysClr>
                </a:gs>
                <a:gs pos="69000">
                  <a:sysClr val="windowText" lastClr="000000">
                    <a:lumMod val="50000"/>
                    <a:lumOff val="50000"/>
                  </a:sysClr>
                </a:gs>
                <a:gs pos="84000">
                  <a:sysClr val="window" lastClr="FFFFFF">
                    <a:lumMod val="95000"/>
                  </a:sysClr>
                </a:gs>
              </a:gsLst>
              <a:lin ang="0" scaled="1"/>
              <a:tileRect/>
            </a:gradFill>
            <a:ln w="25400" cap="flat" cmpd="sng" algn="ctr">
              <a:noFill/>
              <a:prstDash val="solid"/>
            </a:ln>
            <a:effectLst>
              <a:outerShdw blurRad="177800" dist="38100" dir="720000" algn="l" rotWithShape="0">
                <a:prstClr val="black">
                  <a:alpha val="63000"/>
                </a:prstClr>
              </a:outerShdw>
            </a:effectLst>
          </p:spPr>
          <p:txBody>
            <a:bodyPr rtlCol="0" anchor="ctr"/>
            <a:lstStyle/>
            <a:p>
              <a:pPr algn="ctr">
                <a:defRPr/>
              </a:pPr>
              <a:endParaRPr lang="en-US" sz="1200" kern="0">
                <a:solidFill>
                  <a:sysClr val="window" lastClr="FFFFFF"/>
                </a:solidFill>
              </a:endParaRPr>
            </a:p>
          </p:txBody>
        </p:sp>
        <p:sp>
          <p:nvSpPr>
            <p:cNvPr id="5" name="Rectangle 4"/>
            <p:cNvSpPr/>
            <p:nvPr/>
          </p:nvSpPr>
          <p:spPr>
            <a:xfrm>
              <a:off x="9592047" y="-116888"/>
              <a:ext cx="2617416" cy="1048170"/>
            </a:xfrm>
            <a:prstGeom prst="rect">
              <a:avLst/>
            </a:prstGeom>
            <a:noFill/>
          </p:spPr>
          <p:txBody>
            <a:bodyPr wrap="square" lIns="432044" tIns="216022" rIns="432044" bIns="216022">
              <a:spAutoFit/>
            </a:bodyPr>
            <a:lstStyle>
              <a:defPPr>
                <a:defRPr lang="ar-EG"/>
              </a:defPPr>
              <a:lvl1pPr marL="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defTabSz="914363" rtl="0">
                <a:spcBef>
                  <a:spcPct val="0"/>
                </a:spcBef>
                <a:defRPr/>
              </a:pPr>
              <a:r>
                <a:rPr lang="en-US" sz="1400" cap="small" dirty="0" smtClean="0">
                  <a:ln w="12700">
                    <a:noFill/>
                  </a:ln>
                  <a:solidFill>
                    <a:prstClr val="black"/>
                  </a:solidFill>
                  <a:latin typeface="Book Antiqua" pitchFamily="18" charset="0"/>
                  <a:cs typeface="Diwani Letter" pitchFamily="2" charset="-78"/>
                </a:rPr>
                <a:t>Results </a:t>
              </a:r>
              <a:endParaRPr lang="ar-EG" sz="1200" cap="small" dirty="0">
                <a:ln w="12700">
                  <a:noFill/>
                </a:ln>
                <a:solidFill>
                  <a:prstClr val="black"/>
                </a:solidFill>
                <a:latin typeface="Book Antiqua" pitchFamily="18" charset="0"/>
                <a:cs typeface="Diwani Letter" pitchFamily="2" charset="-78"/>
              </a:endParaRPr>
            </a:p>
          </p:txBody>
        </p:sp>
      </p:grpSp>
      <p:sp>
        <p:nvSpPr>
          <p:cNvPr id="12" name="Rectangle 11"/>
          <p:cNvSpPr/>
          <p:nvPr/>
        </p:nvSpPr>
        <p:spPr>
          <a:xfrm>
            <a:off x="4943635" y="2664314"/>
            <a:ext cx="6647268" cy="1484766"/>
          </a:xfrm>
          <a:prstGeom prst="rect">
            <a:avLst/>
          </a:prstGeom>
          <a:solidFill>
            <a:schemeClr val="tx1">
              <a:alpha val="7000"/>
            </a:schemeClr>
          </a:solidFill>
          <a:ln w="19050" cap="flat" cmpd="sng" algn="ctr">
            <a:gradFill flip="none" rotWithShape="1">
              <a:gsLst>
                <a:gs pos="0">
                  <a:srgbClr val="FBE4AE"/>
                </a:gs>
                <a:gs pos="13000">
                  <a:srgbClr val="BD922A"/>
                </a:gs>
                <a:gs pos="21001">
                  <a:srgbClr val="BD922A"/>
                </a:gs>
                <a:gs pos="63000">
                  <a:srgbClr val="FBE4AE"/>
                </a:gs>
                <a:gs pos="67000">
                  <a:srgbClr val="BD922A"/>
                </a:gs>
                <a:gs pos="69000">
                  <a:srgbClr val="835E17"/>
                </a:gs>
                <a:gs pos="82001">
                  <a:srgbClr val="A28949"/>
                </a:gs>
                <a:gs pos="100000">
                  <a:srgbClr val="FAE3B7"/>
                </a:gs>
              </a:gsLst>
              <a:lin ang="18900000" scaled="1"/>
              <a:tileRect/>
            </a:gradFill>
            <a:prstDash val="solid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l" rtl="0"/>
            <a:endParaRPr lang="ar-EG" sz="3600" kern="0">
              <a:solidFill>
                <a:sysClr val="window" lastClr="FFFFFF"/>
              </a:solidFill>
              <a:latin typeface="Cambria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584408" y="3153133"/>
            <a:ext cx="9207542" cy="576248"/>
          </a:xfrm>
          <a:prstGeom prst="rect">
            <a:avLst/>
          </a:prstGeom>
          <a:noFill/>
          <a:ln>
            <a:noFill/>
          </a:ln>
          <a:effectLst>
            <a:glow rad="25400">
              <a:schemeClr val="tx1">
                <a:alpha val="99000"/>
              </a:schemeClr>
            </a:glow>
          </a:effectLst>
        </p:spPr>
        <p:txBody>
          <a:bodyPr wrap="square" rtlCol="1">
            <a:spAutoFit/>
          </a:bodyPr>
          <a:lstStyle>
            <a:defPPr>
              <a:defRPr lang="ar-EG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ctr" defTabSz="914363" rtl="0">
              <a:lnSpc>
                <a:spcPct val="120000"/>
              </a:lnSpc>
              <a:spcBef>
                <a:spcPct val="0"/>
              </a:spcBef>
              <a:defRPr/>
            </a:pPr>
            <a:r>
              <a:rPr lang="en-US" sz="2800" b="1" kern="0" dirty="0" smtClean="0">
                <a:solidFill>
                  <a:srgbClr val="E8B7B7">
                    <a:lumMod val="20000"/>
                    <a:lumOff val="80000"/>
                  </a:srgbClr>
                </a:solidFill>
                <a:effectLst>
                  <a:glow rad="25400">
                    <a:sysClr val="windowText" lastClr="000000">
                      <a:alpha val="99000"/>
                    </a:sysClr>
                  </a:glow>
                  <a:outerShdw blurRad="50800" dist="38100" dir="2700000" algn="tl" rotWithShape="0">
                    <a:prstClr val="black"/>
                  </a:outerShdw>
                </a:effectLst>
                <a:latin typeface="Book Antiqua" pitchFamily="18" charset="0"/>
                <a:cs typeface="Arial" charset="0"/>
              </a:rPr>
              <a:t>Global Longitudinal Strain (GLS)</a:t>
            </a:r>
            <a:endParaRPr lang="en-US" sz="2800" b="1" kern="0" dirty="0">
              <a:solidFill>
                <a:srgbClr val="E8B7B7">
                  <a:lumMod val="20000"/>
                  <a:lumOff val="80000"/>
                </a:srgbClr>
              </a:solidFill>
              <a:effectLst>
                <a:glow rad="25400">
                  <a:sysClr val="windowText" lastClr="000000">
                    <a:alpha val="99000"/>
                  </a:sysClr>
                </a:glow>
                <a:outerShdw blurRad="50800" dist="38100" dir="2700000" algn="tl" rotWithShape="0">
                  <a:prstClr val="black"/>
                </a:outerShdw>
              </a:effectLst>
              <a:latin typeface="Book Antiqua" pitchFamily="18" charset="0"/>
              <a:cs typeface="Arial" charset="0"/>
            </a:endParaRPr>
          </a:p>
        </p:txBody>
      </p:sp>
      <p:pic>
        <p:nvPicPr>
          <p:cNvPr id="10" name="Picture 9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574926" y="980728"/>
            <a:ext cx="4759367" cy="47593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4219516" y="2733902"/>
            <a:ext cx="3517885" cy="1631202"/>
          </a:xfrm>
          <a:prstGeom prst="rect">
            <a:avLst/>
          </a:prstGeom>
        </p:spPr>
        <p:txBody>
          <a:bodyPr wrap="square" lIns="91427" tIns="45713" rIns="91427" bIns="45713">
            <a:spAutoFit/>
          </a:bodyPr>
          <a:lstStyle/>
          <a:p>
            <a:pPr lvl="0" algn="ctr" defTabSz="914363">
              <a:spcBef>
                <a:spcPct val="0"/>
              </a:spcBef>
              <a:defRPr/>
            </a:pPr>
            <a:r>
              <a:rPr lang="en-US" sz="3400" b="1" kern="0" spc="300" dirty="0">
                <a:solidFill>
                  <a:srgbClr val="B01513"/>
                </a:solidFill>
                <a:latin typeface="Book Antiqua" pitchFamily="18" charset="0"/>
                <a:cs typeface="AF_Unizah " pitchFamily="2" charset="-78"/>
              </a:rPr>
              <a:t>A case of</a:t>
            </a:r>
          </a:p>
          <a:p>
            <a:pPr lvl="0" algn="ctr" defTabSz="914363">
              <a:spcBef>
                <a:spcPct val="0"/>
              </a:spcBef>
              <a:defRPr/>
            </a:pPr>
            <a:r>
              <a:rPr lang="en-US" sz="6600" b="1" kern="0" spc="300" dirty="0">
                <a:gradFill flip="none" rotWithShape="1">
                  <a:gsLst>
                    <a:gs pos="0">
                      <a:srgbClr val="38979E">
                        <a:shade val="30000"/>
                        <a:satMod val="115000"/>
                      </a:srgbClr>
                    </a:gs>
                    <a:gs pos="50000">
                      <a:srgbClr val="38979E">
                        <a:shade val="67500"/>
                        <a:satMod val="115000"/>
                      </a:srgbClr>
                    </a:gs>
                    <a:gs pos="100000">
                      <a:srgbClr val="38979E">
                        <a:shade val="100000"/>
                        <a:satMod val="115000"/>
                      </a:srgbClr>
                    </a:gs>
                  </a:gsLst>
                  <a:lin ang="16200000" scaled="1"/>
                  <a:tileRect/>
                </a:gradFill>
                <a:latin typeface="Book Antiqua" pitchFamily="18" charset="0"/>
                <a:cs typeface="AF_Unizah " pitchFamily="2" charset="-78"/>
              </a:rPr>
              <a:t>PIVD</a:t>
            </a:r>
            <a:endParaRPr lang="en-US" sz="6000" b="1" kern="0" spc="300" dirty="0">
              <a:gradFill flip="none" rotWithShape="1">
                <a:gsLst>
                  <a:gs pos="0">
                    <a:srgbClr val="38979E">
                      <a:shade val="30000"/>
                      <a:satMod val="115000"/>
                    </a:srgbClr>
                  </a:gs>
                  <a:gs pos="50000">
                    <a:srgbClr val="38979E">
                      <a:shade val="67500"/>
                      <a:satMod val="115000"/>
                    </a:srgbClr>
                  </a:gs>
                  <a:gs pos="100000">
                    <a:srgbClr val="38979E">
                      <a:shade val="100000"/>
                      <a:satMod val="115000"/>
                    </a:srgbClr>
                  </a:gs>
                </a:gsLst>
                <a:lin ang="16200000" scaled="1"/>
                <a:tileRect/>
              </a:gradFill>
              <a:latin typeface="Book Antiqua" pitchFamily="18" charset="0"/>
              <a:cs typeface="AF_Unizah " pitchFamily="2" charset="-78"/>
            </a:endParaRPr>
          </a:p>
        </p:txBody>
      </p:sp>
    </p:spTree>
    <p:extLst>
      <p:ext uri="{BB962C8B-B14F-4D97-AF65-F5344CB8AC3E}">
        <p14:creationId xmlns:p14="http://schemas.microsoft.com/office/powerpoint/2010/main" val="128480069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" dur="10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" fill="hold">
                            <p:stCondLst>
                              <p:cond delay="1500"/>
                            </p:stCondLst>
                            <p:childTnLst>
                              <p:par>
                                <p:cTn id="13" presetID="35" presetClass="path" presetSubtype="0" accel="50000" decel="5000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0 L -0.25 0 E" pathEditMode="relative" ptsTypes="">
                                      <p:cBhvr>
                                        <p:cTn id="14" dur="1000" fill="hold"/>
                                        <p:tgtEl>
                                          <p:spTgt spid="10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15" presetID="35" presetClass="path" presetSubtype="0" accel="50000" decel="5000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0 L -0.25 0 E" pathEditMode="relative" ptsTypes="">
                                      <p:cBhvr>
                                        <p:cTn id="16" dur="1000" fill="hold"/>
                                        <p:tgtEl>
                                          <p:spTgt spid="11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7" fill="hold">
                            <p:stCondLst>
                              <p:cond delay="2500"/>
                            </p:stCondLst>
                            <p:childTnLst>
                              <p:par>
                                <p:cTn id="18" presetID="2" presetClass="entr" presetSubtype="8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1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1" dur="500" fill="hold"/>
                                        <p:tgtEl>
                                          <p:spTgt spid="1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2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4" dur="500" fill="hold"/>
                                        <p:tgtEl>
                                          <p:spTgt spid="1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5" dur="500" fill="hold"/>
                                        <p:tgtEl>
                                          <p:spTgt spid="1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2" grpId="0" animBg="1"/>
      <p:bldP spid="13" grpId="0"/>
      <p:bldP spid="11" grpId="0"/>
      <p:bldP spid="11" grpId="1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D:\Data Show\Data show 2019\Medicine\Alexandria\Cardiology\Mostafa 3li Soliman\PIVD\GLS\Pre\Mos 36 PreEzz Gaber20180424120618946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063" y="174448"/>
            <a:ext cx="5483863" cy="3175009"/>
          </a:xfrm>
          <a:prstGeom prst="rect">
            <a:avLst/>
          </a:prstGeom>
          <a:ln w="38100">
            <a:gradFill flip="none" rotWithShape="1">
              <a:gsLst>
                <a:gs pos="0">
                  <a:srgbClr val="FBE4AE"/>
                </a:gs>
                <a:gs pos="13000">
                  <a:srgbClr val="BD922A"/>
                </a:gs>
                <a:gs pos="21001">
                  <a:srgbClr val="BD922A"/>
                </a:gs>
                <a:gs pos="63000">
                  <a:srgbClr val="FBE4AE"/>
                </a:gs>
                <a:gs pos="67000">
                  <a:srgbClr val="BD922A"/>
                </a:gs>
                <a:gs pos="69000">
                  <a:srgbClr val="835E17"/>
                </a:gs>
                <a:gs pos="82001">
                  <a:srgbClr val="A28949"/>
                </a:gs>
                <a:gs pos="100000">
                  <a:srgbClr val="FAE3B7"/>
                </a:gs>
              </a:gsLst>
              <a:lin ang="2700000" scaled="1"/>
              <a:tileRect/>
            </a:gradFill>
          </a:ln>
          <a:effectLst>
            <a:outerShdw blurRad="50800" dist="38100" dir="2700000" algn="tl" rotWithShape="0">
              <a:prstClr val="black">
                <a:alpha val="10000"/>
              </a:prst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D:\Data Show\Data show 2019\Medicine\Alexandria\Cardiology\Mostafa 3li Soliman\PIVD\GLS\Pre\Mos 36 PreEzz Gaber20180424120715666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11445" y="188640"/>
            <a:ext cx="5472608" cy="3160817"/>
          </a:xfrm>
          <a:prstGeom prst="rect">
            <a:avLst/>
          </a:prstGeom>
          <a:ln w="38100">
            <a:gradFill flip="none" rotWithShape="1">
              <a:gsLst>
                <a:gs pos="0">
                  <a:srgbClr val="FBE4AE"/>
                </a:gs>
                <a:gs pos="13000">
                  <a:srgbClr val="BD922A"/>
                </a:gs>
                <a:gs pos="21001">
                  <a:srgbClr val="BD922A"/>
                </a:gs>
                <a:gs pos="63000">
                  <a:srgbClr val="FBE4AE"/>
                </a:gs>
                <a:gs pos="67000">
                  <a:srgbClr val="BD922A"/>
                </a:gs>
                <a:gs pos="69000">
                  <a:srgbClr val="835E17"/>
                </a:gs>
                <a:gs pos="82001">
                  <a:srgbClr val="A28949"/>
                </a:gs>
                <a:gs pos="100000">
                  <a:srgbClr val="FAE3B7"/>
                </a:gs>
              </a:gsLst>
              <a:lin ang="2700000" scaled="1"/>
              <a:tileRect/>
            </a:gradFill>
          </a:ln>
          <a:effectLst>
            <a:outerShdw blurRad="50800" dist="38100" dir="2700000" algn="tl" rotWithShape="0">
              <a:prstClr val="black">
                <a:alpha val="10000"/>
              </a:prst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D:\Data Show\Data show 2019\Medicine\Alexandria\Cardiology\Mostafa 3li Soliman\PIVD\GLS\Pre\مع بعض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6574" y="3544670"/>
            <a:ext cx="5460119" cy="3160817"/>
          </a:xfrm>
          <a:prstGeom prst="rect">
            <a:avLst/>
          </a:prstGeom>
          <a:ln w="38100">
            <a:gradFill flip="none" rotWithShape="1">
              <a:gsLst>
                <a:gs pos="0">
                  <a:srgbClr val="FBE4AE"/>
                </a:gs>
                <a:gs pos="13000">
                  <a:srgbClr val="BD922A"/>
                </a:gs>
                <a:gs pos="21001">
                  <a:srgbClr val="BD922A"/>
                </a:gs>
                <a:gs pos="63000">
                  <a:srgbClr val="FBE4AE"/>
                </a:gs>
                <a:gs pos="67000">
                  <a:srgbClr val="BD922A"/>
                </a:gs>
                <a:gs pos="69000">
                  <a:srgbClr val="835E17"/>
                </a:gs>
                <a:gs pos="82001">
                  <a:srgbClr val="A28949"/>
                </a:gs>
                <a:gs pos="100000">
                  <a:srgbClr val="FAE3B7"/>
                </a:gs>
              </a:gsLst>
              <a:lin ang="2700000" scaled="1"/>
              <a:tileRect/>
            </a:gradFill>
          </a:ln>
          <a:effectLst>
            <a:outerShdw blurRad="50800" dist="38100" dir="2700000" algn="tl" rotWithShape="0">
              <a:prstClr val="black">
                <a:alpha val="10000"/>
              </a:prst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D:\Data Show\Data show 2019\Medicine\Alexandria\Cardiology\Mostafa 3li Soliman\PIVD\GLS\Pre\Mos 36 PreEzz Gaber20180424120718701.jpg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590" b="24795"/>
          <a:stretch/>
        </p:blipFill>
        <p:spPr bwMode="auto">
          <a:xfrm>
            <a:off x="6311229" y="3573016"/>
            <a:ext cx="5472823" cy="3168352"/>
          </a:xfrm>
          <a:prstGeom prst="rect">
            <a:avLst/>
          </a:prstGeom>
          <a:ln w="38100">
            <a:gradFill flip="none" rotWithShape="1">
              <a:gsLst>
                <a:gs pos="0">
                  <a:srgbClr val="FBE4AE"/>
                </a:gs>
                <a:gs pos="13000">
                  <a:srgbClr val="BD922A"/>
                </a:gs>
                <a:gs pos="21001">
                  <a:srgbClr val="BD922A"/>
                </a:gs>
                <a:gs pos="63000">
                  <a:srgbClr val="FBE4AE"/>
                </a:gs>
                <a:gs pos="67000">
                  <a:srgbClr val="BD922A"/>
                </a:gs>
                <a:gs pos="69000">
                  <a:srgbClr val="835E17"/>
                </a:gs>
                <a:gs pos="82001">
                  <a:srgbClr val="A28949"/>
                </a:gs>
                <a:gs pos="100000">
                  <a:srgbClr val="FAE3B7"/>
                </a:gs>
              </a:gsLst>
              <a:lin ang="2700000" scaled="1"/>
              <a:tileRect/>
            </a:gradFill>
          </a:ln>
          <a:effectLst>
            <a:outerShdw blurRad="50800" dist="38100" dir="2700000" algn="tl" rotWithShape="0">
              <a:prstClr val="black">
                <a:alpha val="10000"/>
              </a:prst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5" name="Group 4"/>
          <p:cNvGrpSpPr/>
          <p:nvPr/>
        </p:nvGrpSpPr>
        <p:grpSpPr>
          <a:xfrm>
            <a:off x="4078980" y="3212713"/>
            <a:ext cx="4176466" cy="647573"/>
            <a:chOff x="8607848" y="5498564"/>
            <a:chExt cx="1512334" cy="311214"/>
          </a:xfrm>
        </p:grpSpPr>
        <p:sp>
          <p:nvSpPr>
            <p:cNvPr id="3" name="Rectangle 2"/>
            <p:cNvSpPr/>
            <p:nvPr/>
          </p:nvSpPr>
          <p:spPr>
            <a:xfrm>
              <a:off x="8702734" y="5498564"/>
              <a:ext cx="1326004" cy="311214"/>
            </a:xfrm>
            <a:prstGeom prst="rect">
              <a:avLst/>
            </a:prstGeom>
            <a:gradFill flip="none" rotWithShape="1">
              <a:gsLst>
                <a:gs pos="0">
                  <a:sysClr val="window" lastClr="FFFFFF"/>
                </a:gs>
                <a:gs pos="90000">
                  <a:sysClr val="window" lastClr="FFFFFF">
                    <a:lumMod val="65000"/>
                  </a:sysClr>
                </a:gs>
                <a:gs pos="73000">
                  <a:sysClr val="window" lastClr="FFFFFF"/>
                </a:gs>
                <a:gs pos="50500">
                  <a:sysClr val="window" lastClr="FFFFFF"/>
                </a:gs>
                <a:gs pos="14000">
                  <a:sysClr val="window" lastClr="FFFFFF"/>
                </a:gs>
              </a:gsLst>
              <a:path path="circle">
                <a:fillToRect l="50000" t="50000" r="50000" b="50000"/>
              </a:path>
              <a:tileRect/>
            </a:gradFill>
            <a:ln w="25400" cap="flat" cmpd="sng" algn="ctr">
              <a:noFill/>
              <a:prstDash val="solid"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 rtlCol="1" anchor="ctr"/>
            <a:lstStyle/>
            <a:p>
              <a:pPr algn="ctr"/>
              <a:endParaRPr lang="en-GB" sz="2400" kern="0" spc="200">
                <a:solidFill>
                  <a:prstClr val="black"/>
                </a:solidFill>
                <a:latin typeface="Clearly Gothic" pitchFamily="2" charset="0"/>
              </a:endParaRPr>
            </a:p>
          </p:txBody>
        </p:sp>
        <p:sp>
          <p:nvSpPr>
            <p:cNvPr id="4" name="Rectangle 3"/>
            <p:cNvSpPr/>
            <p:nvPr/>
          </p:nvSpPr>
          <p:spPr>
            <a:xfrm>
              <a:off x="8607848" y="5503065"/>
              <a:ext cx="1512334" cy="25702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ase">
                <a:lnSpc>
                  <a:spcPct val="130000"/>
                </a:lnSpc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GB" sz="2400" b="1" kern="0" spc="300" dirty="0" smtClean="0">
                  <a:solidFill>
                    <a:schemeClr val="bg1"/>
                  </a:solidFill>
                  <a:latin typeface="Book Antiqua" panose="02040602050305030304" pitchFamily="18" charset="0"/>
                </a:rPr>
                <a:t>Pre-Pacing GLS </a:t>
              </a:r>
              <a:endParaRPr lang="en-GB" sz="2400" b="1" kern="0" spc="300" dirty="0">
                <a:solidFill>
                  <a:schemeClr val="bg1"/>
                </a:solidFill>
                <a:latin typeface="Book Antiqua" panose="02040602050305030304" pitchFamily="18" charset="0"/>
              </a:endParaRP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9712788" y="6067685"/>
            <a:ext cx="1494986" cy="457659"/>
            <a:chOff x="8702734" y="5498564"/>
            <a:chExt cx="1326004" cy="339921"/>
          </a:xfrm>
        </p:grpSpPr>
        <p:sp>
          <p:nvSpPr>
            <p:cNvPr id="10" name="Rectangle 9"/>
            <p:cNvSpPr/>
            <p:nvPr/>
          </p:nvSpPr>
          <p:spPr>
            <a:xfrm>
              <a:off x="8702734" y="5498564"/>
              <a:ext cx="1326004" cy="311214"/>
            </a:xfrm>
            <a:prstGeom prst="rect">
              <a:avLst/>
            </a:prstGeom>
            <a:gradFill flip="none" rotWithShape="1">
              <a:gsLst>
                <a:gs pos="0">
                  <a:sysClr val="window" lastClr="FFFFFF"/>
                </a:gs>
                <a:gs pos="90000">
                  <a:sysClr val="window" lastClr="FFFFFF">
                    <a:lumMod val="65000"/>
                  </a:sysClr>
                </a:gs>
                <a:gs pos="73000">
                  <a:sysClr val="window" lastClr="FFFFFF"/>
                </a:gs>
                <a:gs pos="50500">
                  <a:sysClr val="window" lastClr="FFFFFF"/>
                </a:gs>
                <a:gs pos="14000">
                  <a:sysClr val="window" lastClr="FFFFFF"/>
                </a:gs>
              </a:gsLst>
              <a:path path="circle">
                <a:fillToRect l="50000" t="50000" r="50000" b="50000"/>
              </a:path>
              <a:tileRect/>
            </a:gradFill>
            <a:ln w="25400" cap="flat" cmpd="sng" algn="ctr">
              <a:noFill/>
              <a:prstDash val="solid"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 rtlCol="1" anchor="ctr"/>
            <a:lstStyle/>
            <a:p>
              <a:pPr algn="ctr"/>
              <a:endParaRPr lang="en-GB" sz="2400" kern="0" spc="200">
                <a:solidFill>
                  <a:prstClr val="black"/>
                </a:solidFill>
                <a:latin typeface="Clearly Gothic" pitchFamily="2" charset="0"/>
              </a:endParaRP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8856995" y="5503065"/>
              <a:ext cx="1014036" cy="3354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lnSpc>
                  <a:spcPct val="83000"/>
                </a:lnSpc>
              </a:pPr>
              <a:r>
                <a:rPr lang="en-GB" sz="1400" b="1" kern="0" dirty="0" smtClean="0">
                  <a:solidFill>
                    <a:srgbClr val="B01513">
                      <a:lumMod val="75000"/>
                    </a:srgbClr>
                  </a:solidFill>
                  <a:latin typeface="Book Antiqua" panose="02040602050305030304" pitchFamily="18" charset="0"/>
                </a:rPr>
                <a:t>GLS (Avg.) </a:t>
              </a:r>
            </a:p>
            <a:p>
              <a:pPr algn="ctr">
                <a:lnSpc>
                  <a:spcPct val="83000"/>
                </a:lnSpc>
              </a:pPr>
              <a:r>
                <a:rPr lang="en-GB" sz="1400" b="1" kern="0" dirty="0" smtClean="0">
                  <a:solidFill>
                    <a:srgbClr val="B01513">
                      <a:lumMod val="75000"/>
                    </a:srgbClr>
                  </a:solidFill>
                  <a:latin typeface="Book Antiqua" panose="02040602050305030304" pitchFamily="18" charset="0"/>
                </a:rPr>
                <a:t>-18%</a:t>
              </a:r>
              <a:endParaRPr lang="en-GB" sz="1400" dirty="0">
                <a:solidFill>
                  <a:srgbClr val="B01513">
                    <a:lumMod val="75000"/>
                  </a:srgbClr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2848683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9" decel="10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1000" fill="hold"/>
                                        <p:tgtEl>
                                          <p:spTgt spid="102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1000" fill="hold"/>
                                        <p:tgtEl>
                                          <p:spTgt spid="102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3" decel="100000" fill="hold" nodeType="withEffect">
                                  <p:stCondLst>
                                    <p:cond delay="10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1000" fill="hold"/>
                                        <p:tgtEl>
                                          <p:spTgt spid="102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1000" fill="hold"/>
                                        <p:tgtEl>
                                          <p:spTgt spid="102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3" presetID="2" presetClass="entr" presetSubtype="12" decel="100000" fill="hold" nodeType="withEffect">
                                  <p:stCondLst>
                                    <p:cond delay="10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5" dur="1000" fill="hold"/>
                                        <p:tgtEl>
                                          <p:spTgt spid="102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6" dur="1000" fill="hold"/>
                                        <p:tgtEl>
                                          <p:spTgt spid="102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7" presetID="2" presetClass="entr" presetSubtype="6" decel="100000" fill="hold" nodeType="withEffect">
                                  <p:stCondLst>
                                    <p:cond delay="10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9" dur="1000" fill="hold"/>
                                        <p:tgtEl>
                                          <p:spTgt spid="102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0" dur="1000" fill="hold"/>
                                        <p:tgtEl>
                                          <p:spTgt spid="102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1" fill="hold">
                            <p:stCondLst>
                              <p:cond delay="1100"/>
                            </p:stCondLst>
                            <p:childTnLst>
                              <p:par>
                                <p:cTn id="22" presetID="53" presetClass="entr" presetSubtype="16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24" dur="5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5" dur="5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26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53" presetClass="entr" presetSubtype="16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31" dur="500" fill="hold"/>
                                        <p:tgtEl>
                                          <p:spTgt spid="9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2" dur="500" fill="hold"/>
                                        <p:tgtEl>
                                          <p:spTgt spid="9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33" dur="500"/>
                                        <p:tgtEl>
                                          <p:spTgt spid="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Mos 36 FupEzz Gaber20180905184304796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334566" y="203154"/>
            <a:ext cx="5572307" cy="3051535"/>
          </a:xfrm>
          <a:prstGeom prst="rect">
            <a:avLst/>
          </a:prstGeom>
          <a:ln w="38100">
            <a:gradFill flip="none" rotWithShape="1">
              <a:gsLst>
                <a:gs pos="0">
                  <a:srgbClr val="FBE4AE"/>
                </a:gs>
                <a:gs pos="13000">
                  <a:srgbClr val="BD922A"/>
                </a:gs>
                <a:gs pos="21001">
                  <a:srgbClr val="BD922A"/>
                </a:gs>
                <a:gs pos="63000">
                  <a:srgbClr val="FBE4AE"/>
                </a:gs>
                <a:gs pos="67000">
                  <a:srgbClr val="BD922A"/>
                </a:gs>
                <a:gs pos="69000">
                  <a:srgbClr val="835E17"/>
                </a:gs>
                <a:gs pos="82001">
                  <a:srgbClr val="A28949"/>
                </a:gs>
                <a:gs pos="100000">
                  <a:srgbClr val="FAE3B7"/>
                </a:gs>
              </a:gsLst>
              <a:lin ang="2700000" scaled="1"/>
              <a:tileRect/>
            </a:gradFill>
          </a:ln>
          <a:effectLst>
            <a:outerShdw blurRad="50800" dist="38100" dir="2700000" algn="tl" rotWithShape="0">
              <a:prstClr val="black">
                <a:alpha val="10000"/>
              </a:prstClr>
            </a:outerShdw>
          </a:effectLst>
        </p:spPr>
      </p:pic>
      <p:pic>
        <p:nvPicPr>
          <p:cNvPr id="6" name="Mos 36 FupEzz Gaber20180905184453672.avi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6326472" y="188640"/>
            <a:ext cx="5601382" cy="3067457"/>
          </a:xfrm>
          <a:prstGeom prst="rect">
            <a:avLst/>
          </a:prstGeom>
          <a:ln w="38100">
            <a:gradFill flip="none" rotWithShape="1">
              <a:gsLst>
                <a:gs pos="0">
                  <a:srgbClr val="FBE4AE"/>
                </a:gs>
                <a:gs pos="13000">
                  <a:srgbClr val="BD922A"/>
                </a:gs>
                <a:gs pos="21001">
                  <a:srgbClr val="BD922A"/>
                </a:gs>
                <a:gs pos="63000">
                  <a:srgbClr val="FBE4AE"/>
                </a:gs>
                <a:gs pos="67000">
                  <a:srgbClr val="BD922A"/>
                </a:gs>
                <a:gs pos="69000">
                  <a:srgbClr val="835E17"/>
                </a:gs>
                <a:gs pos="82001">
                  <a:srgbClr val="A28949"/>
                </a:gs>
                <a:gs pos="100000">
                  <a:srgbClr val="FAE3B7"/>
                </a:gs>
              </a:gsLst>
              <a:lin ang="2700000" scaled="1"/>
              <a:tileRect/>
            </a:gradFill>
          </a:ln>
          <a:effectLst>
            <a:outerShdw blurRad="50800" dist="38100" dir="2700000" algn="tl" rotWithShape="0">
              <a:prstClr val="black">
                <a:alpha val="10000"/>
              </a:prstClr>
            </a:outerShdw>
          </a:effectLst>
        </p:spPr>
      </p:pic>
      <p:pic>
        <p:nvPicPr>
          <p:cNvPr id="7" name="Mos 36 FupEzz Gaber20180905184614931.avi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1"/>
          <a:stretch>
            <a:fillRect/>
          </a:stretch>
        </p:blipFill>
        <p:spPr>
          <a:xfrm>
            <a:off x="334566" y="3573016"/>
            <a:ext cx="5572307" cy="3051535"/>
          </a:xfrm>
          <a:prstGeom prst="rect">
            <a:avLst/>
          </a:prstGeom>
          <a:ln w="38100">
            <a:gradFill flip="none" rotWithShape="1">
              <a:gsLst>
                <a:gs pos="0">
                  <a:srgbClr val="FBE4AE"/>
                </a:gs>
                <a:gs pos="13000">
                  <a:srgbClr val="BD922A"/>
                </a:gs>
                <a:gs pos="21001">
                  <a:srgbClr val="BD922A"/>
                </a:gs>
                <a:gs pos="63000">
                  <a:srgbClr val="FBE4AE"/>
                </a:gs>
                <a:gs pos="67000">
                  <a:srgbClr val="BD922A"/>
                </a:gs>
                <a:gs pos="69000">
                  <a:srgbClr val="835E17"/>
                </a:gs>
                <a:gs pos="82001">
                  <a:srgbClr val="A28949"/>
                </a:gs>
                <a:gs pos="100000">
                  <a:srgbClr val="FAE3B7"/>
                </a:gs>
              </a:gsLst>
              <a:lin ang="2700000" scaled="1"/>
              <a:tileRect/>
            </a:gradFill>
          </a:ln>
          <a:effectLst>
            <a:outerShdw blurRad="50800" dist="38100" dir="2700000" algn="tl" rotWithShape="0">
              <a:prstClr val="black">
                <a:alpha val="10000"/>
              </a:prstClr>
            </a:outerShdw>
          </a:effec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97" t="16410" r="41171" b="38486"/>
          <a:stretch/>
        </p:blipFill>
        <p:spPr bwMode="auto">
          <a:xfrm>
            <a:off x="6324618" y="3586476"/>
            <a:ext cx="5601382" cy="3082884"/>
          </a:xfrm>
          <a:prstGeom prst="rect">
            <a:avLst/>
          </a:prstGeom>
          <a:ln w="38100">
            <a:gradFill flip="none" rotWithShape="1">
              <a:gsLst>
                <a:gs pos="0">
                  <a:srgbClr val="FBE4AE"/>
                </a:gs>
                <a:gs pos="13000">
                  <a:srgbClr val="BD922A"/>
                </a:gs>
                <a:gs pos="21001">
                  <a:srgbClr val="BD922A"/>
                </a:gs>
                <a:gs pos="63000">
                  <a:srgbClr val="FBE4AE"/>
                </a:gs>
                <a:gs pos="67000">
                  <a:srgbClr val="BD922A"/>
                </a:gs>
                <a:gs pos="69000">
                  <a:srgbClr val="835E17"/>
                </a:gs>
                <a:gs pos="82001">
                  <a:srgbClr val="A28949"/>
                </a:gs>
                <a:gs pos="100000">
                  <a:srgbClr val="FAE3B7"/>
                </a:gs>
              </a:gsLst>
              <a:lin ang="2700000" scaled="1"/>
              <a:tileRect/>
            </a:gradFill>
          </a:ln>
          <a:effectLst>
            <a:outerShdw blurRad="50800" dist="38100" dir="2700000" algn="tl" rotWithShape="0">
              <a:prstClr val="black">
                <a:alpha val="10000"/>
              </a:prst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grpSp>
        <p:nvGrpSpPr>
          <p:cNvPr id="15" name="Group 14"/>
          <p:cNvGrpSpPr/>
          <p:nvPr/>
        </p:nvGrpSpPr>
        <p:grpSpPr>
          <a:xfrm>
            <a:off x="4305517" y="3140968"/>
            <a:ext cx="3661897" cy="647573"/>
            <a:chOff x="8702734" y="5498564"/>
            <a:chExt cx="1326004" cy="311214"/>
          </a:xfrm>
        </p:grpSpPr>
        <p:sp>
          <p:nvSpPr>
            <p:cNvPr id="19" name="Rectangle 18"/>
            <p:cNvSpPr/>
            <p:nvPr/>
          </p:nvSpPr>
          <p:spPr>
            <a:xfrm>
              <a:off x="8702734" y="5498564"/>
              <a:ext cx="1326004" cy="311214"/>
            </a:xfrm>
            <a:prstGeom prst="rect">
              <a:avLst/>
            </a:prstGeom>
            <a:gradFill flip="none" rotWithShape="1">
              <a:gsLst>
                <a:gs pos="0">
                  <a:sysClr val="window" lastClr="FFFFFF"/>
                </a:gs>
                <a:gs pos="90000">
                  <a:sysClr val="window" lastClr="FFFFFF">
                    <a:lumMod val="65000"/>
                  </a:sysClr>
                </a:gs>
                <a:gs pos="73000">
                  <a:sysClr val="window" lastClr="FFFFFF"/>
                </a:gs>
                <a:gs pos="50500">
                  <a:sysClr val="window" lastClr="FFFFFF"/>
                </a:gs>
                <a:gs pos="14000">
                  <a:sysClr val="window" lastClr="FFFFFF"/>
                </a:gs>
              </a:gsLst>
              <a:path path="circle">
                <a:fillToRect l="50000" t="50000" r="50000" b="50000"/>
              </a:path>
              <a:tileRect/>
            </a:gradFill>
            <a:ln w="25400" cap="flat" cmpd="sng" algn="ctr">
              <a:noFill/>
              <a:prstDash val="solid"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 rtlCol="1" anchor="ctr"/>
            <a:lstStyle/>
            <a:p>
              <a:pPr algn="ctr"/>
              <a:endParaRPr lang="en-GB" sz="2400" kern="0" spc="200">
                <a:solidFill>
                  <a:prstClr val="black"/>
                </a:solidFill>
                <a:latin typeface="Clearly Gothic" pitchFamily="2" charset="0"/>
              </a:endParaRPr>
            </a:p>
          </p:txBody>
        </p:sp>
        <p:sp>
          <p:nvSpPr>
            <p:cNvPr id="20" name="Rectangle 19"/>
            <p:cNvSpPr/>
            <p:nvPr/>
          </p:nvSpPr>
          <p:spPr>
            <a:xfrm>
              <a:off x="8780013" y="5503065"/>
              <a:ext cx="1168004" cy="25702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ase">
                <a:lnSpc>
                  <a:spcPct val="130000"/>
                </a:lnSpc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GB" sz="2400" b="1" kern="0" spc="300" dirty="0" smtClean="0">
                  <a:solidFill>
                    <a:schemeClr val="bg1"/>
                  </a:solidFill>
                  <a:latin typeface="Book Antiqua" panose="02040602050305030304" pitchFamily="18" charset="0"/>
                </a:rPr>
                <a:t>Post-Pacing GLS </a:t>
              </a:r>
              <a:endParaRPr lang="en-GB" sz="2400" b="1" kern="0" spc="300" dirty="0">
                <a:solidFill>
                  <a:schemeClr val="bg1"/>
                </a:solidFill>
                <a:latin typeface="Book Antiqua" panose="02040602050305030304" pitchFamily="18" charset="0"/>
              </a:endParaRP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9839622" y="5805264"/>
            <a:ext cx="1494986" cy="457659"/>
            <a:chOff x="8702734" y="5498564"/>
            <a:chExt cx="1326004" cy="339921"/>
          </a:xfrm>
        </p:grpSpPr>
        <p:sp>
          <p:nvSpPr>
            <p:cNvPr id="10" name="Rectangle 9"/>
            <p:cNvSpPr/>
            <p:nvPr/>
          </p:nvSpPr>
          <p:spPr>
            <a:xfrm>
              <a:off x="8702734" y="5498564"/>
              <a:ext cx="1326004" cy="311214"/>
            </a:xfrm>
            <a:prstGeom prst="rect">
              <a:avLst/>
            </a:prstGeom>
            <a:gradFill flip="none" rotWithShape="1">
              <a:gsLst>
                <a:gs pos="0">
                  <a:sysClr val="window" lastClr="FFFFFF"/>
                </a:gs>
                <a:gs pos="90000">
                  <a:sysClr val="window" lastClr="FFFFFF">
                    <a:lumMod val="65000"/>
                  </a:sysClr>
                </a:gs>
                <a:gs pos="73000">
                  <a:sysClr val="window" lastClr="FFFFFF"/>
                </a:gs>
                <a:gs pos="50500">
                  <a:sysClr val="window" lastClr="FFFFFF"/>
                </a:gs>
                <a:gs pos="14000">
                  <a:sysClr val="window" lastClr="FFFFFF"/>
                </a:gs>
              </a:gsLst>
              <a:path path="circle">
                <a:fillToRect l="50000" t="50000" r="50000" b="50000"/>
              </a:path>
              <a:tileRect/>
            </a:gradFill>
            <a:ln w="25400" cap="flat" cmpd="sng" algn="ctr">
              <a:noFill/>
              <a:prstDash val="solid"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txBody>
            <a:bodyPr rtlCol="1" anchor="ctr"/>
            <a:lstStyle/>
            <a:p>
              <a:pPr algn="ctr"/>
              <a:endParaRPr lang="en-GB" sz="2400" kern="0" spc="200">
                <a:solidFill>
                  <a:prstClr val="black"/>
                </a:solidFill>
                <a:latin typeface="Clearly Gothic" pitchFamily="2" charset="0"/>
              </a:endParaRP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8856995" y="5503065"/>
              <a:ext cx="1014036" cy="3354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lnSpc>
                  <a:spcPct val="83000"/>
                </a:lnSpc>
              </a:pPr>
              <a:r>
                <a:rPr lang="en-GB" sz="1400" b="1" kern="0" dirty="0" smtClean="0">
                  <a:solidFill>
                    <a:srgbClr val="B01513">
                      <a:lumMod val="75000"/>
                    </a:srgbClr>
                  </a:solidFill>
                  <a:latin typeface="Book Antiqua" panose="02040602050305030304" pitchFamily="18" charset="0"/>
                </a:rPr>
                <a:t>GLS (Avg.) </a:t>
              </a:r>
            </a:p>
            <a:p>
              <a:pPr algn="ctr">
                <a:lnSpc>
                  <a:spcPct val="83000"/>
                </a:lnSpc>
              </a:pPr>
              <a:r>
                <a:rPr lang="en-GB" sz="1400" b="1" kern="0" dirty="0" smtClean="0">
                  <a:solidFill>
                    <a:srgbClr val="B01513">
                      <a:lumMod val="75000"/>
                    </a:srgbClr>
                  </a:solidFill>
                  <a:latin typeface="Book Antiqua" panose="02040602050305030304" pitchFamily="18" charset="0"/>
                </a:rPr>
                <a:t>-15%</a:t>
              </a:r>
              <a:endParaRPr lang="en-GB" sz="1400" dirty="0">
                <a:solidFill>
                  <a:srgbClr val="B01513">
                    <a:lumMod val="75000"/>
                  </a:srgbClr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8926401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6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05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05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9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3" presetID="2" presetClass="entr" presetSubtype="3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5" dur="5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7" presetID="2" presetClass="entr" presetSubtype="1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9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1" fill="hold">
                            <p:stCondLst>
                              <p:cond delay="500"/>
                            </p:stCondLst>
                            <p:childTnLst>
                              <p:par>
                                <p:cTn id="22" presetID="53" presetClass="entr" presetSubtype="16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24" dur="500" fill="hold"/>
                                        <p:tgtEl>
                                          <p:spTgt spid="15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5" dur="500" fill="hold"/>
                                        <p:tgtEl>
                                          <p:spTgt spid="15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26" dur="5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28" dur="8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29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30" dur="767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31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32" dur="800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>
                      <p:stCondLst>
                        <p:cond delay="indefinite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53" presetClass="entr" presetSubtype="16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37" dur="500" fill="hold"/>
                                        <p:tgtEl>
                                          <p:spTgt spid="9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8" dur="500" fill="hold"/>
                                        <p:tgtEl>
                                          <p:spTgt spid="9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39" dur="500"/>
                                        <p:tgtEl>
                                          <p:spTgt spid="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40" repeatCount="indefinite" fill="remove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video>
              <p:cMediaNode vol="80000">
                <p:cTn id="41" repeatCount="indefinite" fill="remove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video>
              <p:cMediaNode vol="80000">
                <p:cTn id="42" repeatCount="indefinite" fill="remove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9479582" y="-59821"/>
            <a:ext cx="2729881" cy="874353"/>
            <a:chOff x="9479582" y="-59821"/>
            <a:chExt cx="2729881" cy="874353"/>
          </a:xfrm>
        </p:grpSpPr>
        <p:sp>
          <p:nvSpPr>
            <p:cNvPr id="4" name="Rectangle 8"/>
            <p:cNvSpPr/>
            <p:nvPr/>
          </p:nvSpPr>
          <p:spPr>
            <a:xfrm rot="5400000" flipH="1">
              <a:off x="10370523" y="-950762"/>
              <a:ext cx="825382" cy="2607264"/>
            </a:xfrm>
            <a:custGeom>
              <a:avLst/>
              <a:gdLst>
                <a:gd name="connsiteX0" fmla="*/ 0 w 381000"/>
                <a:gd name="connsiteY0" fmla="*/ 0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4" fmla="*/ 0 w 381000"/>
                <a:gd name="connsiteY4" fmla="*/ 0 h 1066800"/>
                <a:gd name="connsiteX0" fmla="*/ 155804 w 381000"/>
                <a:gd name="connsiteY0" fmla="*/ 77413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4" fmla="*/ 155804 w 381000"/>
                <a:gd name="connsiteY4" fmla="*/ 77413 h 1066800"/>
                <a:gd name="connsiteX0" fmla="*/ 0 w 381000"/>
                <a:gd name="connsiteY0" fmla="*/ 1066800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0" fmla="*/ 0 w 381000"/>
                <a:gd name="connsiteY0" fmla="*/ 1066800 h 1066800"/>
                <a:gd name="connsiteX1" fmla="*/ 381000 w 381000"/>
                <a:gd name="connsiteY1" fmla="*/ 0 h 1066800"/>
                <a:gd name="connsiteX2" fmla="*/ 381000 w 381000"/>
                <a:gd name="connsiteY2" fmla="*/ 1066800 h 1066800"/>
                <a:gd name="connsiteX3" fmla="*/ 0 w 381000"/>
                <a:gd name="connsiteY3" fmla="*/ 1066800 h 1066800"/>
                <a:gd name="connsiteX0" fmla="*/ 0 w 382100"/>
                <a:gd name="connsiteY0" fmla="*/ 1066800 h 1266097"/>
                <a:gd name="connsiteX1" fmla="*/ 381000 w 382100"/>
                <a:gd name="connsiteY1" fmla="*/ 0 h 1266097"/>
                <a:gd name="connsiteX2" fmla="*/ 382100 w 382100"/>
                <a:gd name="connsiteY2" fmla="*/ 1266097 h 1266097"/>
                <a:gd name="connsiteX3" fmla="*/ 0 w 382100"/>
                <a:gd name="connsiteY3" fmla="*/ 1066800 h 1266097"/>
                <a:gd name="connsiteX0" fmla="*/ 81205 w 463305"/>
                <a:gd name="connsiteY0" fmla="*/ 1066800 h 1278547"/>
                <a:gd name="connsiteX1" fmla="*/ 462205 w 463305"/>
                <a:gd name="connsiteY1" fmla="*/ 0 h 1278547"/>
                <a:gd name="connsiteX2" fmla="*/ 463305 w 463305"/>
                <a:gd name="connsiteY2" fmla="*/ 1266097 h 1278547"/>
                <a:gd name="connsiteX3" fmla="*/ 81205 w 463305"/>
                <a:gd name="connsiteY3" fmla="*/ 1066800 h 1278547"/>
                <a:gd name="connsiteX0" fmla="*/ 1100 w 1100"/>
                <a:gd name="connsiteY0" fmla="*/ 1266097 h 1266097"/>
                <a:gd name="connsiteX1" fmla="*/ 0 w 1100"/>
                <a:gd name="connsiteY1" fmla="*/ 0 h 1266097"/>
                <a:gd name="connsiteX2" fmla="*/ 1100 w 1100"/>
                <a:gd name="connsiteY2" fmla="*/ 1266097 h 1266097"/>
                <a:gd name="connsiteX0" fmla="*/ 4504727 w 4504727"/>
                <a:gd name="connsiteY0" fmla="*/ 10000 h 10000"/>
                <a:gd name="connsiteX1" fmla="*/ 4494727 w 4504727"/>
                <a:gd name="connsiteY1" fmla="*/ 0 h 10000"/>
                <a:gd name="connsiteX2" fmla="*/ 4504727 w 4504727"/>
                <a:gd name="connsiteY2" fmla="*/ 10000 h 10000"/>
                <a:gd name="connsiteX0" fmla="*/ 4711554 w 4711554"/>
                <a:gd name="connsiteY0" fmla="*/ 10376 h 10376"/>
                <a:gd name="connsiteX1" fmla="*/ 3938749 w 4711554"/>
                <a:gd name="connsiteY1" fmla="*/ 0 h 10376"/>
                <a:gd name="connsiteX2" fmla="*/ 4711554 w 4711554"/>
                <a:gd name="connsiteY2" fmla="*/ 10376 h 10376"/>
                <a:gd name="connsiteX0" fmla="*/ 5453499 w 5453499"/>
                <a:gd name="connsiteY0" fmla="*/ 10376 h 10376"/>
                <a:gd name="connsiteX1" fmla="*/ 4680694 w 5453499"/>
                <a:gd name="connsiteY1" fmla="*/ 0 h 10376"/>
                <a:gd name="connsiteX2" fmla="*/ 5453499 w 5453499"/>
                <a:gd name="connsiteY2" fmla="*/ 10376 h 10376"/>
                <a:gd name="connsiteX0" fmla="*/ 5188217 w 5193990"/>
                <a:gd name="connsiteY0" fmla="*/ 10193 h 10193"/>
                <a:gd name="connsiteX1" fmla="*/ 5193988 w 5193990"/>
                <a:gd name="connsiteY1" fmla="*/ 0 h 10193"/>
                <a:gd name="connsiteX2" fmla="*/ 5188217 w 5193990"/>
                <a:gd name="connsiteY2" fmla="*/ 10193 h 10193"/>
                <a:gd name="connsiteX0" fmla="*/ 5198190 w 5203963"/>
                <a:gd name="connsiteY0" fmla="*/ 10265 h 10265"/>
                <a:gd name="connsiteX1" fmla="*/ 5203961 w 5203963"/>
                <a:gd name="connsiteY1" fmla="*/ 72 h 10265"/>
                <a:gd name="connsiteX2" fmla="*/ 5198190 w 5203963"/>
                <a:gd name="connsiteY2" fmla="*/ 10265 h 10265"/>
                <a:gd name="connsiteX0" fmla="*/ 3303499 w 3309272"/>
                <a:gd name="connsiteY0" fmla="*/ 10194 h 10194"/>
                <a:gd name="connsiteX1" fmla="*/ 3309270 w 3309272"/>
                <a:gd name="connsiteY1" fmla="*/ 1 h 10194"/>
                <a:gd name="connsiteX2" fmla="*/ 3303499 w 3309272"/>
                <a:gd name="connsiteY2" fmla="*/ 10194 h 10194"/>
                <a:gd name="connsiteX0" fmla="*/ 3375826 w 3381599"/>
                <a:gd name="connsiteY0" fmla="*/ 10193 h 10193"/>
                <a:gd name="connsiteX1" fmla="*/ 3381597 w 3381599"/>
                <a:gd name="connsiteY1" fmla="*/ 0 h 10193"/>
                <a:gd name="connsiteX2" fmla="*/ 3375826 w 3381599"/>
                <a:gd name="connsiteY2" fmla="*/ 10193 h 10193"/>
                <a:gd name="connsiteX0" fmla="*/ 3305544 w 3311317"/>
                <a:gd name="connsiteY0" fmla="*/ 10193 h 10193"/>
                <a:gd name="connsiteX1" fmla="*/ 3311315 w 3311317"/>
                <a:gd name="connsiteY1" fmla="*/ 0 h 10193"/>
                <a:gd name="connsiteX2" fmla="*/ 3305544 w 3311317"/>
                <a:gd name="connsiteY2" fmla="*/ 10193 h 10193"/>
                <a:gd name="connsiteX0" fmla="*/ 3358833 w 3358835"/>
                <a:gd name="connsiteY0" fmla="*/ 8987 h 8987"/>
                <a:gd name="connsiteX1" fmla="*/ 3232079 w 3358835"/>
                <a:gd name="connsiteY1" fmla="*/ 0 h 8987"/>
                <a:gd name="connsiteX2" fmla="*/ 3358833 w 3358835"/>
                <a:gd name="connsiteY2" fmla="*/ 8987 h 8987"/>
                <a:gd name="connsiteX0" fmla="*/ 6470 w 6470"/>
                <a:gd name="connsiteY0" fmla="*/ 10000 h 10000"/>
                <a:gd name="connsiteX1" fmla="*/ 6093 w 6470"/>
                <a:gd name="connsiteY1" fmla="*/ 0 h 10000"/>
                <a:gd name="connsiteX2" fmla="*/ 6470 w 6470"/>
                <a:gd name="connsiteY2" fmla="*/ 10000 h 10000"/>
                <a:gd name="connsiteX0" fmla="*/ 9802 w 9802"/>
                <a:gd name="connsiteY0" fmla="*/ 10000 h 10000"/>
                <a:gd name="connsiteX1" fmla="*/ 9219 w 9802"/>
                <a:gd name="connsiteY1" fmla="*/ 0 h 10000"/>
                <a:gd name="connsiteX2" fmla="*/ 9802 w 9802"/>
                <a:gd name="connsiteY2" fmla="*/ 10000 h 10000"/>
                <a:gd name="connsiteX0" fmla="*/ 9298 w 10018"/>
                <a:gd name="connsiteY0" fmla="*/ 10932 h 10932"/>
                <a:gd name="connsiteX1" fmla="*/ 9994 w 10018"/>
                <a:gd name="connsiteY1" fmla="*/ 0 h 10932"/>
                <a:gd name="connsiteX2" fmla="*/ 9298 w 10018"/>
                <a:gd name="connsiteY2" fmla="*/ 10932 h 10932"/>
                <a:gd name="connsiteX0" fmla="*/ 10017 w 10017"/>
                <a:gd name="connsiteY0" fmla="*/ 10384 h 10384"/>
                <a:gd name="connsiteX1" fmla="*/ 9391 w 10017"/>
                <a:gd name="connsiteY1" fmla="*/ 0 h 10384"/>
                <a:gd name="connsiteX2" fmla="*/ 10017 w 10017"/>
                <a:gd name="connsiteY2" fmla="*/ 10384 h 10384"/>
                <a:gd name="connsiteX0" fmla="*/ 4732 w 4732"/>
                <a:gd name="connsiteY0" fmla="*/ 10390 h 11041"/>
                <a:gd name="connsiteX1" fmla="*/ 4106 w 4732"/>
                <a:gd name="connsiteY1" fmla="*/ 6 h 11041"/>
                <a:gd name="connsiteX2" fmla="*/ 3 w 4732"/>
                <a:gd name="connsiteY2" fmla="*/ 8873 h 11041"/>
                <a:gd name="connsiteX3" fmla="*/ 4732 w 4732"/>
                <a:gd name="connsiteY3" fmla="*/ 10390 h 11041"/>
                <a:gd name="connsiteX0" fmla="*/ 5470 w 5470"/>
                <a:gd name="connsiteY0" fmla="*/ 9410 h 10025"/>
                <a:gd name="connsiteX1" fmla="*/ 4147 w 5470"/>
                <a:gd name="connsiteY1" fmla="*/ 5 h 10025"/>
                <a:gd name="connsiteX2" fmla="*/ 13 w 5470"/>
                <a:gd name="connsiteY2" fmla="*/ 8140 h 10025"/>
                <a:gd name="connsiteX3" fmla="*/ 5470 w 5470"/>
                <a:gd name="connsiteY3" fmla="*/ 9410 h 10025"/>
                <a:gd name="connsiteX0" fmla="*/ 10000 w 10000"/>
                <a:gd name="connsiteY0" fmla="*/ 9387 h 9696"/>
                <a:gd name="connsiteX1" fmla="*/ 7581 w 10000"/>
                <a:gd name="connsiteY1" fmla="*/ 5 h 9696"/>
                <a:gd name="connsiteX2" fmla="*/ 24 w 10000"/>
                <a:gd name="connsiteY2" fmla="*/ 8120 h 9696"/>
                <a:gd name="connsiteX3" fmla="*/ 10000 w 10000"/>
                <a:gd name="connsiteY3" fmla="*/ 9387 h 9696"/>
                <a:gd name="connsiteX0" fmla="*/ 65556 w 65556"/>
                <a:gd name="connsiteY0" fmla="*/ 9686 h 10004"/>
                <a:gd name="connsiteX1" fmla="*/ 63137 w 65556"/>
                <a:gd name="connsiteY1" fmla="*/ 10 h 10004"/>
                <a:gd name="connsiteX2" fmla="*/ 55580 w 65556"/>
                <a:gd name="connsiteY2" fmla="*/ 8380 h 10004"/>
                <a:gd name="connsiteX3" fmla="*/ 65556 w 65556"/>
                <a:gd name="connsiteY3" fmla="*/ 9686 h 10004"/>
                <a:gd name="connsiteX0" fmla="*/ 65556 w 65556"/>
                <a:gd name="connsiteY0" fmla="*/ 9686 h 10140"/>
                <a:gd name="connsiteX1" fmla="*/ 63137 w 65556"/>
                <a:gd name="connsiteY1" fmla="*/ 10 h 10140"/>
                <a:gd name="connsiteX2" fmla="*/ 55580 w 65556"/>
                <a:gd name="connsiteY2" fmla="*/ 8380 h 10140"/>
                <a:gd name="connsiteX3" fmla="*/ 65556 w 65556"/>
                <a:gd name="connsiteY3" fmla="*/ 9686 h 10140"/>
                <a:gd name="connsiteX0" fmla="*/ 64984 w 64984"/>
                <a:gd name="connsiteY0" fmla="*/ 10088 h 10491"/>
                <a:gd name="connsiteX1" fmla="*/ 63137 w 64984"/>
                <a:gd name="connsiteY1" fmla="*/ 10 h 10491"/>
                <a:gd name="connsiteX2" fmla="*/ 55580 w 64984"/>
                <a:gd name="connsiteY2" fmla="*/ 8380 h 10491"/>
                <a:gd name="connsiteX3" fmla="*/ 64984 w 64984"/>
                <a:gd name="connsiteY3" fmla="*/ 10088 h 10491"/>
                <a:gd name="connsiteX0" fmla="*/ 64984 w 64984"/>
                <a:gd name="connsiteY0" fmla="*/ 10088 h 10411"/>
                <a:gd name="connsiteX1" fmla="*/ 63137 w 64984"/>
                <a:gd name="connsiteY1" fmla="*/ 10 h 10411"/>
                <a:gd name="connsiteX2" fmla="*/ 55580 w 64984"/>
                <a:gd name="connsiteY2" fmla="*/ 8380 h 10411"/>
                <a:gd name="connsiteX3" fmla="*/ 64984 w 64984"/>
                <a:gd name="connsiteY3" fmla="*/ 10088 h 10411"/>
                <a:gd name="connsiteX0" fmla="*/ 64984 w 64984"/>
                <a:gd name="connsiteY0" fmla="*/ 10088 h 10088"/>
                <a:gd name="connsiteX1" fmla="*/ 63137 w 64984"/>
                <a:gd name="connsiteY1" fmla="*/ 10 h 10088"/>
                <a:gd name="connsiteX2" fmla="*/ 55580 w 64984"/>
                <a:gd name="connsiteY2" fmla="*/ 8380 h 10088"/>
                <a:gd name="connsiteX3" fmla="*/ 64984 w 64984"/>
                <a:gd name="connsiteY3" fmla="*/ 10088 h 10088"/>
                <a:gd name="connsiteX0" fmla="*/ 64984 w 64984"/>
                <a:gd name="connsiteY0" fmla="*/ 10088 h 10088"/>
                <a:gd name="connsiteX1" fmla="*/ 63137 w 64984"/>
                <a:gd name="connsiteY1" fmla="*/ 10 h 10088"/>
                <a:gd name="connsiteX2" fmla="*/ 55580 w 64984"/>
                <a:gd name="connsiteY2" fmla="*/ 8380 h 10088"/>
                <a:gd name="connsiteX3" fmla="*/ 64984 w 64984"/>
                <a:gd name="connsiteY3" fmla="*/ 10088 h 10088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097 w 80097"/>
                <a:gd name="connsiteY0" fmla="*/ 10091 h 10091"/>
                <a:gd name="connsiteX1" fmla="*/ 78250 w 80097"/>
                <a:gd name="connsiteY1" fmla="*/ 13 h 10091"/>
                <a:gd name="connsiteX2" fmla="*/ 51116 w 80097"/>
                <a:gd name="connsiteY2" fmla="*/ 7631 h 10091"/>
                <a:gd name="connsiteX3" fmla="*/ 80097 w 80097"/>
                <a:gd name="connsiteY3" fmla="*/ 10091 h 10091"/>
                <a:gd name="connsiteX0" fmla="*/ 80373 w 80373"/>
                <a:gd name="connsiteY0" fmla="*/ 10131 h 10131"/>
                <a:gd name="connsiteX1" fmla="*/ 78526 w 80373"/>
                <a:gd name="connsiteY1" fmla="*/ 53 h 10131"/>
                <a:gd name="connsiteX2" fmla="*/ 51392 w 80373"/>
                <a:gd name="connsiteY2" fmla="*/ 7671 h 10131"/>
                <a:gd name="connsiteX3" fmla="*/ 80373 w 80373"/>
                <a:gd name="connsiteY3" fmla="*/ 10131 h 10131"/>
                <a:gd name="connsiteX0" fmla="*/ 62961 w 62961"/>
                <a:gd name="connsiteY0" fmla="*/ 10126 h 10126"/>
                <a:gd name="connsiteX1" fmla="*/ 61114 w 62961"/>
                <a:gd name="connsiteY1" fmla="*/ 48 h 10126"/>
                <a:gd name="connsiteX2" fmla="*/ 33980 w 62961"/>
                <a:gd name="connsiteY2" fmla="*/ 7666 h 10126"/>
                <a:gd name="connsiteX3" fmla="*/ 62961 w 62961"/>
                <a:gd name="connsiteY3" fmla="*/ 10126 h 10126"/>
                <a:gd name="connsiteX0" fmla="*/ 62961 w 62961"/>
                <a:gd name="connsiteY0" fmla="*/ 10126 h 10126"/>
                <a:gd name="connsiteX1" fmla="*/ 61114 w 62961"/>
                <a:gd name="connsiteY1" fmla="*/ 48 h 10126"/>
                <a:gd name="connsiteX2" fmla="*/ 33980 w 62961"/>
                <a:gd name="connsiteY2" fmla="*/ 7666 h 10126"/>
                <a:gd name="connsiteX3" fmla="*/ 62961 w 62961"/>
                <a:gd name="connsiteY3" fmla="*/ 10126 h 10126"/>
                <a:gd name="connsiteX0" fmla="*/ 62357 w 62357"/>
                <a:gd name="connsiteY0" fmla="*/ 9891 h 9891"/>
                <a:gd name="connsiteX1" fmla="*/ 61114 w 62357"/>
                <a:gd name="connsiteY1" fmla="*/ 48 h 9891"/>
                <a:gd name="connsiteX2" fmla="*/ 33980 w 62357"/>
                <a:gd name="connsiteY2" fmla="*/ 7666 h 9891"/>
                <a:gd name="connsiteX3" fmla="*/ 62357 w 62357"/>
                <a:gd name="connsiteY3" fmla="*/ 9891 h 9891"/>
                <a:gd name="connsiteX0" fmla="*/ 10000 w 10178"/>
                <a:gd name="connsiteY0" fmla="*/ 10000 h 10000"/>
                <a:gd name="connsiteX1" fmla="*/ 9801 w 10178"/>
                <a:gd name="connsiteY1" fmla="*/ 49 h 10000"/>
                <a:gd name="connsiteX2" fmla="*/ 5449 w 10178"/>
                <a:gd name="connsiteY2" fmla="*/ 7750 h 10000"/>
                <a:gd name="connsiteX3" fmla="*/ 10000 w 10178"/>
                <a:gd name="connsiteY3" fmla="*/ 10000 h 10000"/>
                <a:gd name="connsiteX0" fmla="*/ 10000 w 10178"/>
                <a:gd name="connsiteY0" fmla="*/ 10000 h 10000"/>
                <a:gd name="connsiteX1" fmla="*/ 9801 w 10178"/>
                <a:gd name="connsiteY1" fmla="*/ 49 h 10000"/>
                <a:gd name="connsiteX2" fmla="*/ 5449 w 10178"/>
                <a:gd name="connsiteY2" fmla="*/ 7750 h 10000"/>
                <a:gd name="connsiteX3" fmla="*/ 10000 w 10178"/>
                <a:gd name="connsiteY3" fmla="*/ 10000 h 10000"/>
                <a:gd name="connsiteX0" fmla="*/ 10000 w 10178"/>
                <a:gd name="connsiteY0" fmla="*/ 10000 h 10000"/>
                <a:gd name="connsiteX1" fmla="*/ 9801 w 10178"/>
                <a:gd name="connsiteY1" fmla="*/ 49 h 10000"/>
                <a:gd name="connsiteX2" fmla="*/ 5449 w 10178"/>
                <a:gd name="connsiteY2" fmla="*/ 7750 h 10000"/>
                <a:gd name="connsiteX3" fmla="*/ 10000 w 10178"/>
                <a:gd name="connsiteY3" fmla="*/ 10000 h 10000"/>
                <a:gd name="connsiteX0" fmla="*/ 10267 w 10403"/>
                <a:gd name="connsiteY0" fmla="*/ 9740 h 9740"/>
                <a:gd name="connsiteX1" fmla="*/ 9801 w 10403"/>
                <a:gd name="connsiteY1" fmla="*/ 49 h 9740"/>
                <a:gd name="connsiteX2" fmla="*/ 5449 w 10403"/>
                <a:gd name="connsiteY2" fmla="*/ 7750 h 9740"/>
                <a:gd name="connsiteX3" fmla="*/ 10267 w 10403"/>
                <a:gd name="connsiteY3" fmla="*/ 9740 h 9740"/>
                <a:gd name="connsiteX0" fmla="*/ 9564 w 9745"/>
                <a:gd name="connsiteY0" fmla="*/ 9865 h 9865"/>
                <a:gd name="connsiteX1" fmla="*/ 9421 w 9745"/>
                <a:gd name="connsiteY1" fmla="*/ 50 h 9865"/>
                <a:gd name="connsiteX2" fmla="*/ 5238 w 9745"/>
                <a:gd name="connsiteY2" fmla="*/ 7957 h 9865"/>
                <a:gd name="connsiteX3" fmla="*/ 9564 w 9745"/>
                <a:gd name="connsiteY3" fmla="*/ 9865 h 9865"/>
                <a:gd name="connsiteX0" fmla="*/ 10130 w 10317"/>
                <a:gd name="connsiteY0" fmla="*/ 10000 h 10000"/>
                <a:gd name="connsiteX1" fmla="*/ 9984 w 10317"/>
                <a:gd name="connsiteY1" fmla="*/ 51 h 10000"/>
                <a:gd name="connsiteX2" fmla="*/ 5691 w 10317"/>
                <a:gd name="connsiteY2" fmla="*/ 8066 h 10000"/>
                <a:gd name="connsiteX3" fmla="*/ 10130 w 10317"/>
                <a:gd name="connsiteY3" fmla="*/ 10000 h 10000"/>
                <a:gd name="connsiteX0" fmla="*/ 10130 w 10317"/>
                <a:gd name="connsiteY0" fmla="*/ 10000 h 10000"/>
                <a:gd name="connsiteX1" fmla="*/ 9984 w 10317"/>
                <a:gd name="connsiteY1" fmla="*/ 51 h 10000"/>
                <a:gd name="connsiteX2" fmla="*/ 5691 w 10317"/>
                <a:gd name="connsiteY2" fmla="*/ 8066 h 10000"/>
                <a:gd name="connsiteX3" fmla="*/ 10130 w 10317"/>
                <a:gd name="connsiteY3" fmla="*/ 10000 h 10000"/>
                <a:gd name="connsiteX0" fmla="*/ 10130 w 10317"/>
                <a:gd name="connsiteY0" fmla="*/ 10000 h 10000"/>
                <a:gd name="connsiteX1" fmla="*/ 9984 w 10317"/>
                <a:gd name="connsiteY1" fmla="*/ 51 h 10000"/>
                <a:gd name="connsiteX2" fmla="*/ 5691 w 10317"/>
                <a:gd name="connsiteY2" fmla="*/ 8066 h 10000"/>
                <a:gd name="connsiteX3" fmla="*/ 10130 w 10317"/>
                <a:gd name="connsiteY3" fmla="*/ 10000 h 10000"/>
                <a:gd name="connsiteX0" fmla="*/ 9833 w 10120"/>
                <a:gd name="connsiteY0" fmla="*/ 10175 h 10175"/>
                <a:gd name="connsiteX1" fmla="*/ 9984 w 10120"/>
                <a:gd name="connsiteY1" fmla="*/ 51 h 10175"/>
                <a:gd name="connsiteX2" fmla="*/ 5691 w 10120"/>
                <a:gd name="connsiteY2" fmla="*/ 8066 h 10175"/>
                <a:gd name="connsiteX3" fmla="*/ 9833 w 10120"/>
                <a:gd name="connsiteY3" fmla="*/ 10175 h 10175"/>
                <a:gd name="connsiteX0" fmla="*/ 9960 w 10194"/>
                <a:gd name="connsiteY0" fmla="*/ 10252 h 10252"/>
                <a:gd name="connsiteX1" fmla="*/ 9984 w 10194"/>
                <a:gd name="connsiteY1" fmla="*/ 51 h 10252"/>
                <a:gd name="connsiteX2" fmla="*/ 5691 w 10194"/>
                <a:gd name="connsiteY2" fmla="*/ 8066 h 10252"/>
                <a:gd name="connsiteX3" fmla="*/ 9960 w 10194"/>
                <a:gd name="connsiteY3" fmla="*/ 10252 h 10252"/>
                <a:gd name="connsiteX0" fmla="*/ 9960 w 10194"/>
                <a:gd name="connsiteY0" fmla="*/ 10252 h 10252"/>
                <a:gd name="connsiteX1" fmla="*/ 9984 w 10194"/>
                <a:gd name="connsiteY1" fmla="*/ 51 h 10252"/>
                <a:gd name="connsiteX2" fmla="*/ 5691 w 10194"/>
                <a:gd name="connsiteY2" fmla="*/ 8066 h 10252"/>
                <a:gd name="connsiteX3" fmla="*/ 9960 w 10194"/>
                <a:gd name="connsiteY3" fmla="*/ 10252 h 10252"/>
                <a:gd name="connsiteX0" fmla="*/ 10201 w 10373"/>
                <a:gd name="connsiteY0" fmla="*/ 10161 h 10161"/>
                <a:gd name="connsiteX1" fmla="*/ 9984 w 10373"/>
                <a:gd name="connsiteY1" fmla="*/ 51 h 10161"/>
                <a:gd name="connsiteX2" fmla="*/ 5691 w 10373"/>
                <a:gd name="connsiteY2" fmla="*/ 8066 h 10161"/>
                <a:gd name="connsiteX3" fmla="*/ 10201 w 10373"/>
                <a:gd name="connsiteY3" fmla="*/ 10161 h 10161"/>
                <a:gd name="connsiteX0" fmla="*/ 10201 w 10373"/>
                <a:gd name="connsiteY0" fmla="*/ 10161 h 10161"/>
                <a:gd name="connsiteX1" fmla="*/ 9984 w 10373"/>
                <a:gd name="connsiteY1" fmla="*/ 51 h 10161"/>
                <a:gd name="connsiteX2" fmla="*/ 5691 w 10373"/>
                <a:gd name="connsiteY2" fmla="*/ 8066 h 10161"/>
                <a:gd name="connsiteX3" fmla="*/ 10201 w 10373"/>
                <a:gd name="connsiteY3" fmla="*/ 10161 h 10161"/>
                <a:gd name="connsiteX0" fmla="*/ 10592 w 10710"/>
                <a:gd name="connsiteY0" fmla="*/ 10201 h 10201"/>
                <a:gd name="connsiteX1" fmla="*/ 9984 w 10710"/>
                <a:gd name="connsiteY1" fmla="*/ 51 h 10201"/>
                <a:gd name="connsiteX2" fmla="*/ 5691 w 10710"/>
                <a:gd name="connsiteY2" fmla="*/ 8066 h 10201"/>
                <a:gd name="connsiteX3" fmla="*/ 10592 w 10710"/>
                <a:gd name="connsiteY3" fmla="*/ 10201 h 10201"/>
                <a:gd name="connsiteX0" fmla="*/ 10592 w 10710"/>
                <a:gd name="connsiteY0" fmla="*/ 10201 h 10201"/>
                <a:gd name="connsiteX1" fmla="*/ 9984 w 10710"/>
                <a:gd name="connsiteY1" fmla="*/ 51 h 10201"/>
                <a:gd name="connsiteX2" fmla="*/ 5691 w 10710"/>
                <a:gd name="connsiteY2" fmla="*/ 8066 h 10201"/>
                <a:gd name="connsiteX3" fmla="*/ 10592 w 10710"/>
                <a:gd name="connsiteY3" fmla="*/ 10201 h 10201"/>
                <a:gd name="connsiteX0" fmla="*/ 10592 w 10710"/>
                <a:gd name="connsiteY0" fmla="*/ 10201 h 10201"/>
                <a:gd name="connsiteX1" fmla="*/ 9984 w 10710"/>
                <a:gd name="connsiteY1" fmla="*/ 51 h 10201"/>
                <a:gd name="connsiteX2" fmla="*/ 5691 w 10710"/>
                <a:gd name="connsiteY2" fmla="*/ 8066 h 10201"/>
                <a:gd name="connsiteX3" fmla="*/ 10592 w 10710"/>
                <a:gd name="connsiteY3" fmla="*/ 10201 h 10201"/>
                <a:gd name="connsiteX0" fmla="*/ 10934 w 11052"/>
                <a:gd name="connsiteY0" fmla="*/ 10201 h 10201"/>
                <a:gd name="connsiteX1" fmla="*/ 10326 w 11052"/>
                <a:gd name="connsiteY1" fmla="*/ 51 h 10201"/>
                <a:gd name="connsiteX2" fmla="*/ 5609 w 11052"/>
                <a:gd name="connsiteY2" fmla="*/ 8164 h 10201"/>
                <a:gd name="connsiteX3" fmla="*/ 10934 w 11052"/>
                <a:gd name="connsiteY3" fmla="*/ 10201 h 10201"/>
                <a:gd name="connsiteX0" fmla="*/ 10934 w 11052"/>
                <a:gd name="connsiteY0" fmla="*/ 10201 h 10201"/>
                <a:gd name="connsiteX1" fmla="*/ 10326 w 11052"/>
                <a:gd name="connsiteY1" fmla="*/ 51 h 10201"/>
                <a:gd name="connsiteX2" fmla="*/ 5609 w 11052"/>
                <a:gd name="connsiteY2" fmla="*/ 8164 h 10201"/>
                <a:gd name="connsiteX3" fmla="*/ 10934 w 11052"/>
                <a:gd name="connsiteY3" fmla="*/ 10201 h 10201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1373 w 11491"/>
                <a:gd name="connsiteY0" fmla="*/ 10202 h 10202"/>
                <a:gd name="connsiteX1" fmla="*/ 10765 w 11491"/>
                <a:gd name="connsiteY1" fmla="*/ 52 h 10202"/>
                <a:gd name="connsiteX2" fmla="*/ 5506 w 11491"/>
                <a:gd name="connsiteY2" fmla="*/ 7994 h 10202"/>
                <a:gd name="connsiteX3" fmla="*/ 11373 w 11491"/>
                <a:gd name="connsiteY3" fmla="*/ 10202 h 10202"/>
                <a:gd name="connsiteX0" fmla="*/ 18463 w 18581"/>
                <a:gd name="connsiteY0" fmla="*/ 10150 h 10150"/>
                <a:gd name="connsiteX1" fmla="*/ 17855 w 18581"/>
                <a:gd name="connsiteY1" fmla="*/ 0 h 10150"/>
                <a:gd name="connsiteX2" fmla="*/ 12596 w 18581"/>
                <a:gd name="connsiteY2" fmla="*/ 7942 h 10150"/>
                <a:gd name="connsiteX3" fmla="*/ 18463 w 18581"/>
                <a:gd name="connsiteY3" fmla="*/ 10150 h 10150"/>
                <a:gd name="connsiteX0" fmla="*/ 608 w 726"/>
                <a:gd name="connsiteY0" fmla="*/ 10150 h 10150"/>
                <a:gd name="connsiteX1" fmla="*/ 0 w 726"/>
                <a:gd name="connsiteY1" fmla="*/ 0 h 10150"/>
                <a:gd name="connsiteX2" fmla="*/ 608 w 726"/>
                <a:gd name="connsiteY2" fmla="*/ 10150 h 10150"/>
                <a:gd name="connsiteX0" fmla="*/ 59658 w 61295"/>
                <a:gd name="connsiteY0" fmla="*/ 10000 h 10000"/>
                <a:gd name="connsiteX1" fmla="*/ 51283 w 61295"/>
                <a:gd name="connsiteY1" fmla="*/ 0 h 10000"/>
                <a:gd name="connsiteX2" fmla="*/ 59658 w 61295"/>
                <a:gd name="connsiteY2" fmla="*/ 10000 h 10000"/>
                <a:gd name="connsiteX0" fmla="*/ 59658 w 84651"/>
                <a:gd name="connsiteY0" fmla="*/ 10000 h 10000"/>
                <a:gd name="connsiteX1" fmla="*/ 51283 w 84651"/>
                <a:gd name="connsiteY1" fmla="*/ 0 h 10000"/>
                <a:gd name="connsiteX2" fmla="*/ 59658 w 84651"/>
                <a:gd name="connsiteY2" fmla="*/ 10000 h 10000"/>
                <a:gd name="connsiteX0" fmla="*/ 148647 w 173640"/>
                <a:gd name="connsiteY0" fmla="*/ 10000 h 10000"/>
                <a:gd name="connsiteX1" fmla="*/ 140272 w 173640"/>
                <a:gd name="connsiteY1" fmla="*/ 0 h 10000"/>
                <a:gd name="connsiteX2" fmla="*/ 148647 w 173640"/>
                <a:gd name="connsiteY2" fmla="*/ 10000 h 10000"/>
                <a:gd name="connsiteX0" fmla="*/ 148647 w 153064"/>
                <a:gd name="connsiteY0" fmla="*/ 10000 h 10000"/>
                <a:gd name="connsiteX1" fmla="*/ 140272 w 153064"/>
                <a:gd name="connsiteY1" fmla="*/ 0 h 10000"/>
                <a:gd name="connsiteX2" fmla="*/ 148647 w 153064"/>
                <a:gd name="connsiteY2" fmla="*/ 10000 h 10000"/>
                <a:gd name="connsiteX0" fmla="*/ 148647 w 148647"/>
                <a:gd name="connsiteY0" fmla="*/ 10000 h 10000"/>
                <a:gd name="connsiteX1" fmla="*/ 140272 w 148647"/>
                <a:gd name="connsiteY1" fmla="*/ 0 h 10000"/>
                <a:gd name="connsiteX2" fmla="*/ 148647 w 148647"/>
                <a:gd name="connsiteY2" fmla="*/ 10000 h 10000"/>
                <a:gd name="connsiteX0" fmla="*/ 154722 w 154722"/>
                <a:gd name="connsiteY0" fmla="*/ 10000 h 10000"/>
                <a:gd name="connsiteX1" fmla="*/ 146347 w 154722"/>
                <a:gd name="connsiteY1" fmla="*/ 0 h 10000"/>
                <a:gd name="connsiteX2" fmla="*/ 154722 w 154722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2725"/>
                <a:gd name="connsiteY0" fmla="*/ 10000 h 10000"/>
                <a:gd name="connsiteX1" fmla="*/ 144350 w 152725"/>
                <a:gd name="connsiteY1" fmla="*/ 0 h 10000"/>
                <a:gd name="connsiteX2" fmla="*/ 152725 w 152725"/>
                <a:gd name="connsiteY2" fmla="*/ 10000 h 10000"/>
                <a:gd name="connsiteX0" fmla="*/ 152725 w 153231"/>
                <a:gd name="connsiteY0" fmla="*/ 10000 h 10000"/>
                <a:gd name="connsiteX1" fmla="*/ 144350 w 153231"/>
                <a:gd name="connsiteY1" fmla="*/ 0 h 10000"/>
                <a:gd name="connsiteX2" fmla="*/ 152725 w 153231"/>
                <a:gd name="connsiteY2" fmla="*/ 10000 h 10000"/>
                <a:gd name="connsiteX0" fmla="*/ 152725 w 153930"/>
                <a:gd name="connsiteY0" fmla="*/ 10000 h 10000"/>
                <a:gd name="connsiteX1" fmla="*/ 144350 w 153930"/>
                <a:gd name="connsiteY1" fmla="*/ 0 h 10000"/>
                <a:gd name="connsiteX2" fmla="*/ 152725 w 153930"/>
                <a:gd name="connsiteY2" fmla="*/ 10000 h 10000"/>
                <a:gd name="connsiteX0" fmla="*/ 152725 w 156746"/>
                <a:gd name="connsiteY0" fmla="*/ 10000 h 10000"/>
                <a:gd name="connsiteX1" fmla="*/ 144350 w 156746"/>
                <a:gd name="connsiteY1" fmla="*/ 0 h 10000"/>
                <a:gd name="connsiteX2" fmla="*/ 152725 w 156746"/>
                <a:gd name="connsiteY2" fmla="*/ 10000 h 10000"/>
                <a:gd name="connsiteX0" fmla="*/ 156368 w 160389"/>
                <a:gd name="connsiteY0" fmla="*/ 10000 h 10000"/>
                <a:gd name="connsiteX1" fmla="*/ 147993 w 160389"/>
                <a:gd name="connsiteY1" fmla="*/ 0 h 10000"/>
                <a:gd name="connsiteX2" fmla="*/ 156368 w 160389"/>
                <a:gd name="connsiteY2" fmla="*/ 10000 h 10000"/>
                <a:gd name="connsiteX0" fmla="*/ 159522 w 163543"/>
                <a:gd name="connsiteY0" fmla="*/ 10000 h 10000"/>
                <a:gd name="connsiteX1" fmla="*/ 151147 w 163543"/>
                <a:gd name="connsiteY1" fmla="*/ 0 h 10000"/>
                <a:gd name="connsiteX2" fmla="*/ 159522 w 163543"/>
                <a:gd name="connsiteY2" fmla="*/ 10000 h 10000"/>
                <a:gd name="connsiteX0" fmla="*/ 164492 w 168513"/>
                <a:gd name="connsiteY0" fmla="*/ 10000 h 10000"/>
                <a:gd name="connsiteX1" fmla="*/ 156117 w 168513"/>
                <a:gd name="connsiteY1" fmla="*/ 0 h 10000"/>
                <a:gd name="connsiteX2" fmla="*/ 164492 w 168513"/>
                <a:gd name="connsiteY2" fmla="*/ 10000 h 10000"/>
                <a:gd name="connsiteX0" fmla="*/ 157865 w 166869"/>
                <a:gd name="connsiteY0" fmla="*/ 10241 h 10241"/>
                <a:gd name="connsiteX1" fmla="*/ 161044 w 166869"/>
                <a:gd name="connsiteY1" fmla="*/ 0 h 10241"/>
                <a:gd name="connsiteX2" fmla="*/ 157865 w 166869"/>
                <a:gd name="connsiteY2" fmla="*/ 10241 h 1024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66869" h="10241">
                  <a:moveTo>
                    <a:pt x="157865" y="10241"/>
                  </a:moveTo>
                  <a:cubicBezTo>
                    <a:pt x="166687" y="7400"/>
                    <a:pt x="171237" y="2927"/>
                    <a:pt x="161044" y="0"/>
                  </a:cubicBezTo>
                  <a:cubicBezTo>
                    <a:pt x="-90146" y="1558"/>
                    <a:pt x="-12963" y="7628"/>
                    <a:pt x="157865" y="10241"/>
                  </a:cubicBezTo>
                  <a:close/>
                </a:path>
              </a:pathLst>
            </a:custGeom>
            <a:gradFill flip="none" rotWithShape="1">
              <a:gsLst>
                <a:gs pos="20000">
                  <a:srgbClr val="DFDFDF"/>
                </a:gs>
                <a:gs pos="0">
                  <a:sysClr val="window" lastClr="FFFFFF">
                    <a:lumMod val="95000"/>
                  </a:sysClr>
                </a:gs>
                <a:gs pos="97000">
                  <a:sysClr val="window" lastClr="FFFFFF">
                    <a:lumMod val="65000"/>
                  </a:sysClr>
                </a:gs>
                <a:gs pos="69000">
                  <a:sysClr val="windowText" lastClr="000000">
                    <a:lumMod val="50000"/>
                    <a:lumOff val="50000"/>
                  </a:sysClr>
                </a:gs>
                <a:gs pos="84000">
                  <a:sysClr val="window" lastClr="FFFFFF">
                    <a:lumMod val="95000"/>
                  </a:sysClr>
                </a:gs>
              </a:gsLst>
              <a:lin ang="0" scaled="1"/>
              <a:tileRect/>
            </a:gradFill>
            <a:ln w="25400" cap="flat" cmpd="sng" algn="ctr">
              <a:noFill/>
              <a:prstDash val="solid"/>
            </a:ln>
            <a:effectLst>
              <a:outerShdw blurRad="177800" dist="38100" dir="720000" algn="l" rotWithShape="0">
                <a:prstClr val="black">
                  <a:alpha val="63000"/>
                </a:prstClr>
              </a:outerShdw>
            </a:effectLst>
          </p:spPr>
          <p:txBody>
            <a:bodyPr rtlCol="0" anchor="ctr"/>
            <a:lstStyle/>
            <a:p>
              <a:pPr algn="ctr">
                <a:defRPr/>
              </a:pPr>
              <a:endParaRPr lang="en-US" kern="0">
                <a:solidFill>
                  <a:sysClr val="window" lastClr="FFFFFF"/>
                </a:solidFill>
              </a:endParaRPr>
            </a:p>
          </p:txBody>
        </p:sp>
        <p:sp>
          <p:nvSpPr>
            <p:cNvPr id="5" name="Rectangle 4"/>
            <p:cNvSpPr/>
            <p:nvPr/>
          </p:nvSpPr>
          <p:spPr>
            <a:xfrm>
              <a:off x="9592047" y="70492"/>
              <a:ext cx="2617416" cy="744040"/>
            </a:xfrm>
            <a:prstGeom prst="rect">
              <a:avLst/>
            </a:prstGeom>
            <a:noFill/>
          </p:spPr>
          <p:txBody>
            <a:bodyPr wrap="square" lIns="432044" tIns="216022" rIns="432044" bIns="216022">
              <a:spAutoFit/>
            </a:bodyPr>
            <a:lstStyle>
              <a:defPPr>
                <a:defRPr lang="ar-EG"/>
              </a:defPPr>
              <a:lvl1pPr marL="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defTabSz="914363" rtl="0">
                <a:spcBef>
                  <a:spcPct val="0"/>
                </a:spcBef>
                <a:defRPr/>
              </a:pPr>
              <a:r>
                <a:rPr lang="en-US" sz="2000" cap="small" dirty="0" smtClean="0">
                  <a:ln w="12700">
                    <a:noFill/>
                  </a:ln>
                  <a:solidFill>
                    <a:prstClr val="black"/>
                  </a:solidFill>
                  <a:latin typeface="Book Antiqua" pitchFamily="18" charset="0"/>
                  <a:cs typeface="Diwani Letter" pitchFamily="2" charset="-78"/>
                </a:rPr>
                <a:t>Results </a:t>
              </a:r>
              <a:endParaRPr lang="ar-EG" cap="small" dirty="0">
                <a:ln w="12700">
                  <a:noFill/>
                </a:ln>
                <a:solidFill>
                  <a:prstClr val="black"/>
                </a:solidFill>
                <a:latin typeface="Book Antiqua" pitchFamily="18" charset="0"/>
                <a:cs typeface="Diwani Letter" pitchFamily="2" charset="-78"/>
              </a:endParaRPr>
            </a:p>
          </p:txBody>
        </p:sp>
      </p:grpSp>
      <p:grpSp>
        <p:nvGrpSpPr>
          <p:cNvPr id="20" name="Group 19"/>
          <p:cNvGrpSpPr/>
          <p:nvPr/>
        </p:nvGrpSpPr>
        <p:grpSpPr>
          <a:xfrm>
            <a:off x="982638" y="2132857"/>
            <a:ext cx="10513168" cy="2088231"/>
            <a:chOff x="8111283" y="5215504"/>
            <a:chExt cx="1827309" cy="1827309"/>
          </a:xfrm>
        </p:grpSpPr>
        <p:grpSp>
          <p:nvGrpSpPr>
            <p:cNvPr id="21" name="Group 20"/>
            <p:cNvGrpSpPr/>
            <p:nvPr/>
          </p:nvGrpSpPr>
          <p:grpSpPr>
            <a:xfrm rot="21155154">
              <a:off x="8111283" y="5215504"/>
              <a:ext cx="1827309" cy="1827309"/>
              <a:chOff x="-305747" y="2456837"/>
              <a:chExt cx="1223127" cy="1223127"/>
            </a:xfrm>
          </p:grpSpPr>
          <p:sp>
            <p:nvSpPr>
              <p:cNvPr id="23" name="Oval 22"/>
              <p:cNvSpPr/>
              <p:nvPr/>
            </p:nvSpPr>
            <p:spPr>
              <a:xfrm rot="11244846">
                <a:off x="-305747" y="2456837"/>
                <a:ext cx="1223127" cy="1223127"/>
              </a:xfrm>
              <a:prstGeom prst="round2DiagRect">
                <a:avLst/>
              </a:prstGeom>
              <a:noFill/>
              <a:ln w="28575" cap="flat" cmpd="sng" algn="ctr">
                <a:solidFill>
                  <a:srgbClr val="D8B25C"/>
                </a:solidFill>
                <a:prstDash val="sysDot"/>
              </a:ln>
              <a:effectLst>
                <a:outerShdw blurRad="149987" dist="250190" dir="8460000" algn="ctr">
                  <a:srgbClr val="000000">
                    <a:alpha val="28000"/>
                  </a:srgbClr>
                </a:outerShdw>
              </a:effectLst>
            </p:spPr>
            <p:txBody>
              <a:bodyPr rtlCol="1" anchor="ctr"/>
              <a:lstStyle/>
              <a:p>
                <a:pPr algn="ctr">
                  <a:defRPr/>
                </a:pPr>
                <a:endParaRPr lang="ar-EG" sz="2400" kern="0"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24" name="Oval 23"/>
              <p:cNvSpPr/>
              <p:nvPr/>
            </p:nvSpPr>
            <p:spPr>
              <a:xfrm>
                <a:off x="-272002" y="2505857"/>
                <a:ext cx="1153604" cy="1153604"/>
              </a:xfrm>
              <a:prstGeom prst="round2DiagRect">
                <a:avLst/>
              </a:prstGeom>
              <a:noFill/>
              <a:ln w="9525" cap="flat" cmpd="sng" algn="ctr">
                <a:noFill/>
                <a:prstDash val="solid"/>
              </a:ln>
              <a:effectLst/>
              <a:scene3d>
                <a:camera prst="orthographicFront">
                  <a:rot lat="0" lon="0" rev="0"/>
                </a:camera>
                <a:lightRig rig="contrasting" dir="t">
                  <a:rot lat="0" lon="0" rev="7800000"/>
                </a:lightRig>
              </a:scene3d>
              <a:sp3d>
                <a:bevelT w="139700" h="139700" prst="convex"/>
              </a:sp3d>
            </p:spPr>
            <p:txBody>
              <a:bodyPr rtlCol="1" anchor="ctr"/>
              <a:lstStyle/>
              <a:p>
                <a:pPr algn="ctr">
                  <a:defRPr/>
                </a:pPr>
                <a:endParaRPr lang="ar-EG" sz="2400" kern="0"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25" name="Oval 24"/>
              <p:cNvSpPr>
                <a:spLocks noChangeAspect="1"/>
              </p:cNvSpPr>
              <p:nvPr/>
            </p:nvSpPr>
            <p:spPr>
              <a:xfrm rot="444846">
                <a:off x="-248004" y="2495342"/>
                <a:ext cx="1096971" cy="1096972"/>
              </a:xfrm>
              <a:prstGeom prst="round2DiagRect">
                <a:avLst/>
              </a:prstGeom>
              <a:solidFill>
                <a:sysClr val="windowText" lastClr="000000">
                  <a:alpha val="43000"/>
                </a:sysClr>
              </a:solidFill>
              <a:ln w="12700" cap="flat" cmpd="sng" algn="ctr">
                <a:noFill/>
                <a:prstDash val="solid"/>
                <a:miter lim="800000"/>
              </a:ln>
              <a:effectLst>
                <a:outerShdw blurRad="149987" dist="250190" dir="8460000" algn="ctr">
                  <a:srgbClr val="000000">
                    <a:alpha val="28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contrasting" dir="t">
                  <a:rot lat="0" lon="0" rev="1500000"/>
                </a:lightRig>
              </a:scene3d>
              <a:sp3d prstMaterial="metal">
                <a:bevelT w="88900" h="88900"/>
              </a:sp3d>
            </p:spPr>
            <p:txBody>
              <a:bodyPr rtlCol="1" anchor="ctr"/>
              <a:lstStyle/>
              <a:p>
                <a:pPr algn="ctr">
                  <a:defRPr/>
                </a:pPr>
                <a:endParaRPr lang="ar-EG" kern="0">
                  <a:solidFill>
                    <a:prstClr val="white"/>
                  </a:solidFill>
                  <a:latin typeface="Calibri"/>
                </a:endParaRPr>
              </a:p>
            </p:txBody>
          </p:sp>
        </p:grpSp>
        <p:sp>
          <p:nvSpPr>
            <p:cNvPr id="22" name="Rectangle 21"/>
            <p:cNvSpPr/>
            <p:nvPr/>
          </p:nvSpPr>
          <p:spPr>
            <a:xfrm flipH="1">
              <a:off x="8293967" y="5554421"/>
              <a:ext cx="1459665" cy="223971"/>
            </a:xfrm>
            <a:prstGeom prst="round2DiagRect">
              <a:avLst/>
            </a:prstGeom>
            <a:noFill/>
          </p:spPr>
          <p:txBody>
            <a:bodyPr wrap="square" lIns="0" tIns="0" rIns="0" bIns="0">
              <a:spAutoFit/>
            </a:bodyPr>
            <a:lstStyle>
              <a:defPPr>
                <a:defRPr lang="ar-EG"/>
              </a:defPPr>
              <a:lvl1pPr marL="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rtl="0" fontAlgn="base">
                <a:lnSpc>
                  <a:spcPct val="110000"/>
                </a:lnSpc>
                <a:spcBef>
                  <a:spcPct val="0"/>
                </a:spcBef>
                <a:spcAft>
                  <a:spcPct val="0"/>
                </a:spcAft>
                <a:defRPr/>
              </a:pPr>
              <a:endParaRPr lang="en-GB" sz="2400" b="1" kern="0" dirty="0">
                <a:solidFill>
                  <a:prstClr val="white"/>
                </a:solidFill>
                <a:latin typeface="Book Antiqua" panose="02040602050305030304" pitchFamily="18" charset="0"/>
              </a:endParaRPr>
            </a:p>
          </p:txBody>
        </p:sp>
      </p:grpSp>
      <p:sp>
        <p:nvSpPr>
          <p:cNvPr id="12" name="Rectangle 21"/>
          <p:cNvSpPr/>
          <p:nvPr/>
        </p:nvSpPr>
        <p:spPr>
          <a:xfrm flipH="1">
            <a:off x="2062758" y="2474633"/>
            <a:ext cx="8424937" cy="1170391"/>
          </a:xfrm>
          <a:prstGeom prst="round2DiagRect">
            <a:avLst/>
          </a:prstGeom>
          <a:noFill/>
        </p:spPr>
        <p:txBody>
          <a:bodyPr wrap="square" lIns="0" tIns="0" rIns="0" bIns="0">
            <a:spAutoFit/>
          </a:bodyPr>
          <a:lstStyle>
            <a:defPPr>
              <a:defRPr lang="ar-EG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rtl="0" fontAlgn="base">
              <a:lnSpc>
                <a:spcPct val="110000"/>
              </a:lnSpc>
              <a:spcBef>
                <a:spcPct val="0"/>
              </a:spcBef>
              <a:spcAft>
                <a:spcPct val="0"/>
              </a:spcAft>
              <a:defRPr/>
            </a:pPr>
            <a:r>
              <a:rPr lang="en-GB" sz="3200" b="1" kern="0" dirty="0" smtClean="0">
                <a:solidFill>
                  <a:prstClr val="white"/>
                </a:solidFill>
                <a:latin typeface="Book Antiqua" panose="02040602050305030304" pitchFamily="18" charset="0"/>
              </a:rPr>
              <a:t>So, changes in </a:t>
            </a:r>
            <a:r>
              <a:rPr lang="en-GB" sz="3200" b="1" kern="0" dirty="0" smtClean="0">
                <a:solidFill>
                  <a:srgbClr val="FFCC66"/>
                </a:solidFill>
                <a:latin typeface="Book Antiqua" panose="02040602050305030304" pitchFamily="18" charset="0"/>
              </a:rPr>
              <a:t>Post-pacing</a:t>
            </a:r>
            <a:r>
              <a:rPr lang="en-GB" sz="3200" b="1" kern="0" dirty="0" smtClean="0">
                <a:solidFill>
                  <a:prstClr val="white"/>
                </a:solidFill>
                <a:latin typeface="Book Antiqua" panose="02040602050305030304" pitchFamily="18" charset="0"/>
              </a:rPr>
              <a:t> GLS at one week preceded the decline in LVEF at 6 months</a:t>
            </a:r>
            <a:endParaRPr lang="en-GB" sz="3200" b="1" kern="0" dirty="0">
              <a:solidFill>
                <a:srgbClr val="FFCC66"/>
              </a:solidFill>
              <a:latin typeface="Book Antiqua" panose="020406020503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281469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6" presetClass="entr" presetSubtype="32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out)">
                                      <p:cBhvr>
                                        <p:cTn id="7" dur="5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6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9" dur="500" tmFilter="0, 0; .2, .5; .8, .5; 1, 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  <p:animScale>
                                      <p:cBhvr>
                                        <p:cTn id="10" dur="250" autoRev="1" fill="hold"/>
                                        <p:tgtEl>
                                          <p:spTgt spid="20"/>
                                        </p:tgtEl>
                                      </p:cBhvr>
                                      <p:by x="105000" y="10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Ion">
  <a:themeElements>
    <a:clrScheme name="Ion">
      <a:dk1>
        <a:sysClr val="windowText" lastClr="000000"/>
      </a:dk1>
      <a:lt1>
        <a:sysClr val="window" lastClr="FFFFFF"/>
      </a:lt1>
      <a:dk2>
        <a:srgbClr val="1E5155"/>
      </a:dk2>
      <a:lt2>
        <a:srgbClr val="EBEBEB"/>
      </a:lt2>
      <a:accent1>
        <a:srgbClr val="B01513"/>
      </a:accent1>
      <a:accent2>
        <a:srgbClr val="EA6312"/>
      </a:accent2>
      <a:accent3>
        <a:srgbClr val="E6B729"/>
      </a:accent3>
      <a:accent4>
        <a:srgbClr val="6AAC90"/>
      </a:accent4>
      <a:accent5>
        <a:srgbClr val="54849A"/>
      </a:accent5>
      <a:accent6>
        <a:srgbClr val="9E5E9B"/>
      </a:accent6>
      <a:hlink>
        <a:srgbClr val="58C1BA"/>
      </a:hlink>
      <a:folHlink>
        <a:srgbClr val="9DFFCB"/>
      </a:folHlink>
    </a:clrScheme>
    <a:fontScheme name="Ion">
      <a:majorFont>
        <a:latin typeface="Century Gothic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Gothic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Ion">
      <a:fillStyleLst>
        <a:solidFill>
          <a:schemeClr val="phClr"/>
        </a:solidFill>
        <a:gradFill rotWithShape="1">
          <a:gsLst>
            <a:gs pos="0">
              <a:schemeClr val="phClr">
                <a:tint val="64000"/>
                <a:lumMod val="118000"/>
              </a:schemeClr>
            </a:gs>
            <a:gs pos="100000">
              <a:schemeClr val="phClr">
                <a:tint val="92000"/>
                <a:alpha val="100000"/>
                <a:lumMod val="11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8000"/>
                <a:lumMod val="114000"/>
              </a:schemeClr>
            </a:gs>
            <a:gs pos="100000">
              <a:schemeClr val="phClr">
                <a:shade val="90000"/>
                <a:lumMod val="84000"/>
              </a:schemeClr>
            </a:gs>
          </a:gsLst>
          <a:lin ang="5400000" scaled="0"/>
        </a:gradFill>
      </a:fillStyleLst>
      <a:lnStyleLst>
        <a:ln w="9525" cap="rnd" cmpd="sng" algn="ctr">
          <a:solidFill>
            <a:schemeClr val="phClr"/>
          </a:solidFill>
          <a:prstDash val="solid"/>
        </a:ln>
        <a:ln w="19050" cap="rnd" cmpd="sng" algn="ctr">
          <a:solidFill>
            <a:schemeClr val="phClr"/>
          </a:solidFill>
          <a:prstDash val="solid"/>
        </a:ln>
        <a:ln w="28575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63500" dist="38100" dir="5400000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l"/>
          </a:scene3d>
          <a:sp3d prstMaterial="plastic">
            <a:bevelT w="0" h="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7000"/>
                <a:hueMod val="88000"/>
                <a:satMod val="130000"/>
                <a:lumMod val="124000"/>
              </a:schemeClr>
            </a:gs>
            <a:gs pos="100000">
              <a:schemeClr val="phClr">
                <a:tint val="96000"/>
                <a:shade val="88000"/>
                <a:hueMod val="108000"/>
                <a:satMod val="164000"/>
                <a:lumMod val="76000"/>
              </a:schemeClr>
            </a:gs>
          </a:gsLst>
          <a:path path="circle">
            <a:fillToRect l="45000" t="65000" r="125000" b="100000"/>
          </a:path>
        </a:gradFill>
        <a:blipFill rotWithShape="1">
          <a:blip xmlns:r="http://schemas.openxmlformats.org/officeDocument/2006/relationships" r:embed="rId1">
            <a:duotone>
              <a:schemeClr val="phClr">
                <a:shade val="69000"/>
                <a:hueMod val="108000"/>
                <a:satMod val="164000"/>
                <a:lumMod val="74000"/>
              </a:schemeClr>
              <a:schemeClr val="phClr">
                <a:tint val="96000"/>
                <a:hueMod val="88000"/>
                <a:satMod val="140000"/>
                <a:lumMod val="132000"/>
              </a:schemeClr>
            </a:duotone>
          </a:blip>
          <a:stretch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Ion" id="{B8441ADB-2E43-4AF7-B97A-BD870242C6A8}" vid="{292E63A9-BB86-4E3D-B92A-7223C6510D2E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17</TotalTime>
  <Words>75</Words>
  <Application>Microsoft Office PowerPoint</Application>
  <PresentationFormat>Custom</PresentationFormat>
  <Paragraphs>27</Paragraphs>
  <Slides>7</Slides>
  <Notes>3</Notes>
  <HiddenSlides>0</HiddenSlides>
  <MMClips>9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7" baseType="lpstr">
      <vt:lpstr>AF_Unizah </vt:lpstr>
      <vt:lpstr>Arial</vt:lpstr>
      <vt:lpstr>Book Antiqua</vt:lpstr>
      <vt:lpstr>Calibri</vt:lpstr>
      <vt:lpstr>Cambria</vt:lpstr>
      <vt:lpstr>Century Gothic</vt:lpstr>
      <vt:lpstr>Clearly Gothic</vt:lpstr>
      <vt:lpstr>Diwani Letter</vt:lpstr>
      <vt:lpstr>Wingdings 3</vt:lpstr>
      <vt:lpstr>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a</dc:creator>
  <cp:lastModifiedBy>M</cp:lastModifiedBy>
  <cp:revision>6751</cp:revision>
  <dcterms:created xsi:type="dcterms:W3CDTF">2006-08-16T00:00:00Z</dcterms:created>
  <dcterms:modified xsi:type="dcterms:W3CDTF">2020-05-30T10:48:36Z</dcterms:modified>
</cp:coreProperties>
</file>